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7" r:id="rId2"/>
  </p:sldIdLst>
  <p:sldSz cx="6492875" cy="841216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045">
          <p15:clr>
            <a:srgbClr val="A4A3A4"/>
          </p15:clr>
        </p15:guide>
        <p15:guide id="3" orient="horz" pos="6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43" autoAdjust="0"/>
    <p:restoredTop sz="96081" autoAdjust="0"/>
  </p:normalViewPr>
  <p:slideViewPr>
    <p:cSldViewPr>
      <p:cViewPr varScale="1">
        <p:scale>
          <a:sx n="78" d="100"/>
          <a:sy n="78" d="100"/>
        </p:scale>
        <p:origin x="1122" y="108"/>
      </p:cViewPr>
      <p:guideLst>
        <p:guide pos="2045"/>
        <p:guide orient="horz" pos="6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" userId="b11a5121-062d-4360-8951-d081ad96d999" providerId="ADAL" clId="{9F3DCE2B-CD69-4735-8D75-F97BD501C620}"/>
    <pc:docChg chg="undo redo custSel delSld modSld">
      <pc:chgData name="Go" userId="b11a5121-062d-4360-8951-d081ad96d999" providerId="ADAL" clId="{9F3DCE2B-CD69-4735-8D75-F97BD501C620}" dt="2022-10-06T03:01:28.049" v="365" actId="1035"/>
      <pc:docMkLst>
        <pc:docMk/>
      </pc:docMkLst>
      <pc:sldChg chg="addSp delSp modSp mod">
        <pc:chgData name="Go" userId="b11a5121-062d-4360-8951-d081ad96d999" providerId="ADAL" clId="{9F3DCE2B-CD69-4735-8D75-F97BD501C620}" dt="2022-10-06T01:59:05.555" v="40" actId="1035"/>
        <pc:sldMkLst>
          <pc:docMk/>
          <pc:sldMk cId="765565405" sldId="295"/>
        </pc:sldMkLst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5" creationId="{A13A7755-482B-DB79-B7FA-774EDD0CF951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6" creationId="{D51863D8-455B-EC0F-71CB-5FDB543079E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7" creationId="{9AD3C06D-AD2A-06FC-BE68-B49D85C3C27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8" creationId="{0451ED29-33C0-93F8-7A36-FA45EAFD881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0" creationId="{13C8E1A1-5815-DA4D-8E86-1F21026E355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3" creationId="{8BBE0DCD-5716-2704-9454-472A9944543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5" creationId="{3958EEFB-0F3C-661B-D83D-665E60B1FF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6" creationId="{DFED24C3-182C-8E23-946D-496948D6DAC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7" creationId="{CA3E831C-A33B-43D2-4F89-C1F7CD8DD0F3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8" creationId="{C1D5D536-8CBB-3EDB-A7A2-5D4B65174D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9" creationId="{7BEEB265-4B51-6C6C-35D4-DDC52F490E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81" creationId="{3AF757E8-4AE4-91BF-3E89-1C195E53A1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14" creationId="{EF596959-60D3-4521-DE7A-48D803BF3B4D}"/>
          </ac:spMkLst>
        </pc:spChg>
        <pc:spChg chg="mod">
          <ac:chgData name="Go" userId="b11a5121-062d-4360-8951-d081ad96d999" providerId="ADAL" clId="{9F3DCE2B-CD69-4735-8D75-F97BD501C620}" dt="2022-10-06T01:59:00.819" v="39" actId="1035"/>
          <ac:spMkLst>
            <pc:docMk/>
            <pc:sldMk cId="765565405" sldId="295"/>
            <ac:spMk id="216" creationId="{D657EAB7-2F22-372F-9161-BC037AAB4596}"/>
          </ac:spMkLst>
        </pc:spChg>
        <pc:spChg chg="mod">
          <ac:chgData name="Go" userId="b11a5121-062d-4360-8951-d081ad96d999" providerId="ADAL" clId="{9F3DCE2B-CD69-4735-8D75-F97BD501C620}" dt="2022-10-06T01:58:57.487" v="36" actId="1035"/>
          <ac:spMkLst>
            <pc:docMk/>
            <pc:sldMk cId="765565405" sldId="295"/>
            <ac:spMk id="218" creationId="{DEF0CF26-0463-2340-281E-4E244F51EE6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4" creationId="{496BC65B-71E2-B748-5735-2F5B94283B9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7" creationId="{08B8E35D-A3C5-891E-C395-16525445E0F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9" creationId="{C0E28091-6E1D-3F5D-B88E-B2A6DD29E0F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31" creationId="{04F20118-ABCF-DE51-B90D-76C4364A529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49" creationId="{2882A209-37C6-C544-F7FA-06B6F9367A5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0" creationId="{ACD10E03-4C8C-F276-636D-6243D531551C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1" creationId="{1017BC00-01DE-61D9-21A2-3D40BC47FF3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2" creationId="{3B01E9EB-DEFC-7FE9-A5F0-ADD2FCEAECB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3" creationId="{A1BD4D14-C8EF-62A2-EB85-FE16D10AF27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4" creationId="{C609FA06-A566-4E80-A9F9-8EEDAD7EA1EE}"/>
          </ac:spMkLst>
        </pc:s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5" creationId="{AD8DB468-048F-B9FC-6CFF-C0488CA069F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8" creationId="{1AB48F4C-6B99-087F-F438-3FD82BD25946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9" creationId="{7A847D17-1ACF-D55D-13C8-86539824C27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31" creationId="{8176E087-5509-EB8F-312F-9CE869835A67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25" creationId="{EC15710E-7CE9-A2A5-77EF-8A1B923D8D58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58" creationId="{88CF5590-DD0D-0456-695B-C7F320C4D46D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68" creationId="{71E89F71-02F2-647A-FBAF-2276502E671F}"/>
          </ac:grpSpMkLst>
        </pc:grpChg>
        <pc:graphicFrameChg chg="add del mod">
          <ac:chgData name="Go" userId="b11a5121-062d-4360-8951-d081ad96d999" providerId="ADAL" clId="{9F3DCE2B-CD69-4735-8D75-F97BD501C620}" dt="2022-10-06T01:57:36.085" v="8"/>
          <ac:graphicFrameMkLst>
            <pc:docMk/>
            <pc:sldMk cId="765565405" sldId="295"/>
            <ac:graphicFrameMk id="2" creationId="{73622A94-0173-6612-EE8E-82144F55ED2C}"/>
          </ac:graphicFrameMkLst>
        </pc:graphicFrameChg>
        <pc:graphicFrameChg chg="mod">
          <ac:chgData name="Go" userId="b11a5121-062d-4360-8951-d081ad96d999" providerId="ADAL" clId="{9F3DCE2B-CD69-4735-8D75-F97BD501C620}" dt="2022-10-06T01:58:06.317" v="16"/>
          <ac:graphicFrameMkLst>
            <pc:docMk/>
            <pc:sldMk cId="765565405" sldId="295"/>
            <ac:graphicFrameMk id="257" creationId="{93C7C028-D7E1-E394-069E-29D1113A0275}"/>
          </ac:graphicFrameMkLst>
        </pc:graphicFrameChg>
        <pc:picChg chg="add mod modCrop">
          <ac:chgData name="Go" userId="b11a5121-062d-4360-8951-d081ad96d999" providerId="ADAL" clId="{9F3DCE2B-CD69-4735-8D75-F97BD501C620}" dt="2022-10-06T01:59:05.555" v="40" actId="1035"/>
          <ac:picMkLst>
            <pc:docMk/>
            <pc:sldMk cId="765565405" sldId="295"/>
            <ac:picMk id="10" creationId="{A3549F28-64D7-EB92-998C-4E26A68827E2}"/>
          </ac:picMkLst>
        </pc:picChg>
        <pc:picChg chg="del mod">
          <ac:chgData name="Go" userId="b11a5121-062d-4360-8951-d081ad96d999" providerId="ADAL" clId="{9F3DCE2B-CD69-4735-8D75-F97BD501C620}" dt="2022-10-06T01:58:42.303" v="25" actId="478"/>
          <ac:picMkLst>
            <pc:docMk/>
            <pc:sldMk cId="765565405" sldId="295"/>
            <ac:picMk id="262" creationId="{A92ABF3D-C883-625D-933E-47CC786B689E}"/>
          </ac:picMkLst>
        </pc:picChg>
        <pc:picChg chg="del mod">
          <ac:chgData name="Go" userId="b11a5121-062d-4360-8951-d081ad96d999" providerId="ADAL" clId="{9F3DCE2B-CD69-4735-8D75-F97BD501C620}" dt="2022-10-06T01:58:43.479" v="26" actId="478"/>
          <ac:picMkLst>
            <pc:docMk/>
            <pc:sldMk cId="765565405" sldId="295"/>
            <ac:picMk id="263" creationId="{EBAFD2EB-5626-2B49-9723-8A5BAC7693A1}"/>
          </ac:picMkLst>
        </pc:picChg>
        <pc:picChg chg="del mod">
          <ac:chgData name="Go" userId="b11a5121-062d-4360-8951-d081ad96d999" providerId="ADAL" clId="{9F3DCE2B-CD69-4735-8D75-F97BD501C620}" dt="2022-10-06T01:58:44.701" v="27" actId="478"/>
          <ac:picMkLst>
            <pc:docMk/>
            <pc:sldMk cId="765565405" sldId="295"/>
            <ac:picMk id="264" creationId="{8652B5E2-4623-CA66-805E-616B7FA3FF24}"/>
          </ac:picMkLst>
        </pc:picChg>
      </pc:sldChg>
      <pc:sldChg chg="del">
        <pc:chgData name="Go" userId="b11a5121-062d-4360-8951-d081ad96d999" providerId="ADAL" clId="{9F3DCE2B-CD69-4735-8D75-F97BD501C620}" dt="2022-10-06T01:27:14.763" v="0" actId="47"/>
        <pc:sldMkLst>
          <pc:docMk/>
          <pc:sldMk cId="2177906614" sldId="300"/>
        </pc:sldMkLst>
      </pc:sldChg>
      <pc:sldChg chg="addSp delSp modSp mod">
        <pc:chgData name="Go" userId="b11a5121-062d-4360-8951-d081ad96d999" providerId="ADAL" clId="{9F3DCE2B-CD69-4735-8D75-F97BD501C620}" dt="2022-10-06T03:01:28.049" v="365" actId="1035"/>
        <pc:sldMkLst>
          <pc:docMk/>
          <pc:sldMk cId="3299870256" sldId="301"/>
        </pc:sldMkLst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6" creationId="{2D415CC3-EC50-47BD-9C07-95599E264991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36" creationId="{0ABDE28E-4F18-7EA1-324E-0C46208B54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4" creationId="{089D6C4B-E85D-1CD3-914B-2088CDFD16B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61" creationId="{5141CB8A-7B8E-6254-DBB4-D32013666423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7" creationId="{8A76B3BE-6305-3092-D6E1-5320853AEDB0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5" creationId="{131802D4-FD62-DC83-FE86-405BECC0C5A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7" creationId="{89D1BCF2-D4AC-8C3F-17A1-9C25E61AACD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3" creationId="{56F6A622-9BDD-3332-828E-C876E4560F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9" creationId="{59BF9AEA-DF00-F9B3-5F98-B7501CB2231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0" creationId="{1EF5F240-AEF8-72E9-3C23-CEA138F855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1" creationId="{B8EF6791-1158-4708-9A41-CD908898F733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2" creationId="{C9089F88-A7E2-5192-3F75-580721F351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3" creationId="{94B3687A-97A1-8162-DA02-5A08EB9BA277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4" creationId="{5DAC7207-6117-B06A-89BC-088ABA7B6A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5" creationId="{5D88F820-8544-2545-70B6-0BDC1A5C5C1E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6" creationId="{AF751193-0DF9-5599-55EE-F3E02CCEAA68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7" creationId="{AF1BA0F4-20EC-226C-B2A1-722E87497F17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1" creationId="{B48E4DE0-D0C2-B224-D68D-CB7F847EFBE1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2" creationId="{0CF15B6C-3EB2-F776-FBC5-FC00A990B539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4" creationId="{460DEB48-76D4-95E0-407D-DDA21DDCBA5F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5" creationId="{3779F03F-3B36-8DA2-E323-D4E5CF78779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48" creationId="{2A461E41-4216-804B-0458-33A2868184CA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4" creationId="{C806C188-7867-D5B4-150F-4F77934B8ECB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5" creationId="{22380C95-4B15-1A66-81BF-353DE139D1E1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6" creationId="{05DF12E6-6425-A279-8DF6-B401F100E7E4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7" creationId="{EB0679B9-FB9D-D1A9-8665-BD7FA0EB5622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65" creationId="{836643C2-CA20-7104-1C79-E65775AADB7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6" creationId="{5F7E0991-BECC-20EF-901D-EAB2B04864D8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9F3DCE2B-CD69-4735-8D75-F97BD501C620}" dt="2022-10-06T02:41:12.703" v="356" actId="1076"/>
          <ac:spMkLst>
            <pc:docMk/>
            <pc:sldMk cId="3299870256" sldId="301"/>
            <ac:spMk id="383" creationId="{61A85EF3-E6C7-95D6-BA84-F36035F58FA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6" creationId="{A2558EC1-8F79-87E0-9F0A-99507D5576B2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04" creationId="{02ECC1BC-F39A-F87F-9CAA-AAC3D74418F5}"/>
          </ac:spMkLst>
        </pc:spChg>
        <pc:spChg chg="mod topLvl">
          <ac:chgData name="Go" userId="b11a5121-062d-4360-8951-d081ad96d999" providerId="ADAL" clId="{9F3DCE2B-CD69-4735-8D75-F97BD501C620}" dt="2022-10-06T02:40:53.751" v="349" actId="1076"/>
          <ac:spMkLst>
            <pc:docMk/>
            <pc:sldMk cId="3299870256" sldId="301"/>
            <ac:spMk id="405" creationId="{C923D1E9-D5B0-0DF4-CBD0-3D3506D36739}"/>
          </ac:spMkLst>
        </pc:spChg>
        <pc:spChg chg="mod topLvl">
          <ac:chgData name="Go" userId="b11a5121-062d-4360-8951-d081ad96d999" providerId="ADAL" clId="{9F3DCE2B-CD69-4735-8D75-F97BD501C620}" dt="2022-10-06T02:41:01.432" v="354" actId="1037"/>
          <ac:spMkLst>
            <pc:docMk/>
            <pc:sldMk cId="3299870256" sldId="301"/>
            <ac:spMk id="406" creationId="{0803A274-7185-EFF4-5AF0-E12E2D8EFEA3}"/>
          </ac:spMkLst>
        </pc:spChg>
        <pc:spChg chg="mod topLvl">
          <ac:chgData name="Go" userId="b11a5121-062d-4360-8951-d081ad96d999" providerId="ADAL" clId="{9F3DCE2B-CD69-4735-8D75-F97BD501C620}" dt="2022-10-06T02:41:07.288" v="355" actId="1076"/>
          <ac:spMkLst>
            <pc:docMk/>
            <pc:sldMk cId="3299870256" sldId="301"/>
            <ac:spMk id="408" creationId="{AB7599AF-4951-AA93-87B7-6A93798964A9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452" creationId="{2136A444-A366-651A-8DD2-6AF9265DE35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5" creationId="{3821EC33-988D-5E7A-366D-8526840CF9C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6" creationId="{F84D33E0-D75B-E5DD-90F3-F58810190783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7" creationId="{0674B0C4-69D0-6BA3-FBC1-6938931A39E6}"/>
          </ac:spMkLst>
        </pc:spChg>
        <pc:spChg chg="add mod">
          <ac:chgData name="Go" userId="b11a5121-062d-4360-8951-d081ad96d999" providerId="ADAL" clId="{9F3DCE2B-CD69-4735-8D75-F97BD501C620}" dt="2022-10-06T02:26:51.843" v="140" actId="14100"/>
          <ac:spMkLst>
            <pc:docMk/>
            <pc:sldMk cId="3299870256" sldId="301"/>
            <ac:spMk id="569" creationId="{7FEE8F95-0A39-7126-223C-C6EF2690BC96}"/>
          </ac:spMkLst>
        </pc:spChg>
        <pc:spChg chg="add mod">
          <ac:chgData name="Go" userId="b11a5121-062d-4360-8951-d081ad96d999" providerId="ADAL" clId="{9F3DCE2B-CD69-4735-8D75-F97BD501C620}" dt="2022-10-06T02:27:03.098" v="143" actId="6549"/>
          <ac:spMkLst>
            <pc:docMk/>
            <pc:sldMk cId="3299870256" sldId="301"/>
            <ac:spMk id="570" creationId="{59DE02A7-C0DC-0479-0D80-A0B880F649FC}"/>
          </ac:spMkLst>
        </pc:spChg>
        <pc:spChg chg="add mod">
          <ac:chgData name="Go" userId="b11a5121-062d-4360-8951-d081ad96d999" providerId="ADAL" clId="{9F3DCE2B-CD69-4735-8D75-F97BD501C620}" dt="2022-10-06T02:26:55.376" v="141"/>
          <ac:spMkLst>
            <pc:docMk/>
            <pc:sldMk cId="3299870256" sldId="301"/>
            <ac:spMk id="571" creationId="{B5FECC4F-4C4A-CF55-3697-F1285BD8FDC6}"/>
          </ac:spMkLst>
        </pc:spChg>
        <pc:spChg chg="add mod">
          <ac:chgData name="Go" userId="b11a5121-062d-4360-8951-d081ad96d999" providerId="ADAL" clId="{9F3DCE2B-CD69-4735-8D75-F97BD501C620}" dt="2022-10-06T02:26:46.155" v="138" actId="14100"/>
          <ac:spMkLst>
            <pc:docMk/>
            <pc:sldMk cId="3299870256" sldId="301"/>
            <ac:spMk id="572" creationId="{A0827BB1-6801-B6D2-2367-75A2600B37A0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6" creationId="{B3051111-6CD4-B04F-9F5B-F260D6C89BD5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7" creationId="{291D8301-F5B4-C87F-E0CE-35783993D7FC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8" creationId="{39F090BB-F7CE-9A2D-DB70-190E68C5EB83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9" creationId="{0F2B4379-20AA-5B82-9C7E-6CD3C418FAD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0" creationId="{7792413A-1C5F-F801-4015-D5F0C3EBE6A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6" creationId="{205EBF96-3975-9EBB-82BF-524229ADCA5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6" creationId="{D90BAA66-82BF-AB0E-F44E-A3693776677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5" creationId="{2DEC7FC4-B77B-41B9-39FB-F34AC4A598D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29" creationId="{F9EE2836-7AC4-31A7-0E13-A86BEF57BE09}"/>
          </ac:spMkLst>
        </pc:s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20" creationId="{E21F8CEC-E83B-F070-D777-299FA4EAFA32}"/>
          </ac:grpSpMkLst>
        </pc:grpChg>
        <pc:grpChg chg="del">
          <ac:chgData name="Go" userId="b11a5121-062d-4360-8951-d081ad96d999" providerId="ADAL" clId="{9F3DCE2B-CD69-4735-8D75-F97BD501C620}" dt="2022-10-06T02:19:21.711" v="86" actId="478"/>
          <ac:grpSpMkLst>
            <pc:docMk/>
            <pc:sldMk cId="3299870256" sldId="301"/>
            <ac:grpSpMk id="21" creationId="{4C4BFF3F-907D-5187-7CB9-14A7EFEEED2A}"/>
          </ac:grpSpMkLst>
        </pc:grpChg>
        <pc:grpChg chg="del mod topLvl">
          <ac:chgData name="Go" userId="b11a5121-062d-4360-8951-d081ad96d999" providerId="ADAL" clId="{9F3DCE2B-CD69-4735-8D75-F97BD501C620}" dt="2022-10-06T02:25:01.107" v="115" actId="165"/>
          <ac:grpSpMkLst>
            <pc:docMk/>
            <pc:sldMk cId="3299870256" sldId="301"/>
            <ac:grpSpMk id="26" creationId="{0BA1BCA1-5FC4-0C49-C14F-40FB8ED755B9}"/>
          </ac:grpSpMkLst>
        </pc:grpChg>
        <pc:grpChg chg="del mod topLvl">
          <ac:chgData name="Go" userId="b11a5121-062d-4360-8951-d081ad96d999" providerId="ADAL" clId="{9F3DCE2B-CD69-4735-8D75-F97BD501C620}" dt="2022-10-06T02:25:05.203" v="116" actId="478"/>
          <ac:grpSpMkLst>
            <pc:docMk/>
            <pc:sldMk cId="3299870256" sldId="301"/>
            <ac:grpSpMk id="32" creationId="{C5C02679-FE29-E5DC-3B04-0FEEB2230AC0}"/>
          </ac:grpSpMkLst>
        </pc:grpChg>
        <pc:grpChg chg="del mod">
          <ac:chgData name="Go" userId="b11a5121-062d-4360-8951-d081ad96d999" providerId="ADAL" clId="{9F3DCE2B-CD69-4735-8D75-F97BD501C620}" dt="2022-10-06T02:24:54.472" v="114" actId="165"/>
          <ac:grpSpMkLst>
            <pc:docMk/>
            <pc:sldMk cId="3299870256" sldId="301"/>
            <ac:grpSpMk id="33" creationId="{F87A5B70-5377-48A3-675A-7BB159218FC4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35" creationId="{3B5D5338-4068-0B8B-9A3F-750DB95A2FDC}"/>
          </ac:grpSpMkLst>
        </pc:grpChg>
        <pc:grpChg chg="del mod topLvl">
          <ac:chgData name="Go" userId="b11a5121-062d-4360-8951-d081ad96d999" providerId="ADAL" clId="{9F3DCE2B-CD69-4735-8D75-F97BD501C620}" dt="2022-10-06T02:27:09.450" v="144" actId="165"/>
          <ac:grpSpMkLst>
            <pc:docMk/>
            <pc:sldMk cId="3299870256" sldId="301"/>
            <ac:grpSpMk id="37" creationId="{C9AA53E6-8F5E-1970-A858-EA458C60055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8" creationId="{C1E8B024-5731-5476-C6B6-95AA4CAD3B0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265" creationId="{58D7A5F3-D98F-4285-EE18-1B7425AB048A}"/>
          </ac:grpSpMkLst>
        </pc:grpChg>
        <pc:grpChg chg="del mod topLvl">
          <ac:chgData name="Go" userId="b11a5121-062d-4360-8951-d081ad96d999" providerId="ADAL" clId="{9F3DCE2B-CD69-4735-8D75-F97BD501C620}" dt="2022-10-06T02:27:18.765" v="147" actId="478"/>
          <ac:grpSpMkLst>
            <pc:docMk/>
            <pc:sldMk cId="3299870256" sldId="301"/>
            <ac:grpSpMk id="294" creationId="{16B64ABB-AAB7-D70E-E2F1-5D23EAEE781C}"/>
          </ac:grpSpMkLst>
        </pc:grpChg>
        <pc:grpChg chg="del mod topLvl">
          <ac:chgData name="Go" userId="b11a5121-062d-4360-8951-d081ad96d999" providerId="ADAL" clId="{9F3DCE2B-CD69-4735-8D75-F97BD501C620}" dt="2022-10-06T02:27:12.746" v="146" actId="478"/>
          <ac:grpSpMkLst>
            <pc:docMk/>
            <pc:sldMk cId="3299870256" sldId="301"/>
            <ac:grpSpMk id="340" creationId="{6978A1B5-46A4-5B6A-79C9-71083DA3C80C}"/>
          </ac:grpSpMkLst>
        </pc:grpChg>
        <pc:grpChg chg="del mod topLvl">
          <ac:chgData name="Go" userId="b11a5121-062d-4360-8951-d081ad96d999" providerId="ADAL" clId="{9F3DCE2B-CD69-4735-8D75-F97BD501C620}" dt="2022-10-06T02:25:06.866" v="117" actId="478"/>
          <ac:grpSpMkLst>
            <pc:docMk/>
            <pc:sldMk cId="3299870256" sldId="301"/>
            <ac:grpSpMk id="353" creationId="{FD21445C-3153-DE45-74B6-F1410920582C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64" creationId="{17C21720-62CF-2EB6-2C65-7D0429926D99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68" creationId="{706C3840-D8CA-33D8-4500-9CF9E3C9CD63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3" creationId="{FBA6C53D-B473-F3A3-9284-0CA75D11F752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4" creationId="{09B9E57B-C211-879A-4E02-D57C8D7370D5}"/>
          </ac:grpSpMkLst>
        </pc:grpChg>
        <pc:grpChg chg="add del mod">
          <ac:chgData name="Go" userId="b11a5121-062d-4360-8951-d081ad96d999" providerId="ADAL" clId="{9F3DCE2B-CD69-4735-8D75-F97BD501C620}" dt="2022-10-06T02:38:58.369" v="299" actId="165"/>
          <ac:grpSpMkLst>
            <pc:docMk/>
            <pc:sldMk cId="3299870256" sldId="301"/>
            <ac:grpSpMk id="575" creationId="{B920F064-3CFB-215B-A207-B4908F644B6C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1" creationId="{4E21338A-FC59-5D0F-6590-E5BBA4062FCA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2" creationId="{8285CAB0-3863-6BEB-31C1-2CA27C7772C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639" creationId="{1DE898C2-E809-2B55-CF57-DE7A01B03F65}"/>
          </ac:grpSpMkLst>
        </pc:grpChg>
        <pc:graphicFrameChg chg="add mod or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9F3DCE2B-CD69-4735-8D75-F97BD501C620}" dt="2022-10-06T02:35:20.501" v="220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del mod topLvl">
          <ac:chgData name="Go" userId="b11a5121-062d-4360-8951-d081ad96d999" providerId="ADAL" clId="{9F3DCE2B-CD69-4735-8D75-F97BD501C620}" dt="2022-10-06T02:25:47.036" v="126" actId="478"/>
          <ac:graphicFrameMkLst>
            <pc:docMk/>
            <pc:sldMk cId="3299870256" sldId="301"/>
            <ac:graphicFrameMk id="214" creationId="{3A7A70EC-40DB-875B-87FC-ADBA3AA62B73}"/>
          </ac:graphicFrameMkLst>
        </pc:graphicFrameChg>
        <pc:picChg chg="del topLvl">
          <ac:chgData name="Go" userId="b11a5121-062d-4360-8951-d081ad96d999" providerId="ADAL" clId="{9F3DCE2B-CD69-4735-8D75-F97BD501C620}" dt="2022-10-06T02:19:21.711" v="86" actId="478"/>
          <ac:picMkLst>
            <pc:docMk/>
            <pc:sldMk cId="3299870256" sldId="301"/>
            <ac:picMk id="267" creationId="{56C78E99-E031-09B9-7725-4188B39EFF2C}"/>
          </ac:picMkLst>
        </pc:picChg>
      </pc:sldChg>
    </pc:docChg>
  </pc:docChgLst>
  <pc:docChgLst>
    <pc:chgData name="Go" userId="b11a5121-062d-4360-8951-d081ad96d999" providerId="ADAL" clId="{52F29124-2773-4FC9-A15B-0DFCA3E9DA52}"/>
    <pc:docChg chg="undo custSel modSld">
      <pc:chgData name="Go" userId="b11a5121-062d-4360-8951-d081ad96d999" providerId="ADAL" clId="{52F29124-2773-4FC9-A15B-0DFCA3E9DA52}" dt="2022-10-13T06:03:31.608" v="99" actId="6549"/>
      <pc:docMkLst>
        <pc:docMk/>
      </pc:docMkLst>
      <pc:sldChg chg="addSp delSp modSp mod">
        <pc:chgData name="Go" userId="b11a5121-062d-4360-8951-d081ad96d999" providerId="ADAL" clId="{52F29124-2773-4FC9-A15B-0DFCA3E9DA52}" dt="2022-10-13T06:03:31.608" v="99" actId="6549"/>
        <pc:sldMkLst>
          <pc:docMk/>
          <pc:sldMk cId="4198847848" sldId="289"/>
        </pc:sldMkLst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6" creationId="{1371575E-03FE-EE70-76FF-FA71A80DCB10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2" creationId="{862C96C3-B678-4FDB-79C7-BD9FF90DBB5B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4" creationId="{46907438-93BD-1BB7-73D0-42587FA78A56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52F29124-2773-4FC9-A15B-0DFCA3E9DA52}" dt="2022-10-13T06:03:13.558" v="89"/>
          <ac:spMkLst>
            <pc:docMk/>
            <pc:sldMk cId="4198847848" sldId="289"/>
            <ac:spMk id="19" creationId="{7D68F769-E8DD-44CF-A4E5-1312488851B5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0" creationId="{1E5638A1-D88D-1784-8C3B-1B8361927869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2" creationId="{36E91FB9-4892-1F8E-353E-FF9EB925FD47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3" creationId="{8F56171D-F7BE-E561-DC43-A9B6735F84A4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5" creationId="{68F4F58B-8832-9843-D9CE-23AFF4B8F241}"/>
          </ac:spMkLst>
        </pc:spChg>
        <pc:spChg chg="del mod topLvl">
          <ac:chgData name="Go" userId="b11a5121-062d-4360-8951-d081ad96d999" providerId="ADAL" clId="{52F29124-2773-4FC9-A15B-0DFCA3E9DA52}" dt="2022-10-13T06:02:23.728" v="69" actId="478"/>
          <ac:spMkLst>
            <pc:docMk/>
            <pc:sldMk cId="4198847848" sldId="289"/>
            <ac:spMk id="26" creationId="{C7291577-3B2B-CF92-110E-2F3C3AF1C20E}"/>
          </ac:spMkLst>
        </pc:spChg>
        <pc:spChg chg="mod topLvl">
          <ac:chgData name="Go" userId="b11a5121-062d-4360-8951-d081ad96d999" providerId="ADAL" clId="{52F29124-2773-4FC9-A15B-0DFCA3E9DA52}" dt="2022-10-13T06:02:18.358" v="68" actId="164"/>
          <ac:spMkLst>
            <pc:docMk/>
            <pc:sldMk cId="4198847848" sldId="289"/>
            <ac:spMk id="29" creationId="{0859BD14-4FA4-0795-E0EB-5AAE01B9CCD5}"/>
          </ac:spMkLst>
        </pc:spChg>
        <pc:spChg chg="mod">
          <ac:chgData name="Go" userId="b11a5121-062d-4360-8951-d081ad96d999" providerId="ADAL" clId="{52F29124-2773-4FC9-A15B-0DFCA3E9DA52}" dt="2022-10-13T06:02:43.058" v="77" actId="14100"/>
          <ac:spMkLst>
            <pc:docMk/>
            <pc:sldMk cId="4198847848" sldId="289"/>
            <ac:spMk id="30" creationId="{FC148F42-5523-6278-2C5F-3B069D4677E0}"/>
          </ac:spMkLst>
        </pc:spChg>
        <pc:spChg chg="mod">
          <ac:chgData name="Go" userId="b11a5121-062d-4360-8951-d081ad96d999" providerId="ADAL" clId="{52F29124-2773-4FC9-A15B-0DFCA3E9DA52}" dt="2022-10-13T06:02:40.849" v="76" actId="14100"/>
          <ac:spMkLst>
            <pc:docMk/>
            <pc:sldMk cId="4198847848" sldId="289"/>
            <ac:spMk id="31" creationId="{4B0C0D4E-C485-800D-136E-3B5190E9C0AF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3" creationId="{2C118948-231F-1F9D-09C3-4B4F5BA9B6A0}"/>
          </ac:spMkLst>
        </pc:spChg>
        <pc:spChg chg="mod">
          <ac:chgData name="Go" userId="b11a5121-062d-4360-8951-d081ad96d999" providerId="ADAL" clId="{52F29124-2773-4FC9-A15B-0DFCA3E9DA52}" dt="2022-10-13T06:02:28.228" v="70" actId="14100"/>
          <ac:spMkLst>
            <pc:docMk/>
            <pc:sldMk cId="4198847848" sldId="289"/>
            <ac:spMk id="34" creationId="{830A266A-048F-1F68-B3E0-F65F808C7741}"/>
          </ac:spMkLst>
        </pc:spChg>
        <pc:spChg chg="mod">
          <ac:chgData name="Go" userId="b11a5121-062d-4360-8951-d081ad96d999" providerId="ADAL" clId="{52F29124-2773-4FC9-A15B-0DFCA3E9DA52}" dt="2022-10-13T06:02:29.898" v="71" actId="14100"/>
          <ac:spMkLst>
            <pc:docMk/>
            <pc:sldMk cId="4198847848" sldId="289"/>
            <ac:spMk id="35" creationId="{5400C05B-D17B-E886-3BA9-7F75EDADED5E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6" creationId="{7FF9410D-73F7-EB65-E0FF-E2112266A595}"/>
          </ac:spMkLst>
        </pc:spChg>
        <pc:spChg chg="add del mod">
          <ac:chgData name="Go" userId="b11a5121-062d-4360-8951-d081ad96d999" providerId="ADAL" clId="{52F29124-2773-4FC9-A15B-0DFCA3E9DA52}" dt="2022-10-13T06:01:32.518" v="56"/>
          <ac:spMkLst>
            <pc:docMk/>
            <pc:sldMk cId="4198847848" sldId="289"/>
            <ac:spMk id="37" creationId="{E1C7FEAE-40E1-AD62-FABA-24EF613FC5BB}"/>
          </ac:spMkLst>
        </pc:spChg>
        <pc:spChg chg="mod">
          <ac:chgData name="Go" userId="b11a5121-062d-4360-8951-d081ad96d999" providerId="ADAL" clId="{52F29124-2773-4FC9-A15B-0DFCA3E9DA52}" dt="2022-10-13T06:03:03.298" v="84" actId="20577"/>
          <ac:spMkLst>
            <pc:docMk/>
            <pc:sldMk cId="4198847848" sldId="289"/>
            <ac:spMk id="56" creationId="{591B5E2C-071D-1FA3-516C-A23252F4EAE0}"/>
          </ac:spMkLst>
        </pc:spChg>
        <pc:spChg chg="add mod">
          <ac:chgData name="Go" userId="b11a5121-062d-4360-8951-d081ad96d999" providerId="ADAL" clId="{52F29124-2773-4FC9-A15B-0DFCA3E9DA52}" dt="2022-10-13T06:03:31.608" v="99" actId="6549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52F29124-2773-4FC9-A15B-0DFCA3E9DA52}" dt="2022-10-13T06:03:16.368" v="94"/>
          <ac:spMkLst>
            <pc:docMk/>
            <pc:sldMk cId="4198847848" sldId="289"/>
            <ac:spMk id="69" creationId="{ECFCF99C-38AB-4DC4-A277-DFC8A3B1ECDF}"/>
          </ac:spMkLst>
        </pc:spChg>
        <pc:spChg chg="ord">
          <ac:chgData name="Go" userId="b11a5121-062d-4360-8951-d081ad96d999" providerId="ADAL" clId="{52F29124-2773-4FC9-A15B-0DFCA3E9DA52}" dt="2022-10-13T06:01:39.228" v="57" actId="167"/>
          <ac:spMkLst>
            <pc:docMk/>
            <pc:sldMk cId="4198847848" sldId="289"/>
            <ac:spMk id="74" creationId="{EA64EB29-ADCA-73ED-7718-2E8F06FCEFA9}"/>
          </ac:spMkLst>
        </pc:spChg>
        <pc:grpChg chg="mod">
          <ac:chgData name="Go" userId="b11a5121-062d-4360-8951-d081ad96d999" providerId="ADAL" clId="{52F29124-2773-4FC9-A15B-0DFCA3E9DA52}" dt="2022-10-13T05:48:39.978" v="43" actId="1038"/>
          <ac:grpSpMkLst>
            <pc:docMk/>
            <pc:sldMk cId="4198847848" sldId="289"/>
            <ac:grpSpMk id="2" creationId="{B2FD1FFB-4E78-0C3D-A641-8046DE08B520}"/>
          </ac:grpSpMkLst>
        </pc:grpChg>
        <pc:grpChg chg="add del mod">
          <ac:chgData name="Go" userId="b11a5121-062d-4360-8951-d081ad96d999" providerId="ADAL" clId="{52F29124-2773-4FC9-A15B-0DFCA3E9DA52}" dt="2022-10-13T05:59:26.328" v="49" actId="165"/>
          <ac:grpSpMkLst>
            <pc:docMk/>
            <pc:sldMk cId="4198847848" sldId="289"/>
            <ac:grpSpMk id="3" creationId="{9FCC5441-2205-C08C-6D50-7D141B324DC7}"/>
          </ac:grpSpMkLst>
        </pc:grpChg>
        <pc:grpChg chg="del 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8" creationId="{24E21BA2-1B5B-917F-B506-20D2BE47DF70}"/>
          </ac:grpSpMkLst>
        </pc:grpChg>
        <pc:grpChg chg="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27" creationId="{075889E4-E48A-F0E3-C5D2-CEC000F97771}"/>
          </ac:grpSpMkLst>
        </pc:grpChg>
        <pc:grpChg chg="mod topLvl">
          <ac:chgData name="Go" userId="b11a5121-062d-4360-8951-d081ad96d999" providerId="ADAL" clId="{52F29124-2773-4FC9-A15B-0DFCA3E9DA52}" dt="2022-10-13T06:02:33.718" v="73" actId="14100"/>
          <ac:grpSpMkLst>
            <pc:docMk/>
            <pc:sldMk cId="4198847848" sldId="289"/>
            <ac:grpSpMk id="28" creationId="{B2BC3338-3EEF-6A44-68D8-885DD23C1818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45" creationId="{2DFEA9BC-4E4D-469F-F722-637BB01AF58C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55" creationId="{26809872-AEDA-55C9-D4EF-8B78CEE05A9F}"/>
          </ac:grpSpMkLst>
        </pc:grp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4" creationId="{C61A9ACD-A35E-CABF-DC0F-DFC3FE911A68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5" creationId="{D529FFCD-96DD-2085-D658-05BE8822553F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7" creationId="{570C03D4-9885-1DE9-A161-07890068A4F9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0" creationId="{47239B5B-AE66-30F7-4FE8-F032BB78F5AE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3" creationId="{6384335C-79AE-8172-D5DF-7529DDE9B744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6" creationId="{4A4092D2-96F2-FA8F-E9AB-2569B80AAA70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7" creationId="{C2F012C9-F323-36DA-07F4-CEA68E0FBAF6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24" creationId="{7158A9C9-E5E3-F9F3-6597-D9E12877E31C}"/>
          </ac:picMkLst>
        </pc:picChg>
        <pc:cxnChg chg="add mod">
          <ac:chgData name="Go" userId="b11a5121-062d-4360-8951-d081ad96d999" providerId="ADAL" clId="{52F29124-2773-4FC9-A15B-0DFCA3E9DA52}" dt="2022-10-13T06:02:18.358" v="68" actId="164"/>
          <ac:cxnSpMkLst>
            <pc:docMk/>
            <pc:sldMk cId="4198847848" sldId="289"/>
            <ac:cxnSpMk id="38" creationId="{5BD417B4-8375-6009-ED5A-2BFA8E28E7E7}"/>
          </ac:cxnSpMkLst>
        </pc:cxnChg>
        <pc:cxnChg chg="mod">
          <ac:chgData name="Go" userId="b11a5121-062d-4360-8951-d081ad96d999" providerId="ADAL" clId="{52F29124-2773-4FC9-A15B-0DFCA3E9DA52}" dt="2022-10-13T06:02:49.548" v="78"/>
          <ac:cxnSpMkLst>
            <pc:docMk/>
            <pc:sldMk cId="4198847848" sldId="289"/>
            <ac:cxnSpMk id="58" creationId="{1E81D1DD-D381-72F3-3ABE-D9D10DA53938}"/>
          </ac:cxnSpMkLst>
        </pc:cxnChg>
      </pc:sldChg>
      <pc:sldChg chg="modSp mod">
        <pc:chgData name="Go" userId="b11a5121-062d-4360-8951-d081ad96d999" providerId="ADAL" clId="{52F29124-2773-4FC9-A15B-0DFCA3E9DA52}" dt="2022-10-13T05:48:18.939" v="12" actId="1038"/>
        <pc:sldMkLst>
          <pc:docMk/>
          <pc:sldMk cId="2231304746" sldId="299"/>
        </pc:sldMkLst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6" creationId="{B24D405F-2229-B7DC-EC12-925F30D0A658}"/>
          </ac:spMkLst>
        </pc:spChg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7" creationId="{B42E50CF-C6BD-ED37-FE05-0B55412D9AD3}"/>
          </ac:spMkLst>
        </pc:spChg>
        <pc:grpChg chg="mod">
          <ac:chgData name="Go" userId="b11a5121-062d-4360-8951-d081ad96d999" providerId="ADAL" clId="{52F29124-2773-4FC9-A15B-0DFCA3E9DA52}" dt="2022-10-13T05:48:18.939" v="12" actId="1038"/>
          <ac:grpSpMkLst>
            <pc:docMk/>
            <pc:sldMk cId="2231304746" sldId="299"/>
            <ac:grpSpMk id="4" creationId="{27BA6C3D-7A59-89EB-3682-D8BCAA78894E}"/>
          </ac:grpSpMkLst>
        </pc:grpChg>
      </pc:sldChg>
    </pc:docChg>
  </pc:docChgLst>
  <pc:docChgLst>
    <pc:chgData name="Go" userId="b11a5121-062d-4360-8951-d081ad96d999" providerId="ADAL" clId="{491CC7F4-2FA0-4F37-9370-6F073DD5677C}"/>
    <pc:docChg chg="delSld">
      <pc:chgData name="Go" userId="b11a5121-062d-4360-8951-d081ad96d999" providerId="ADAL" clId="{491CC7F4-2FA0-4F37-9370-6F073DD5677C}" dt="2022-10-15T03:35:03.524" v="1" actId="47"/>
      <pc:docMkLst>
        <pc:docMk/>
      </pc:docMkLst>
      <pc:sldChg chg="del">
        <pc:chgData name="Go" userId="b11a5121-062d-4360-8951-d081ad96d999" providerId="ADAL" clId="{491CC7F4-2FA0-4F37-9370-6F073DD5677C}" dt="2022-10-15T03:35:00.185" v="0" actId="47"/>
        <pc:sldMkLst>
          <pc:docMk/>
          <pc:sldMk cId="1094954127" sldId="284"/>
        </pc:sldMkLst>
      </pc:sldChg>
      <pc:sldChg chg="del">
        <pc:chgData name="Go" userId="b11a5121-062d-4360-8951-d081ad96d999" providerId="ADAL" clId="{491CC7F4-2FA0-4F37-9370-6F073DD5677C}" dt="2022-10-15T03:35:03.524" v="1" actId="47"/>
        <pc:sldMkLst>
          <pc:docMk/>
          <pc:sldMk cId="4198847848" sldId="289"/>
        </pc:sldMkLst>
      </pc:sldChg>
      <pc:sldChg chg="del">
        <pc:chgData name="Go" userId="b11a5121-062d-4360-8951-d081ad96d999" providerId="ADAL" clId="{491CC7F4-2FA0-4F37-9370-6F073DD5677C}" dt="2022-10-15T03:35:00.185" v="0" actId="47"/>
        <pc:sldMkLst>
          <pc:docMk/>
          <pc:sldMk cId="765565405" sldId="295"/>
        </pc:sldMkLst>
      </pc:sldChg>
      <pc:sldChg chg="del">
        <pc:chgData name="Go" userId="b11a5121-062d-4360-8951-d081ad96d999" providerId="ADAL" clId="{491CC7F4-2FA0-4F37-9370-6F073DD5677C}" dt="2022-10-15T03:35:00.185" v="0" actId="47"/>
        <pc:sldMkLst>
          <pc:docMk/>
          <pc:sldMk cId="2231304746" sldId="299"/>
        </pc:sldMkLst>
      </pc:sldChg>
      <pc:sldChg chg="del">
        <pc:chgData name="Go" userId="b11a5121-062d-4360-8951-d081ad96d999" providerId="ADAL" clId="{491CC7F4-2FA0-4F37-9370-6F073DD5677C}" dt="2022-10-15T03:35:00.185" v="0" actId="47"/>
        <pc:sldMkLst>
          <pc:docMk/>
          <pc:sldMk cId="3299870256" sldId="301"/>
        </pc:sldMkLst>
      </pc:sldChg>
      <pc:sldChg chg="del">
        <pc:chgData name="Go" userId="b11a5121-062d-4360-8951-d081ad96d999" providerId="ADAL" clId="{491CC7F4-2FA0-4F37-9370-6F073DD5677C}" dt="2022-10-15T03:35:00.185" v="0" actId="47"/>
        <pc:sldMkLst>
          <pc:docMk/>
          <pc:sldMk cId="2069005311" sldId="302"/>
        </pc:sldMkLst>
      </pc:sldChg>
      <pc:sldChg chg="del">
        <pc:chgData name="Go" userId="b11a5121-062d-4360-8951-d081ad96d999" providerId="ADAL" clId="{491CC7F4-2FA0-4F37-9370-6F073DD5677C}" dt="2022-10-15T03:35:03.524" v="1" actId="47"/>
        <pc:sldMkLst>
          <pc:docMk/>
          <pc:sldMk cId="1909606739" sldId="303"/>
        </pc:sldMkLst>
      </pc:sldChg>
    </pc:docChg>
  </pc:docChgLst>
  <pc:docChgLst>
    <pc:chgData name="Go" userId="b11a5121-062d-4360-8951-d081ad96d999" providerId="ADAL" clId="{A37B11FE-7E2B-4B71-9282-AB38B86228CA}"/>
    <pc:docChg chg="undo redo custSel addSld modSld sldOrd">
      <pc:chgData name="Go" userId="b11a5121-062d-4360-8951-d081ad96d999" providerId="ADAL" clId="{A37B11FE-7E2B-4B71-9282-AB38B86228CA}" dt="2022-10-15T01:48:08.111" v="1521" actId="555"/>
      <pc:docMkLst>
        <pc:docMk/>
      </pc:docMkLst>
      <pc:sldChg chg="modSp mod">
        <pc:chgData name="Go" userId="b11a5121-062d-4360-8951-d081ad96d999" providerId="ADAL" clId="{A37B11FE-7E2B-4B71-9282-AB38B86228CA}" dt="2022-10-15T01:46:26.953" v="1491" actId="20577"/>
        <pc:sldMkLst>
          <pc:docMk/>
          <pc:sldMk cId="1094954127" sldId="284"/>
        </pc:sldMkLst>
        <pc:spChg chg="mod">
          <ac:chgData name="Go" userId="b11a5121-062d-4360-8951-d081ad96d999" providerId="ADAL" clId="{A37B11FE-7E2B-4B71-9282-AB38B86228CA}" dt="2022-10-15T01:46:12.230" v="1482" actId="20577"/>
          <ac:spMkLst>
            <pc:docMk/>
            <pc:sldMk cId="1094954127" sldId="284"/>
            <ac:spMk id="347" creationId="{7E39A75D-38B4-D5AD-98A4-4AE965473059}"/>
          </ac:spMkLst>
        </pc:spChg>
        <pc:spChg chg="mod">
          <ac:chgData name="Go" userId="b11a5121-062d-4360-8951-d081ad96d999" providerId="ADAL" clId="{A37B11FE-7E2B-4B71-9282-AB38B86228CA}" dt="2022-10-15T01:46:17.881" v="1485" actId="20577"/>
          <ac:spMkLst>
            <pc:docMk/>
            <pc:sldMk cId="1094954127" sldId="284"/>
            <ac:spMk id="359" creationId="{C8E420D2-28A1-5437-B38E-6D212B142507}"/>
          </ac:spMkLst>
        </pc:spChg>
        <pc:spChg chg="mod">
          <ac:chgData name="Go" userId="b11a5121-062d-4360-8951-d081ad96d999" providerId="ADAL" clId="{A37B11FE-7E2B-4B71-9282-AB38B86228CA}" dt="2022-10-15T01:46:23.467" v="1488" actId="20577"/>
          <ac:spMkLst>
            <pc:docMk/>
            <pc:sldMk cId="1094954127" sldId="284"/>
            <ac:spMk id="371" creationId="{38316EC8-82FB-7105-7E65-4D366D5DC41F}"/>
          </ac:spMkLst>
        </pc:spChg>
        <pc:spChg chg="mod">
          <ac:chgData name="Go" userId="b11a5121-062d-4360-8951-d081ad96d999" providerId="ADAL" clId="{A37B11FE-7E2B-4B71-9282-AB38B86228CA}" dt="2022-10-15T01:46:26.953" v="1491" actId="20577"/>
          <ac:spMkLst>
            <pc:docMk/>
            <pc:sldMk cId="1094954127" sldId="284"/>
            <ac:spMk id="455" creationId="{1B83A5B9-24D0-604A-B889-D87FC290C02C}"/>
          </ac:spMkLst>
        </pc:spChg>
      </pc:sldChg>
      <pc:sldChg chg="delSp modSp mod">
        <pc:chgData name="Go" userId="b11a5121-062d-4360-8951-d081ad96d999" providerId="ADAL" clId="{A37B11FE-7E2B-4B71-9282-AB38B86228CA}" dt="2022-10-15T01:48:08.111" v="1521" actId="555"/>
        <pc:sldMkLst>
          <pc:docMk/>
          <pc:sldMk cId="4198847848" sldId="289"/>
        </pc:sldMkLst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6" creationId="{1371575E-03FE-EE70-76FF-FA71A80DCB10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2" creationId="{862C96C3-B678-4FDB-79C7-BD9FF90DBB5B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4" creationId="{46907438-93BD-1BB7-73D0-42587FA78A56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A37B11FE-7E2B-4B71-9282-AB38B86228CA}" dt="2022-10-13T20:38:46.290" v="1118" actId="20577"/>
          <ac:spMkLst>
            <pc:docMk/>
            <pc:sldMk cId="4198847848" sldId="289"/>
            <ac:spMk id="19" creationId="{7D68F769-E8DD-44CF-A4E5-1312488851B5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0" creationId="{1E5638A1-D88D-1784-8C3B-1B8361927869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2" creationId="{36E91FB9-4892-1F8E-353E-FF9EB925FD47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3" creationId="{8F56171D-F7BE-E561-DC43-A9B6735F84A4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5" creationId="{68F4F58B-8832-9843-D9CE-23AFF4B8F241}"/>
          </ac:spMkLst>
        </pc:spChg>
        <pc:spChg chg="mod">
          <ac:chgData name="Go" userId="b11a5121-062d-4360-8951-d081ad96d999" providerId="ADAL" clId="{A37B11FE-7E2B-4B71-9282-AB38B86228CA}" dt="2022-10-13T20:38:31.029" v="1085" actId="20577"/>
          <ac:spMkLst>
            <pc:docMk/>
            <pc:sldMk cId="4198847848" sldId="289"/>
            <ac:spMk id="44" creationId="{4EBA0680-77E2-2ABD-9B13-E3E33B2FEBA0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52" creationId="{9870C4CC-D847-B4A6-B69D-EA5358FC56E3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A37B11FE-7E2B-4B71-9282-AB38B86228CA}" dt="2022-10-13T20:38:48.726" v="1120" actId="20577"/>
          <ac:spMkLst>
            <pc:docMk/>
            <pc:sldMk cId="4198847848" sldId="289"/>
            <ac:spMk id="69" creationId="{ECFCF99C-38AB-4DC4-A277-DFC8A3B1ECD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7" creationId="{33C1C1D7-4480-E59E-7619-2126CC1A36F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9" creationId="{E0309F23-C5EE-0A6E-0543-BF3AE2E1E50B}"/>
          </ac:spMkLst>
        </pc:spChg>
        <pc:grpChg chg="mod">
          <ac:chgData name="Go" userId="b11a5121-062d-4360-8951-d081ad96d999" providerId="ADAL" clId="{A37B11FE-7E2B-4B71-9282-AB38B86228CA}" dt="2022-10-13T20:38:42.614" v="1116" actId="1037"/>
          <ac:grpSpMkLst>
            <pc:docMk/>
            <pc:sldMk cId="4198847848" sldId="289"/>
            <ac:grpSpMk id="2" creationId="{B2FD1FFB-4E78-0C3D-A641-8046DE08B520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7" creationId="{075889E4-E48A-F0E3-C5D2-CEC000F97771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8" creationId="{B2BC3338-3EEF-6A44-68D8-885DD23C1818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45" creationId="{2DFEA9BC-4E4D-469F-F722-637BB01AF58C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55" creationId="{26809872-AEDA-55C9-D4EF-8B78CEE05A9F}"/>
          </ac:grpSpMkLst>
        </pc:grp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4" creationId="{C61A9ACD-A35E-CABF-DC0F-DFC3FE911A68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5" creationId="{D529FFCD-96DD-2085-D658-05BE8822553F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7" creationId="{570C03D4-9885-1DE9-A161-07890068A4F9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0" creationId="{47239B5B-AE66-30F7-4FE8-F032BB78F5AE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3" creationId="{6384335C-79AE-8172-D5DF-7529DDE9B744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6" creationId="{4A4092D2-96F2-FA8F-E9AB-2569B80AAA70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7" creationId="{C2F012C9-F323-36DA-07F4-CEA68E0FBAF6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24" creationId="{7158A9C9-E5E3-F9F3-6597-D9E12877E31C}"/>
          </ac:picMkLst>
        </pc:picChg>
      </pc:sldChg>
      <pc:sldChg chg="addSp delSp modSp mod">
        <pc:chgData name="Go" userId="b11a5121-062d-4360-8951-d081ad96d999" providerId="ADAL" clId="{A37B11FE-7E2B-4B71-9282-AB38B86228CA}" dt="2022-10-14T01:53:43.823" v="1347" actId="478"/>
        <pc:sldMkLst>
          <pc:docMk/>
          <pc:sldMk cId="765565405" sldId="295"/>
        </pc:sldMkLst>
        <pc:spChg chg="add del mod">
          <ac:chgData name="Go" userId="b11a5121-062d-4360-8951-d081ad96d999" providerId="ADAL" clId="{A37B11FE-7E2B-4B71-9282-AB38B86228CA}" dt="2022-10-13T20:39:51.738" v="1124" actId="478"/>
          <ac:spMkLst>
            <pc:docMk/>
            <pc:sldMk cId="765565405" sldId="295"/>
            <ac:spMk id="2" creationId="{7288BBF4-1537-B43B-BB42-DA412F0CAAEB}"/>
          </ac:spMkLst>
        </pc:spChg>
        <pc:spChg chg="del">
          <ac:chgData name="Go" userId="b11a5121-062d-4360-8951-d081ad96d999" providerId="ADAL" clId="{A37B11FE-7E2B-4B71-9282-AB38B86228CA}" dt="2022-10-13T20:39:37.685" v="1122" actId="478"/>
          <ac:spMkLst>
            <pc:docMk/>
            <pc:sldMk cId="765565405" sldId="295"/>
            <ac:spMk id="6" creationId="{47B992C5-C82F-9A33-E06F-0CF2A4077CC8}"/>
          </ac:spMkLst>
        </pc:spChg>
        <pc:spChg chg="del">
          <ac:chgData name="Go" userId="b11a5121-062d-4360-8951-d081ad96d999" providerId="ADAL" clId="{A37B11FE-7E2B-4B71-9282-AB38B86228CA}" dt="2022-10-13T20:40:53.102" v="1133" actId="478"/>
          <ac:spMkLst>
            <pc:docMk/>
            <pc:sldMk cId="765565405" sldId="295"/>
            <ac:spMk id="32" creationId="{01000DD1-93DA-1423-F7E5-5A48E9CC7F42}"/>
          </ac:spMkLst>
        </pc:spChg>
        <pc:spChg chg="add mod">
          <ac:chgData name="Go" userId="b11a5121-062d-4360-8951-d081ad96d999" providerId="ADAL" clId="{A37B11FE-7E2B-4B71-9282-AB38B86228CA}" dt="2022-10-13T20:42:07.095" v="1155" actId="1036"/>
          <ac:spMkLst>
            <pc:docMk/>
            <pc:sldMk cId="765565405" sldId="295"/>
            <ac:spMk id="36" creationId="{F245A393-AA8C-8E50-A7C0-9BBDD069179F}"/>
          </ac:spMkLst>
        </pc:spChg>
        <pc:spChg chg="add mod">
          <ac:chgData name="Go" userId="b11a5121-062d-4360-8951-d081ad96d999" providerId="ADAL" clId="{A37B11FE-7E2B-4B71-9282-AB38B86228CA}" dt="2022-10-13T20:41:15.141" v="1141" actId="1076"/>
          <ac:spMkLst>
            <pc:docMk/>
            <pc:sldMk cId="765565405" sldId="295"/>
            <ac:spMk id="37" creationId="{660F6457-F508-AE06-1A3B-E3DBC117B738}"/>
          </ac:spMkLst>
        </pc:spChg>
        <pc:picChg chg="add del mod">
          <ac:chgData name="Go" userId="b11a5121-062d-4360-8951-d081ad96d999" providerId="ADAL" clId="{A37B11FE-7E2B-4B71-9282-AB38B86228CA}" dt="2022-10-14T01:53:43.823" v="1347" actId="478"/>
          <ac:picMkLst>
            <pc:docMk/>
            <pc:sldMk cId="765565405" sldId="295"/>
            <ac:picMk id="40" creationId="{5DDE6FC3-ECFB-5D45-AE89-4D8A04E171F8}"/>
          </ac:picMkLst>
        </pc:picChg>
        <pc:cxnChg chg="add del mod">
          <ac:chgData name="Go" userId="b11a5121-062d-4360-8951-d081ad96d999" providerId="ADAL" clId="{A37B11FE-7E2B-4B71-9282-AB38B86228CA}" dt="2022-10-13T20:40:54.620" v="1134" actId="478"/>
          <ac:cxnSpMkLst>
            <pc:docMk/>
            <pc:sldMk cId="765565405" sldId="295"/>
            <ac:cxnSpMk id="35" creationId="{D3EAD5EB-A2A1-BD4B-748C-6AD789159238}"/>
          </ac:cxnSpMkLst>
        </pc:cxnChg>
      </pc:sldChg>
      <pc:sldChg chg="modSp mod">
        <pc:chgData name="Go" userId="b11a5121-062d-4360-8951-d081ad96d999" providerId="ADAL" clId="{A37B11FE-7E2B-4B71-9282-AB38B86228CA}" dt="2022-10-15T01:47:01.280" v="1505" actId="20577"/>
        <pc:sldMkLst>
          <pc:docMk/>
          <pc:sldMk cId="970619779" sldId="297"/>
        </pc:sldMkLst>
        <pc:spChg chg="mod">
          <ac:chgData name="Go" userId="b11a5121-062d-4360-8951-d081ad96d999" providerId="ADAL" clId="{A37B11FE-7E2B-4B71-9282-AB38B86228CA}" dt="2022-10-15T01:46:40.900" v="1494" actId="20577"/>
          <ac:spMkLst>
            <pc:docMk/>
            <pc:sldMk cId="970619779" sldId="297"/>
            <ac:spMk id="1113" creationId="{39F2BCD9-900F-01E9-1717-5DA5F4D4C967}"/>
          </ac:spMkLst>
        </pc:spChg>
        <pc:spChg chg="mod">
          <ac:chgData name="Go" userId="b11a5121-062d-4360-8951-d081ad96d999" providerId="ADAL" clId="{A37B11FE-7E2B-4B71-9282-AB38B86228CA}" dt="2022-10-15T01:46:56.153" v="1502" actId="13926"/>
          <ac:spMkLst>
            <pc:docMk/>
            <pc:sldMk cId="970619779" sldId="297"/>
            <ac:spMk id="1185" creationId="{D9F5002C-825F-FC50-D3F7-F7E1E66A74B0}"/>
          </ac:spMkLst>
        </pc:spChg>
        <pc:spChg chg="mod">
          <ac:chgData name="Go" userId="b11a5121-062d-4360-8951-d081ad96d999" providerId="ADAL" clId="{A37B11FE-7E2B-4B71-9282-AB38B86228CA}" dt="2022-10-15T01:47:01.280" v="1505" actId="20577"/>
          <ac:spMkLst>
            <pc:docMk/>
            <pc:sldMk cId="970619779" sldId="297"/>
            <ac:spMk id="1221" creationId="{596C9DE2-9098-44CD-FA87-981A8ED98497}"/>
          </ac:spMkLst>
        </pc:spChg>
      </pc:sldChg>
      <pc:sldChg chg="addSp delSp modSp mod">
        <pc:chgData name="Go" userId="b11a5121-062d-4360-8951-d081ad96d999" providerId="ADAL" clId="{A37B11FE-7E2B-4B71-9282-AB38B86228CA}" dt="2022-10-15T01:45:25.502" v="1479" actId="20577"/>
        <pc:sldMkLst>
          <pc:docMk/>
          <pc:sldMk cId="3299870256" sldId="301"/>
        </pc:sldMkLst>
        <pc:spChg chg="mod">
          <ac:chgData name="Go" userId="b11a5121-062d-4360-8951-d081ad96d999" providerId="ADAL" clId="{A37B11FE-7E2B-4B71-9282-AB38B86228CA}" dt="2022-10-14T00:57:19.778" v="1193" actId="554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6" creationId="{2D415CC3-EC50-47BD-9C07-95599E264991}"/>
          </ac:spMkLst>
        </pc:spChg>
        <pc:spChg chg="add del mod">
          <ac:chgData name="Go" userId="b11a5121-062d-4360-8951-d081ad96d999" providerId="ADAL" clId="{A37B11FE-7E2B-4B71-9282-AB38B86228CA}" dt="2022-10-14T05:28:21.614" v="1473" actId="478"/>
          <ac:spMkLst>
            <pc:docMk/>
            <pc:sldMk cId="3299870256" sldId="301"/>
            <ac:spMk id="21" creationId="{0BCBD50A-D2DE-9423-2FCD-6A2AF9DA2E79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24" creationId="{DE2A6ADC-279B-EB8D-4D1B-8A1449932BC7}"/>
          </ac:spMkLst>
        </pc:spChg>
        <pc:spChg chg="mod topLvl">
          <ac:chgData name="Go" userId="b11a5121-062d-4360-8951-d081ad96d999" providerId="ADAL" clId="{A37B11FE-7E2B-4B71-9282-AB38B86228CA}" dt="2022-10-14T01:36:07.890" v="1310" actId="164"/>
          <ac:spMkLst>
            <pc:docMk/>
            <pc:sldMk cId="3299870256" sldId="301"/>
            <ac:spMk id="37" creationId="{873ABBA6-F404-2931-A177-FA14A024DAE1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4" creationId="{089D6C4B-E85D-1CD3-914B-2088CDFD16BB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99" creationId="{C89A6AE9-D9E0-46E2-ACDE-19A7EC9088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100" creationId="{F6DAD6F7-1072-4389-B036-7467DC7F1C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7" creationId="{8A76B3BE-6305-3092-D6E1-5320853AEDB0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2" creationId="{F68DB3C2-4564-74AC-DFC6-43FCC3D3E48B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3" creationId="{AF8279E9-D98F-4C66-2611-E40CEBB01977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4" creationId="{062BBD42-984D-069F-1412-A08C27DAFD2C}"/>
          </ac:spMkLst>
        </pc:spChg>
        <pc:spChg chg="add mod topLvl">
          <ac:chgData name="Go" userId="b11a5121-062d-4360-8951-d081ad96d999" providerId="ADAL" clId="{A37B11FE-7E2B-4B71-9282-AB38B86228CA}" dt="2022-10-14T00:59:52.956" v="1242" actId="554"/>
          <ac:spMkLst>
            <pc:docMk/>
            <pc:sldMk cId="3299870256" sldId="301"/>
            <ac:spMk id="147" creationId="{F8F1AE5A-A214-4AA6-B7F8-28DC4C5193D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1" creationId="{410B34D5-B21B-1370-706A-E83FD2C998D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2" creationId="{5CA570F2-FD9E-C7C0-BED4-4844B823FFD2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3" creationId="{C8331F8C-B2BF-090A-B61A-EA551E60FF4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4" creationId="{32C6731D-4C97-B09A-895D-9591540B3CA3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5" creationId="{72FAA0B2-0F23-A665-57A5-DD5AF0F7FDB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6" creationId="{D37F5891-CB3D-0432-66EB-7AACF067DA6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7" creationId="{C5C9552E-F78D-0C3F-9E24-A306C70AD2A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4" creationId="{797590FF-41DB-2D3E-7727-D12E05DA07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5" creationId="{7DAC27D9-CD5C-0A1E-6661-5E581B5CE1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0" creationId="{AD58643F-7E35-7DF6-0A9E-666FB89DA40A}"/>
          </ac:spMkLst>
        </pc:spChg>
        <pc:spChg chg="mod topLvl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3" creationId="{B1D845A5-3098-D846-9A7C-1E92E624AA0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6" creationId="{30116284-ABB0-05C0-8ECF-05A13F661117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7" creationId="{B04C50BB-6C20-23E9-2C3D-67C921011979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9" creationId="{223152C6-6F3E-4B9C-1FAB-6FE3606B51DA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1" creationId="{050F6027-1DFF-7CE2-01D4-531DFC658F2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3" creationId="{A8ABD308-10EB-1461-E88B-37AA7F48C2C0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5" creationId="{DC094AB9-5000-D2A7-51BE-B2B71B1F027B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7" creationId="{FC66F015-C44C-65B9-1C1F-9266CA083B4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9" creationId="{9F8BD057-798E-C352-0523-F8ED43AB17C1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91" creationId="{F3A5E892-050B-70EB-D2CC-62D5FBF30FD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4" creationId="{EE94773D-5D9B-1C40-E368-03AF1BD63AF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6" creationId="{C42C49A1-C07F-4823-E569-91B91B755B4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7" creationId="{1103D0D3-6D6E-40A8-68C4-264398024C3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8" creationId="{F9EA1132-45A4-2108-6B16-3A0E2423231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9" creationId="{B08E2F55-95F2-B43E-00B2-0C0A0F36AA8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0" creationId="{76EDAA07-94BC-156E-0580-C09DA35F535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1" creationId="{8740DBA2-4FF4-6B96-159C-2DC0BD0D939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2" creationId="{E29DD96A-7BA8-0D91-4F6A-96AC9EDC3781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4" creationId="{9CD771A1-8D0D-352A-8060-AD4928AB94D8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6" creationId="{D0FC6218-5698-90CE-F787-8BBA6078919D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8" creationId="{2A7499D1-1E3B-A887-1963-B1383A8CF87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0" creationId="{86EC0BC4-A1E4-CD4A-0F01-A44D291FF2E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2" creationId="{CEBEB22F-93EF-38BE-DFF4-CC4920E6861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4" creationId="{91A9AE94-577E-8E33-C932-431481F040F2}"/>
          </ac:spMkLst>
        </pc:spChg>
        <pc:spChg chg="mod">
          <ac:chgData name="Go" userId="b11a5121-062d-4360-8951-d081ad96d999" providerId="ADAL" clId="{A37B11FE-7E2B-4B71-9282-AB38B86228CA}" dt="2022-10-13T19:37:49.807" v="278" actId="20577"/>
          <ac:spMkLst>
            <pc:docMk/>
            <pc:sldMk cId="3299870256" sldId="301"/>
            <ac:spMk id="215" creationId="{131802D4-FD62-DC83-FE86-405BECC0C5A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6" creationId="{6EE8B2C0-C171-F025-FF38-79271C556B5F}"/>
          </ac:spMkLst>
        </pc:spChg>
        <pc:spChg chg="mod topLvl">
          <ac:chgData name="Go" userId="b11a5121-062d-4360-8951-d081ad96d999" providerId="ADAL" clId="{A37B11FE-7E2B-4B71-9282-AB38B86228CA}" dt="2022-10-14T04:48:12.717" v="1469" actId="20577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19" creationId="{6D8CA97D-F558-BC5F-31A4-DE0F2829044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0" creationId="{889F0B7B-5A9E-19BE-28A5-B1EBE2A39EC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1" creationId="{13522CE3-C41C-10C4-F76C-DF37342B9C4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2" creationId="{24D16945-1AFD-F22D-7D89-AB65CCE4FB41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3" creationId="{64BB2A03-9676-EC4E-4315-26C55CFBA8F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6" creationId="{7EFDD885-E759-5633-16AB-83EBABFD10F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8" creationId="{EEB83C73-C9F0-F538-9D71-F91A136029B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1" creationId="{E20DBB86-5321-43D4-CB59-5868ACA36A90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2" creationId="{F80AF707-F9C5-DFF3-4775-E6E60AC6BC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5" creationId="{E5E79CFE-CF5A-258B-9604-679C5D9AA6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7" creationId="{89D1BCF2-D4AC-8C3F-17A1-9C25E61AACD4}"/>
          </ac:spMkLst>
        </pc:spChg>
        <pc:spChg chg="add mod topLvl">
          <ac:chgData name="Go" userId="b11a5121-062d-4360-8951-d081ad96d999" providerId="ADAL" clId="{A37B11FE-7E2B-4B71-9282-AB38B86228CA}" dt="2022-10-14T02:29:48.593" v="1455" actId="165"/>
          <ac:spMkLst>
            <pc:docMk/>
            <pc:sldMk cId="3299870256" sldId="301"/>
            <ac:spMk id="239" creationId="{55468863-7BBD-8A76-7C95-BCDCE8D1690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2" creationId="{38A457A0-6299-A36D-F9B4-45B52B2DE62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3" creationId="{EE0326AC-C714-2619-B53B-3301BC65247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5" creationId="{BC9EF48A-F0A0-2C75-14C4-D4F63F70D2BD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7" creationId="{EDD17BF4-DD9A-E43E-C91C-936DA3F1C64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9" creationId="{5B97B126-3602-DBBE-E080-38451E40E46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1" creationId="{324AE1E1-B787-38F6-A0CC-407494CA79A5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3" creationId="{DFE31705-E4C4-DEF6-9035-25B45B8B5F37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5" creationId="{9A070BDD-A588-B11F-531A-59BBB3CEDF13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7" creationId="{AB60716B-3E83-4CBF-FBED-16441BEF075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8" creationId="{914F3C87-7FCA-419B-1E93-14D6129C080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9" creationId="{8B257F69-AB3F-5C08-4EB2-6F4244C62D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0" creationId="{DE906DF3-C9AF-1C9B-E116-A6DCDB37989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1" creationId="{0912BD74-E735-9597-BEF9-74C9A57A78A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2" creationId="{4E4E8A32-917C-289D-6F00-1AB3E3E5E713}"/>
          </ac:spMkLst>
        </pc:spChg>
        <pc:spChg chg="mod topLvl">
          <ac:chgData name="Go" userId="b11a5121-062d-4360-8951-d081ad96d999" providerId="ADAL" clId="{A37B11FE-7E2B-4B71-9282-AB38B86228CA}" dt="2022-10-14T04:48:15.954" v="1470" actId="20577"/>
          <ac:spMkLst>
            <pc:docMk/>
            <pc:sldMk cId="3299870256" sldId="301"/>
            <ac:spMk id="273" creationId="{C210E4EB-3C52-AF8D-4A79-5A61361B4082}"/>
          </ac:spMkLst>
        </pc:spChg>
        <pc:spChg chg="mod topLvl">
          <ac:chgData name="Go" userId="b11a5121-062d-4360-8951-d081ad96d999" providerId="ADAL" clId="{A37B11FE-7E2B-4B71-9282-AB38B86228CA}" dt="2022-10-13T19:59:05.306" v="496" actId="164"/>
          <ac:spMkLst>
            <pc:docMk/>
            <pc:sldMk cId="3299870256" sldId="301"/>
            <ac:spMk id="281" creationId="{1369908A-0A01-7976-2954-B5D6EF43679B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3" creationId="{E3F5427E-0639-BBD4-6023-720F1BD74CB1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5" creationId="{4D89257F-ADA3-4D9F-69B3-BE376248B92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7" creationId="{C96BEBA5-198A-60C9-97E3-3D213A1DE43E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9" creationId="{9EF922F4-6E43-7047-6E71-A344DF1A146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91" creationId="{3E1A0532-51CA-BA86-754F-0B6DB8FB50F5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294" creationId="{677421E6-57E3-4798-6373-C17F5D175D9A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3" creationId="{7DD169BB-39E6-03F8-84E4-00C88278E47A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5" creationId="{8F842E5A-061E-FBF8-D81A-961C95AE4D98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7" creationId="{1CFD66BD-464B-F4F9-CB0F-827B3F7EAADC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9" creationId="{418769DE-D879-63BB-AE3A-950845F6CDA3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1" creationId="{B5AF5CE1-DAE3-6A69-94E6-9CCBDDB7A4C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3" creationId="{D1329BDE-346B-4B3C-A2FF-2DDE44C2227B}"/>
          </ac:spMkLst>
        </pc:spChg>
        <pc:spChg chg="del mod topLvl">
          <ac:chgData name="Go" userId="b11a5121-062d-4360-8951-d081ad96d999" providerId="ADAL" clId="{A37B11FE-7E2B-4B71-9282-AB38B86228CA}" dt="2022-10-13T20:15:28.643" v="716" actId="478"/>
          <ac:spMkLst>
            <pc:docMk/>
            <pc:sldMk cId="3299870256" sldId="301"/>
            <ac:spMk id="321" creationId="{7933A066-F9C5-BA68-6D9B-EA66E4D763E3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3" creationId="{56EAB5A6-DA9A-1633-90AF-5C2407E9ACBF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5" creationId="{76F53C94-1C4B-8B2B-3722-4828FDC374B6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7" creationId="{E1A00A2D-5FC7-1B94-AFB9-0F7EA0B0965C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9" creationId="{1B6D271F-8BC9-BF59-3720-402DCE293261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33" creationId="{995AB39E-D048-F3F8-8DC9-3FB4AAE5D86E}"/>
          </ac:spMkLst>
        </pc:spChg>
        <pc:spChg chg="add del mod topLvl">
          <ac:chgData name="Go" userId="b11a5121-062d-4360-8951-d081ad96d999" providerId="ADAL" clId="{A37B11FE-7E2B-4B71-9282-AB38B86228CA}" dt="2022-10-13T20:37:11.999" v="1065" actId="478"/>
          <ac:spMkLst>
            <pc:docMk/>
            <pc:sldMk cId="3299870256" sldId="301"/>
            <ac:spMk id="338" creationId="{F61388DE-78D6-A063-F8E2-2E1EB0C288EB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2" creationId="{5B182495-D05C-96FA-90A6-B181E5093098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3" creationId="{88163E27-4BD9-6721-43BC-FC14157C7427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4" creationId="{3F91C208-2C69-E38B-1897-E6CDBB5D543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5" creationId="{22FD6676-1D73-9E66-4253-E581101CE7EF}"/>
          </ac:spMkLst>
        </pc:spChg>
        <pc:spChg chg="mod topLvl">
          <ac:chgData name="Go" userId="b11a5121-062d-4360-8951-d081ad96d999" providerId="ADAL" clId="{A37B11FE-7E2B-4B71-9282-AB38B86228CA}" dt="2022-10-14T00:58:30.819" v="1209" actId="1036"/>
          <ac:spMkLst>
            <pc:docMk/>
            <pc:sldMk cId="3299870256" sldId="301"/>
            <ac:spMk id="347" creationId="{8C2F235E-BE56-B400-BDA7-5C1A101B84CD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48" creationId="{2A461E41-4216-804B-0458-33A2868184C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3" creationId="{1F4CA620-E81E-2F50-4DA7-C796E90AC79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4" creationId="{67A08CF0-2928-977E-98A5-CFDF5FC048E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5" creationId="{3B8B14B8-A98A-D94A-537F-D4BA1BD9C84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6" creationId="{21CA8342-E53C-1399-DB93-98E1343B97D4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7" creationId="{18AC1B22-6F97-05EE-AAF5-FE7524CC6C7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8" creationId="{ABDBAC41-3AA4-B8E0-2AEA-507E1DAD2F9B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9" creationId="{55D50987-4EE4-E058-8699-52B43934212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0" creationId="{361DFD0E-6289-4549-33CE-BA74C4A458BC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1" creationId="{7F295788-CB92-F4DB-5157-B691C112E0DA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2" creationId="{B6FE5AD6-2AEF-DDC3-74C7-91BBEA0D846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3" creationId="{0D339847-D246-EAF2-4A13-5EFEDD0EC755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4" creationId="{A43BB9FD-A784-657A-B34B-0E0533415E3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5" creationId="{03D66B09-C79D-3129-8189-FF4AE8E228E1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6" creationId="{5F7E0991-BECC-20EF-901D-EAB2B04864D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367" creationId="{1CE6BBD2-914A-B05C-14F0-406EAAD341E0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9" creationId="{6A0B3758-47AE-CAB8-B244-037548C315E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0" creationId="{58300AB8-C197-A261-49FD-C1C855DC6A8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1" creationId="{B8CC8457-3C8D-BCAA-998C-4CDCF8725E1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2" creationId="{6B92EA03-FA8A-9F99-5D6F-95A7565A202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3" creationId="{2789CC9A-BB73-C89F-238A-C7A0AACD5F48}"/>
          </ac:spMkLst>
        </pc:spChg>
        <pc:spChg chg="add mod">
          <ac:chgData name="Go" userId="b11a5121-062d-4360-8951-d081ad96d999" providerId="ADAL" clId="{A37B11FE-7E2B-4B71-9282-AB38B86228CA}" dt="2022-10-14T01:00:36.842" v="1249" actId="1076"/>
          <ac:spMkLst>
            <pc:docMk/>
            <pc:sldMk cId="3299870256" sldId="301"/>
            <ac:spMk id="375" creationId="{D8E59C99-FE38-C093-2603-38F0FAF81006}"/>
          </ac:spMkLst>
        </pc:spChg>
        <pc:spChg chg="add del mod">
          <ac:chgData name="Go" userId="b11a5121-062d-4360-8951-d081ad96d999" providerId="ADAL" clId="{A37B11FE-7E2B-4B71-9282-AB38B86228CA}" dt="2022-10-14T01:33:53.139" v="1290" actId="478"/>
          <ac:spMkLst>
            <pc:docMk/>
            <pc:sldMk cId="3299870256" sldId="301"/>
            <ac:spMk id="376" creationId="{B2628F72-15A4-CC7F-80F0-4C978868CE08}"/>
          </ac:spMkLst>
        </pc:spChg>
        <pc:spChg chg="add del mod">
          <ac:chgData name="Go" userId="b11a5121-062d-4360-8951-d081ad96d999" providerId="ADAL" clId="{A37B11FE-7E2B-4B71-9282-AB38B86228CA}" dt="2022-10-14T02:29:24.684" v="1453" actId="478"/>
          <ac:spMkLst>
            <pc:docMk/>
            <pc:sldMk cId="3299870256" sldId="301"/>
            <ac:spMk id="377" creationId="{5B62DD5F-9DED-CCE0-B537-41C43ABF0433}"/>
          </ac:spMkLst>
        </pc:spChg>
        <pc:spChg chg="mod">
          <ac:chgData name="Go" userId="b11a5121-062d-4360-8951-d081ad96d999" providerId="ADAL" clId="{A37B11FE-7E2B-4B71-9282-AB38B86228CA}" dt="2022-10-13T20:28:51.124" v="1025" actId="1076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A37B11FE-7E2B-4B71-9282-AB38B86228CA}" dt="2022-10-14T04:48:18.557" v="1471" actId="20577"/>
          <ac:spMkLst>
            <pc:docMk/>
            <pc:sldMk cId="3299870256" sldId="301"/>
            <ac:spMk id="386" creationId="{A2558EC1-8F79-87E0-9F0A-99507D5576B2}"/>
          </ac:spMkLst>
        </pc:spChg>
        <pc:spChg chg="add del mod">
          <ac:chgData name="Go" userId="b11a5121-062d-4360-8951-d081ad96d999" providerId="ADAL" clId="{A37B11FE-7E2B-4B71-9282-AB38B86228CA}" dt="2022-10-14T01:35:57.189" v="1304" actId="478"/>
          <ac:spMkLst>
            <pc:docMk/>
            <pc:sldMk cId="3299870256" sldId="301"/>
            <ac:spMk id="387" creationId="{5B255E18-82A7-5851-9AFC-6200480DA9F3}"/>
          </ac:spMkLst>
        </pc:spChg>
        <pc:spChg chg="add 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388" creationId="{0C1977C0-E865-A02A-3AE8-62B202FA0D49}"/>
          </ac:spMkLst>
        </pc:spChg>
        <pc:spChg chg="add del mod">
          <ac:chgData name="Go" userId="b11a5121-062d-4360-8951-d081ad96d999" providerId="ADAL" clId="{A37B11FE-7E2B-4B71-9282-AB38B86228CA}" dt="2022-10-14T05:28:19.845" v="1472" actId="478"/>
          <ac:spMkLst>
            <pc:docMk/>
            <pc:sldMk cId="3299870256" sldId="301"/>
            <ac:spMk id="400" creationId="{11176BA0-D140-7221-C5F0-E0D29AAF7CD4}"/>
          </ac:spMkLst>
        </pc:spChg>
        <pc:spChg chg="add mod">
          <ac:chgData name="Go" userId="b11a5121-062d-4360-8951-d081ad96d999" providerId="ADAL" clId="{A37B11FE-7E2B-4B71-9282-AB38B86228CA}" dt="2022-10-14T02:31:02.987" v="1466" actId="1076"/>
          <ac:spMkLst>
            <pc:docMk/>
            <pc:sldMk cId="3299870256" sldId="301"/>
            <ac:spMk id="401" creationId="{6D03CB62-9395-58D3-20AA-37BEE1BE1AEE}"/>
          </ac:spMkLst>
        </pc:spChg>
        <pc:spChg chg="mod">
          <ac:chgData name="Go" userId="b11a5121-062d-4360-8951-d081ad96d999" providerId="ADAL" clId="{A37B11FE-7E2B-4B71-9282-AB38B86228CA}" dt="2022-10-13T19:42:29.526" v="330" actId="164"/>
          <ac:spMkLst>
            <pc:docMk/>
            <pc:sldMk cId="3299870256" sldId="301"/>
            <ac:spMk id="404" creationId="{02ECC1BC-F39A-F87F-9CAA-AAC3D74418F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499" creationId="{3E85AFA4-C5F7-DF52-BB9E-66D505EBD6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04" creationId="{4A085E4F-99C9-9469-54B8-25B756BA80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20" creationId="{98230770-BA50-4A07-C329-6CF4E9E4E9F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A37B11FE-7E2B-4B71-9282-AB38B86228CA}" dt="2022-10-13T20:13:18.935" v="662" actId="1076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5" creationId="{3821EC33-988D-5E7A-366D-8526840CF9CB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580" creationId="{7792413A-1C5F-F801-4015-D5F0C3EBE6AD}"/>
          </ac:spMkLst>
        </pc:spChg>
        <pc:spChg chg="mod topLvl">
          <ac:chgData name="Go" userId="b11a5121-062d-4360-8951-d081ad96d999" providerId="ADAL" clId="{A37B11FE-7E2B-4B71-9282-AB38B86228CA}" dt="2022-10-14T01:36:06.800" v="1309" actId="164"/>
          <ac:spMkLst>
            <pc:docMk/>
            <pc:sldMk cId="3299870256" sldId="301"/>
            <ac:spMk id="585" creationId="{E23D58ED-5C8D-3D42-D41C-1749190240B7}"/>
          </ac:spMkLst>
        </pc:spChg>
        <pc:spChg chg="mod">
          <ac:chgData name="Go" userId="b11a5121-062d-4360-8951-d081ad96d999" providerId="ADAL" clId="{A37B11FE-7E2B-4B71-9282-AB38B86228CA}" dt="2022-10-13T20:12:06.081" v="648" actId="1035"/>
          <ac:spMkLst>
            <pc:docMk/>
            <pc:sldMk cId="3299870256" sldId="301"/>
            <ac:spMk id="586" creationId="{205EBF96-3975-9EBB-82BF-524229ADCA56}"/>
          </ac:spMkLst>
        </pc:spChg>
        <pc:spChg chg="mod topLvl">
          <ac:chgData name="Go" userId="b11a5121-062d-4360-8951-d081ad96d999" providerId="ADAL" clId="{A37B11FE-7E2B-4B71-9282-AB38B86228CA}" dt="2022-10-14T01:36:21.436" v="1316" actId="164"/>
          <ac:spMkLst>
            <pc:docMk/>
            <pc:sldMk cId="3299870256" sldId="301"/>
            <ac:spMk id="588" creationId="{A32DF1B7-4FEE-A5A9-0149-91E988297B3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6" creationId="{D90BAA66-82BF-AB0E-F44E-A36937766776}"/>
          </ac:spMkLst>
        </pc:spChg>
        <pc:spChg chg="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597" creationId="{E6292181-C7C6-4CF8-A805-A931E21A76A1}"/>
          </ac:spMkLst>
        </pc:spChg>
        <pc:spChg chg="del mod topLvl">
          <ac:chgData name="Go" userId="b11a5121-062d-4360-8951-d081ad96d999" providerId="ADAL" clId="{A37B11FE-7E2B-4B71-9282-AB38B86228CA}" dt="2022-10-13T20:44:50.671" v="1174" actId="478"/>
          <ac:spMkLst>
            <pc:docMk/>
            <pc:sldMk cId="3299870256" sldId="301"/>
            <ac:spMk id="599" creationId="{E3E9E340-698C-4C41-C51F-F9688B6E4A7B}"/>
          </ac:spMkLst>
        </pc:spChg>
        <pc:spChg chg="mod topLvl">
          <ac:chgData name="Go" userId="b11a5121-062d-4360-8951-d081ad96d999" providerId="ADAL" clId="{A37B11FE-7E2B-4B71-9282-AB38B86228CA}" dt="2022-10-14T01:36:20.178" v="1315" actId="164"/>
          <ac:spMkLst>
            <pc:docMk/>
            <pc:sldMk cId="3299870256" sldId="301"/>
            <ac:spMk id="600" creationId="{25A313C0-ED4F-B2AC-AA3D-FC9850323AB4}"/>
          </ac:spMkLst>
        </pc:spChg>
        <pc:spChg chg="mod topLvl">
          <ac:chgData name="Go" userId="b11a5121-062d-4360-8951-d081ad96d999" providerId="ADAL" clId="{A37B11FE-7E2B-4B71-9282-AB38B86228CA}" dt="2022-10-14T01:36:05.499" v="1308" actId="164"/>
          <ac:spMkLst>
            <pc:docMk/>
            <pc:sldMk cId="3299870256" sldId="301"/>
            <ac:spMk id="601" creationId="{A697E26C-8009-3F24-4E68-358C8DEF8C11}"/>
          </ac:spMkLst>
        </pc:spChg>
        <pc:spChg chg="mod topLvl">
          <ac:chgData name="Go" userId="b11a5121-062d-4360-8951-d081ad96d999" providerId="ADAL" clId="{A37B11FE-7E2B-4B71-9282-AB38B86228CA}" dt="2022-10-14T01:36:14.970" v="1314" actId="164"/>
          <ac:spMkLst>
            <pc:docMk/>
            <pc:sldMk cId="3299870256" sldId="301"/>
            <ac:spMk id="603" creationId="{020F0874-AAB1-362B-9A95-E64C15A3E8FA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4" creationId="{7A9BDA8B-9DBA-9769-D99B-EFE7737C9653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7" creationId="{722E467E-3687-BA7D-239B-1BF6CF2A196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5" creationId="{2DEC7FC4-B77B-41B9-39FB-F34AC4A598DE}"/>
          </ac:spMkLst>
        </pc:spChg>
        <pc:spChg chg="mod topLvl">
          <ac:chgData name="Go" userId="b11a5121-062d-4360-8951-d081ad96d999" providerId="ADAL" clId="{A37B11FE-7E2B-4B71-9282-AB38B86228CA}" dt="2022-10-15T01:45:25.502" v="1479" actId="20577"/>
          <ac:spMkLst>
            <pc:docMk/>
            <pc:sldMk cId="3299870256" sldId="301"/>
            <ac:spMk id="627" creationId="{BB631823-0DC3-5C1A-041D-A50258A2A6BF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28" creationId="{31E8D49C-35CD-EDF2-DC82-42A21F575D80}"/>
          </ac:spMkLst>
        </pc:spChg>
        <pc:spChg chg="mod topLvl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9" creationId="{F9EE2836-7AC4-31A7-0E13-A86BEF57BE09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0" creationId="{F103AB24-EC14-CA9C-C4C8-EE62809B3B01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1" creationId="{2D9A61C5-B110-F215-6EE2-F5FA5C51E266}"/>
          </ac:spMkLst>
        </pc:spChg>
        <pc:spChg chg="mod topLvl">
          <ac:chgData name="Go" userId="b11a5121-062d-4360-8951-d081ad96d999" providerId="ADAL" clId="{A37B11FE-7E2B-4B71-9282-AB38B86228CA}" dt="2022-10-15T01:45:21.181" v="1476" actId="20577"/>
          <ac:spMkLst>
            <pc:docMk/>
            <pc:sldMk cId="3299870256" sldId="301"/>
            <ac:spMk id="633" creationId="{54DFD1DA-06A8-DAA2-E105-226D1953D5D8}"/>
          </ac:spMkLst>
        </pc:spChg>
        <pc:grpChg chg="mod topLvl">
          <ac:chgData name="Go" userId="b11a5121-062d-4360-8951-d081ad96d999" providerId="ADAL" clId="{A37B11FE-7E2B-4B71-9282-AB38B86228CA}" dt="2022-10-14T00:58:14.953" v="1205" actId="1037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6" creationId="{EFB1E376-C984-27E2-D7BA-ECC00BD555CB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8" creationId="{88008BFA-7955-448B-7576-35EA5B30252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17" creationId="{93C19B69-5A22-1796-D34A-E0CFBF4D294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0" creationId="{E21F8CEC-E83B-F070-D777-299FA4EAFA32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2" creationId="{263E61ED-5421-DE06-B82D-EE1732F3DA7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3" creationId="{65B76B05-D1BD-E06F-2690-D36B4A3C129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5" creationId="{08034CE4-3BE0-82C9-E197-E68BA40F9FFB}"/>
          </ac:grpSpMkLst>
        </pc:grpChg>
        <pc:grpChg chg="add del mod">
          <ac:chgData name="Go" userId="b11a5121-062d-4360-8951-d081ad96d999" providerId="ADAL" clId="{A37B11FE-7E2B-4B71-9282-AB38B86228CA}" dt="2022-10-13T19:25:12.606" v="201" actId="165"/>
          <ac:grpSpMkLst>
            <pc:docMk/>
            <pc:sldMk cId="3299870256" sldId="301"/>
            <ac:grpSpMk id="26" creationId="{3A610986-9E30-7E86-865F-33685AA918A1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7" creationId="{9722C1A9-94D4-550D-27FD-D9A371E8B1B3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8" creationId="{4C3A9C18-AA41-2261-76B8-6A3AF44FBB04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9" creationId="{A7DDF06A-382C-6CD8-C3E3-BE0952D0724E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0" creationId="{DE657C15-C591-D2D6-7331-C3DA2583BEC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1" creationId="{1B170842-CD20-41D8-BECA-DB0F71589DFC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4" creationId="{5CBAE8C0-4B65-AE6B-5DF5-74957DC4BC0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35" creationId="{3B5D5338-4068-0B8B-9A3F-750DB95A2FDC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0" creationId="{DA83DE12-C34C-C77E-7C63-AF20E33CF15F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1" creationId="{5A65F7AC-5AE9-8CE2-C5A0-43547C8A0C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A37B11FE-7E2B-4B71-9282-AB38B86228CA}" dt="2022-10-13T19:37:57.744" v="281" actId="164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2" creationId="{48E7B0E3-D283-8BA1-1AFA-8DE42C102D2F}"/>
          </ac:grpSpMkLst>
        </pc:grpChg>
        <pc:grpChg chg="mod topLvl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A37B11FE-7E2B-4B71-9282-AB38B86228CA}" dt="2022-10-13T19:42:29.526" v="330" actId="164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8" creationId="{C1E8B024-5731-5476-C6B6-95AA4CAD3B03}"/>
          </ac:grpSpMkLst>
        </pc:grpChg>
        <pc:grpChg chg="add del mod">
          <ac:chgData name="Go" userId="b11a5121-062d-4360-8951-d081ad96d999" providerId="ADAL" clId="{A37B11FE-7E2B-4B71-9282-AB38B86228CA}" dt="2022-10-14T00:59:40.964" v="1240" actId="165"/>
          <ac:grpSpMkLst>
            <pc:docMk/>
            <pc:sldMk cId="3299870256" sldId="301"/>
            <ac:grpSpMk id="148" creationId="{DA943FAE-201F-B1F7-CF56-BE6899E04EDE}"/>
          </ac:grpSpMkLst>
        </pc:grpChg>
        <pc:grpChg chg="add del mod">
          <ac:chgData name="Go" userId="b11a5121-062d-4360-8951-d081ad96d999" providerId="ADAL" clId="{A37B11FE-7E2B-4B71-9282-AB38B86228CA}" dt="2022-10-13T19:29:13.781" v="260" actId="478"/>
          <ac:grpSpMkLst>
            <pc:docMk/>
            <pc:sldMk cId="3299870256" sldId="301"/>
            <ac:grpSpMk id="149" creationId="{D3A98D2F-2446-214B-B826-9BB044E14D15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0" creationId="{05F86C2F-640D-E1D5-36EB-E6E50B8C3F91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8" creationId="{20C4011F-06A5-AD21-717D-E7DCFB5938BD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9" creationId="{888587E8-F72F-7AE3-6E49-39A5F6F39D88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0" creationId="{2503A332-E3D4-87E9-47D4-A2C1195791C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1" creationId="{81FB3C0B-C61C-C430-93FB-1E80A877F9F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2" creationId="{BACCF2D1-C048-E0F7-D0DD-15E11C95356C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3" creationId="{4A37BA4A-52DE-625C-3261-8EE61324ED0F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6" creationId="{AF619EF9-F673-DAA6-00F8-12297E94F04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7" creationId="{D0DA96D6-88AB-3185-11D5-A333C067C9B4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8" creationId="{03B504D3-9D18-15FC-01FA-6B74980B0B9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9" creationId="{7A29E34A-835F-0AE1-F6A4-8483D9010DE9}"/>
          </ac:grpSpMkLst>
        </pc:grpChg>
        <pc:grpChg chg="add del 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193" creationId="{89CCBB04-7A77-C318-6C19-2E834C00AD68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03" creationId="{CA055B1A-29F7-78DE-2EA1-2873F4ABC67E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17" creationId="{00040F81-2DC4-3E38-9036-FC1F1F38BE7F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4" creationId="{71E7D225-FA66-432D-8FC6-B6242D429D47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5" creationId="{BD3B101C-4210-8AF9-1348-81B31A70C4A5}"/>
          </ac:grpSpMkLst>
        </pc:grpChg>
        <pc:grpChg chg="add del mod">
          <ac:chgData name="Go" userId="b11a5121-062d-4360-8951-d081ad96d999" providerId="ADAL" clId="{A37B11FE-7E2B-4B71-9282-AB38B86228CA}" dt="2022-10-14T02:29:48.593" v="1455" actId="165"/>
          <ac:grpSpMkLst>
            <pc:docMk/>
            <pc:sldMk cId="3299870256" sldId="301"/>
            <ac:grpSpMk id="240" creationId="{BED4C65C-1302-ADDD-5052-6C97109E5888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59" creationId="{06052E30-B50E-1C14-3C48-1E6384204462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60" creationId="{DB986CF1-E1A6-C8BC-4A2D-B9BF80A0EBDC}"/>
          </ac:grpSpMkLst>
        </pc:grpChg>
        <pc:grpChg chg="add del 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61" creationId="{BD2AFFE4-E983-4043-6794-C32D45ACD43C}"/>
          </ac:grpSpMkLst>
        </pc:grpChg>
        <pc:grpChg chg="add del 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62" creationId="{61B0BC72-812D-A231-D96A-F6087C5E3EE6}"/>
          </ac:grpSpMkLst>
        </pc:grpChg>
        <pc:grpChg chg="add del mod">
          <ac:chgData name="Go" userId="b11a5121-062d-4360-8951-d081ad96d999" providerId="ADAL" clId="{A37B11FE-7E2B-4B71-9282-AB38B86228CA}" dt="2022-10-14T01:01:34.453" v="1259" actId="478"/>
          <ac:grpSpMkLst>
            <pc:docMk/>
            <pc:sldMk cId="3299870256" sldId="301"/>
            <ac:grpSpMk id="263" creationId="{B0AC73BE-6F55-4723-14F2-ADCD102BA898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64" creationId="{68282E87-717A-8666-E037-BFEC9228F9BE}"/>
          </ac:grpSpMkLst>
        </pc:grpChg>
        <pc:grpChg chg="mod topLvl">
          <ac:chgData name="Go" userId="b11a5121-062d-4360-8951-d081ad96d999" providerId="ADAL" clId="{A37B11FE-7E2B-4B71-9282-AB38B86228CA}" dt="2022-10-14T00:57:24.470" v="1194" actId="1038"/>
          <ac:grpSpMkLst>
            <pc:docMk/>
            <pc:sldMk cId="3299870256" sldId="301"/>
            <ac:grpSpMk id="265" creationId="{58D7A5F3-D98F-4285-EE18-1B7425AB048A}"/>
          </ac:grpSpMkLst>
        </pc:grpChg>
        <pc:grpChg chg="add del 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66" creationId="{FDD02D53-F9C4-E829-3548-2F53BFBEF7F5}"/>
          </ac:grpSpMkLst>
        </pc:grpChg>
        <pc:grpChg chg="add del mod">
          <ac:chgData name="Go" userId="b11a5121-062d-4360-8951-d081ad96d999" providerId="ADAL" clId="{A37B11FE-7E2B-4B71-9282-AB38B86228CA}" dt="2022-10-13T19:57:57.841" v="482" actId="165"/>
          <ac:grpSpMkLst>
            <pc:docMk/>
            <pc:sldMk cId="3299870256" sldId="301"/>
            <ac:grpSpMk id="267" creationId="{D4E4A787-B943-BF86-3346-2D6278942CFC}"/>
          </ac:grpSpMkLst>
        </pc:grpChg>
        <pc:grpChg chg="del mod topLvl">
          <ac:chgData name="Go" userId="b11a5121-062d-4360-8951-d081ad96d999" providerId="ADAL" clId="{A37B11FE-7E2B-4B71-9282-AB38B86228CA}" dt="2022-10-13T19:58:04.305" v="483" actId="165"/>
          <ac:grpSpMkLst>
            <pc:docMk/>
            <pc:sldMk cId="3299870256" sldId="301"/>
            <ac:grpSpMk id="274" creationId="{875AD099-F79F-5547-17A1-3CB1F0DE0D7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5" creationId="{2158226A-2A85-E602-9A30-79BEBEA3D320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6" creationId="{114847D3-18A6-759B-AE6B-087468152E16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7" creationId="{11523D18-64A6-16B0-416E-2EAD11284048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8" creationId="{AB8DEA19-BAE1-4C09-BCA8-37C2A07CE1E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9" creationId="{280A69EF-3FA3-42BF-A3BF-970EC68C35C7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92" creationId="{A8D94023-2F40-FAB7-4B38-1E6FEAAB6C72}"/>
          </ac:grpSpMkLst>
        </pc:grpChg>
        <pc:grpChg chg="add del mod">
          <ac:chgData name="Go" userId="b11a5121-062d-4360-8951-d081ad96d999" providerId="ADAL" clId="{A37B11FE-7E2B-4B71-9282-AB38B86228CA}" dt="2022-10-13T20:09:47.735" v="627"/>
          <ac:grpSpMkLst>
            <pc:docMk/>
            <pc:sldMk cId="3299870256" sldId="301"/>
            <ac:grpSpMk id="293" creationId="{B1964AB4-0E69-E994-4026-A46804A76D7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6" creationId="{FC6F99FC-79C9-2209-7971-392B413549E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7" creationId="{B0D4C18E-3363-8B56-22FE-A41267AA89FC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8" creationId="{1BB8B353-3D71-2B26-8968-183486501540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9" creationId="{52A52DF8-7456-73AB-62E4-82D75F8C0E88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0" creationId="{A5F6D758-F059-6A13-B942-EB95B8D109E7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1" creationId="{FC5468B3-7BDA-852D-9EB3-4C3821F961B5}"/>
          </ac:grpSpMkLst>
        </pc:grpChg>
        <pc:grpChg chg="add del mod">
          <ac:chgData name="Go" userId="b11a5121-062d-4360-8951-d081ad96d999" providerId="ADAL" clId="{A37B11FE-7E2B-4B71-9282-AB38B86228CA}" dt="2022-10-13T20:09:58.048" v="631" actId="165"/>
          <ac:grpSpMkLst>
            <pc:docMk/>
            <pc:sldMk cId="3299870256" sldId="301"/>
            <ac:grpSpMk id="314" creationId="{898D394D-672C-000D-342D-400772054CE8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5" creationId="{9DF2153F-54CF-41D9-92CA-304D9C0F4E19}"/>
          </ac:grpSpMkLst>
        </pc:grpChg>
        <pc:grpChg chg="mod topLvl">
          <ac:chgData name="Go" userId="b11a5121-062d-4360-8951-d081ad96d999" providerId="ADAL" clId="{A37B11FE-7E2B-4B71-9282-AB38B86228CA}" dt="2022-10-13T20:11:40.162" v="640" actId="164"/>
          <ac:grpSpMkLst>
            <pc:docMk/>
            <pc:sldMk cId="3299870256" sldId="301"/>
            <ac:grpSpMk id="316" creationId="{58532A4C-F9CD-9019-825E-0C65A6314E0C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7" creationId="{F03F37D9-D1DC-8D1E-1E1F-0E4F3AD1A154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8" creationId="{3A39B59E-48B3-8BE2-1987-B615FF746E62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9" creationId="{6E199C07-D00E-0C25-D136-995E9A39EAF9}"/>
          </ac:grpSpMkLst>
        </pc:grpChg>
        <pc:grpChg chg="add mod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36" creationId="{DCE78AD3-C711-3E16-3E7F-D857F61DDA9B}"/>
          </ac:grpSpMkLst>
        </pc:grpChg>
        <pc:grpChg chg="add mod topLvl">
          <ac:chgData name="Go" userId="b11a5121-062d-4360-8951-d081ad96d999" providerId="ADAL" clId="{A37B11FE-7E2B-4B71-9282-AB38B86228CA}" dt="2022-10-14T01:00:33.659" v="1248" actId="1076"/>
          <ac:grpSpMkLst>
            <pc:docMk/>
            <pc:sldMk cId="3299870256" sldId="301"/>
            <ac:grpSpMk id="337" creationId="{A592923E-902B-1B0D-72C1-7CA0B9A4BB1C}"/>
          </ac:grpSpMkLst>
        </pc:grpChg>
        <pc:grpChg chg="add del mod">
          <ac:chgData name="Go" userId="b11a5121-062d-4360-8951-d081ad96d999" providerId="ADAL" clId="{A37B11FE-7E2B-4B71-9282-AB38B86228CA}" dt="2022-10-13T20:37:11.999" v="1065" actId="478"/>
          <ac:grpSpMkLst>
            <pc:docMk/>
            <pc:sldMk cId="3299870256" sldId="301"/>
            <ac:grpSpMk id="339" creationId="{6676A960-59B6-7C0B-035C-8F4BE41BEDAA}"/>
          </ac:grpSpMkLst>
        </pc:grpChg>
        <pc:grpChg chg="add del mod">
          <ac:chgData name="Go" userId="b11a5121-062d-4360-8951-d081ad96d999" providerId="ADAL" clId="{A37B11FE-7E2B-4B71-9282-AB38B86228CA}" dt="2022-10-13T20:24:09.931" v="865" actId="165"/>
          <ac:grpSpMkLst>
            <pc:docMk/>
            <pc:sldMk cId="3299870256" sldId="301"/>
            <ac:grpSpMk id="340" creationId="{671D36F8-D555-942C-3E5D-AAA35E59A0A4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6" creationId="{E3EC0F57-23A8-8FFB-0A67-17581C852908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9" creationId="{2BA48B4E-73AD-40F9-7176-5EDE0323FA4B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50" creationId="{B1B0CBD4-0FAD-2780-2395-1FB3557AB250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1" creationId="{47D789D8-FE9C-BF73-69A9-D6B8EA12AA0E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2" creationId="{C52075DA-F236-C5A1-FFCF-53173DA2EF5D}"/>
          </ac:grpSpMkLst>
        </pc:grpChg>
        <pc:grpChg chg="add mod">
          <ac:chgData name="Go" userId="b11a5121-062d-4360-8951-d081ad96d999" providerId="ADAL" clId="{A37B11FE-7E2B-4B71-9282-AB38B86228CA}" dt="2022-10-14T00:58:24.463" v="1206" actId="1036"/>
          <ac:grpSpMkLst>
            <pc:docMk/>
            <pc:sldMk cId="3299870256" sldId="301"/>
            <ac:grpSpMk id="374" creationId="{AAF6BCB0-A71D-E66D-E543-E248480A65DC}"/>
          </ac:grpSpMkLst>
        </pc:grpChg>
        <pc:grpChg chg="add del mod">
          <ac:chgData name="Go" userId="b11a5121-062d-4360-8951-d081ad96d999" providerId="ADAL" clId="{A37B11FE-7E2B-4B71-9282-AB38B86228CA}" dt="2022-10-14T01:34:22.952" v="1296" actId="165"/>
          <ac:grpSpMkLst>
            <pc:docMk/>
            <pc:sldMk cId="3299870256" sldId="301"/>
            <ac:grpSpMk id="378" creationId="{5FFF24B6-C87F-CBE8-3E41-3B9ED19D81C8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89" creationId="{25FC274A-B6D8-289C-446E-766DA1432518}"/>
          </ac:grpSpMkLst>
        </pc:grpChg>
        <pc:grpChg chg="add mod">
          <ac:chgData name="Go" userId="b11a5121-062d-4360-8951-d081ad96d999" providerId="ADAL" clId="{A37B11FE-7E2B-4B71-9282-AB38B86228CA}" dt="2022-10-14T01:36:05.499" v="1308" actId="164"/>
          <ac:grpSpMkLst>
            <pc:docMk/>
            <pc:sldMk cId="3299870256" sldId="301"/>
            <ac:grpSpMk id="390" creationId="{88B4357D-F221-0FB8-5451-F494353BCF01}"/>
          </ac:grpSpMkLst>
        </pc:grpChg>
        <pc:grpChg chg="add mod">
          <ac:chgData name="Go" userId="b11a5121-062d-4360-8951-d081ad96d999" providerId="ADAL" clId="{A37B11FE-7E2B-4B71-9282-AB38B86228CA}" dt="2022-10-14T01:36:06.800" v="1309" actId="164"/>
          <ac:grpSpMkLst>
            <pc:docMk/>
            <pc:sldMk cId="3299870256" sldId="301"/>
            <ac:grpSpMk id="391" creationId="{56F5E0E1-433B-E0CD-9B1A-609B3A9E497D}"/>
          </ac:grpSpMkLst>
        </pc:grpChg>
        <pc:grpChg chg="add mod">
          <ac:chgData name="Go" userId="b11a5121-062d-4360-8951-d081ad96d999" providerId="ADAL" clId="{A37B11FE-7E2B-4B71-9282-AB38B86228CA}" dt="2022-10-14T01:36:07.890" v="1310" actId="164"/>
          <ac:grpSpMkLst>
            <pc:docMk/>
            <pc:sldMk cId="3299870256" sldId="301"/>
            <ac:grpSpMk id="392" creationId="{F3D96FC1-C2D2-7B17-73F0-75EA30515C07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93" creationId="{BB0A7282-2B13-93EF-0556-B0F550101E56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4" creationId="{ACAC60D1-21EC-ACB0-DEDE-C686500DE9BE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5" creationId="{1D1AE8C7-A0B7-49C4-EA03-8B8AC06968C1}"/>
          </ac:grpSpMkLst>
        </pc:grpChg>
        <pc:grpChg chg="add mod">
          <ac:chgData name="Go" userId="b11a5121-062d-4360-8951-d081ad96d999" providerId="ADAL" clId="{A37B11FE-7E2B-4B71-9282-AB38B86228CA}" dt="2022-10-14T01:36:20.178" v="1315" actId="164"/>
          <ac:grpSpMkLst>
            <pc:docMk/>
            <pc:sldMk cId="3299870256" sldId="301"/>
            <ac:grpSpMk id="396" creationId="{DB5C0BBC-03F2-39E0-1842-A4556752C54E}"/>
          </ac:grpSpMkLst>
        </pc:grpChg>
        <pc:grpChg chg="add mod">
          <ac:chgData name="Go" userId="b11a5121-062d-4360-8951-d081ad96d999" providerId="ADAL" clId="{A37B11FE-7E2B-4B71-9282-AB38B86228CA}" dt="2022-10-14T01:36:21.436" v="1316" actId="164"/>
          <ac:grpSpMkLst>
            <pc:docMk/>
            <pc:sldMk cId="3299870256" sldId="301"/>
            <ac:grpSpMk id="397" creationId="{B646B08F-FD34-C549-D704-3078D9996104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64" creationId="{17C21720-62CF-2EB6-2C65-7D0429926D99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94" creationId="{5541D77E-146B-9CA5-ABC1-585250266CB6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68" creationId="{706C3840-D8CA-33D8-4500-9CF9E3C9CD63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3" creationId="{FBA6C53D-B473-F3A3-9284-0CA75D11F752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4" creationId="{09B9E57B-C211-879A-4E02-D57C8D7370D5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1" creationId="{4E21338A-FC59-5D0F-6590-E5BBA4062FCA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2" creationId="{8285CAB0-3863-6BEB-31C1-2CA27C7772CF}"/>
          </ac:grpSpMkLst>
        </pc:grpChg>
        <pc:grpChg chg="del mod topLvl">
          <ac:chgData name="Go" userId="b11a5121-062d-4360-8951-d081ad96d999" providerId="ADAL" clId="{A37B11FE-7E2B-4B71-9282-AB38B86228CA}" dt="2022-10-13T19:25:23.053" v="204" actId="165"/>
          <ac:grpSpMkLst>
            <pc:docMk/>
            <pc:sldMk cId="3299870256" sldId="301"/>
            <ac:grpSpMk id="583" creationId="{C172713A-54D7-22D0-035B-9E05CBD66C13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5" creationId="{A1356258-CE95-6898-7C17-5897EA0D9115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6" creationId="{20C45F35-C86C-5E72-B540-C0B86CD2C27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639" creationId="{1DE898C2-E809-2B55-CF57-DE7A01B03F65}"/>
          </ac:grpSpMkLst>
        </pc:grpChg>
        <pc:graphicFrameChg chg="mod">
          <ac:chgData name="Go" userId="b11a5121-062d-4360-8951-d081ad96d999" providerId="ADAL" clId="{A37B11FE-7E2B-4B71-9282-AB38B86228CA}" dt="2022-10-13T19:39:15.377" v="292" actId="164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A37B11FE-7E2B-4B71-9282-AB38B86228CA}" dt="2022-10-14T00:57:07.779" v="1192" actId="165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A37B11FE-7E2B-4B71-9282-AB38B86228CA}" dt="2022-10-13T19:37:44.577" v="276" actId="164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mod topLvl">
          <ac:chgData name="Go" userId="b11a5121-062d-4360-8951-d081ad96d999" providerId="ADAL" clId="{A37B11FE-7E2B-4B71-9282-AB38B86228CA}" dt="2022-10-13T20:27:28.335" v="982" actId="164"/>
          <ac:graphicFrameMkLst>
            <pc:docMk/>
            <pc:sldMk cId="3299870256" sldId="301"/>
            <ac:graphicFrameMk id="341" creationId="{D64BF4A6-E3DC-8AAE-CAC2-318CE7EFEC5C}"/>
          </ac:graphicFrameMkLst>
        </pc:graphicFrameChg>
        <pc:picChg chg="mod topLvl">
          <ac:chgData name="Go" userId="b11a5121-062d-4360-8951-d081ad96d999" providerId="ADAL" clId="{A37B11FE-7E2B-4B71-9282-AB38B86228CA}" dt="2022-10-14T01:36:14.970" v="1314" actId="164"/>
          <ac:picMkLst>
            <pc:docMk/>
            <pc:sldMk cId="3299870256" sldId="301"/>
            <ac:picMk id="32" creationId="{2175B2CF-25CD-A072-BE64-BA372B9244D8}"/>
          </ac:picMkLst>
        </pc:picChg>
        <pc:picChg chg="mod topLvl">
          <ac:chgData name="Go" userId="b11a5121-062d-4360-8951-d081ad96d999" providerId="ADAL" clId="{A37B11FE-7E2B-4B71-9282-AB38B86228CA}" dt="2022-10-14T01:36:20.178" v="1315" actId="164"/>
          <ac:picMkLst>
            <pc:docMk/>
            <pc:sldMk cId="3299870256" sldId="301"/>
            <ac:picMk id="33" creationId="{86A53033-86F9-389C-04D5-9CD2C9AD01C7}"/>
          </ac:picMkLst>
        </pc:picChg>
        <pc:picChg chg="mod modCrop">
          <ac:chgData name="Go" userId="b11a5121-062d-4360-8951-d081ad96d999" providerId="ADAL" clId="{A37B11FE-7E2B-4B71-9282-AB38B86228CA}" dt="2022-10-13T20:31:51.861" v="1028" actId="732"/>
          <ac:picMkLst>
            <pc:docMk/>
            <pc:sldMk cId="3299870256" sldId="301"/>
            <ac:picMk id="57" creationId="{E1D85ABA-4B6A-4782-B82E-435A15947D01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1" creationId="{A560FC92-4919-4B14-889D-8C2914B72130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2" creationId="{9740845C-8279-4BED-92E8-8A0979FDFD33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3" creationId="{AE457A15-1519-464E-A3CE-71E3E325892C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7" creationId="{B94AD668-0A32-446F-BE51-E1497543E9EE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8" creationId="{A5F75C6C-B398-4E7A-812C-C7FBBC62310F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9" creationId="{75A60953-8AA9-4F02-B89B-EF8574966FFF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72" creationId="{FE95AE74-DC2E-9C0A-30F0-56061665B389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0" creationId="{599237E0-A6BA-B535-F78D-0455DD124D02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2" creationId="{E18B8620-6E4C-5622-6580-0071CB265FF6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4" creationId="{F9AD6C7D-96E2-2720-C7FF-986551E1E6EA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6" creationId="{37539F2F-9ABF-6C7B-B760-5A27B78D95CC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8" creationId="{FD7407D0-35C7-7024-0B01-1C8BD7630444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92" creationId="{F8D28C29-6038-2007-FEAB-6EE40969F86D}"/>
          </ac:picMkLst>
        </pc:picChg>
        <pc:picChg chg="mod topLvl">
          <ac:chgData name="Go" userId="b11a5121-062d-4360-8951-d081ad96d999" providerId="ADAL" clId="{A37B11FE-7E2B-4B71-9282-AB38B86228CA}" dt="2022-10-14T02:30:26.872" v="1461" actId="14100"/>
          <ac:picMkLst>
            <pc:docMk/>
            <pc:sldMk cId="3299870256" sldId="301"/>
            <ac:picMk id="195" creationId="{786CCD50-E8F9-E81C-0AAB-7EF8B6F3918F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5" creationId="{8E4A55A6-943E-0E63-1E18-354FD95B363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7" creationId="{DEB24383-22A9-2F3E-6C00-9C29A0BCD65F}"/>
          </ac:picMkLst>
        </pc:picChg>
        <pc:picChg chg="mod topLvl">
          <ac:chgData name="Go" userId="b11a5121-062d-4360-8951-d081ad96d999" providerId="ADAL" clId="{A37B11FE-7E2B-4B71-9282-AB38B86228CA}" dt="2022-10-14T02:30:31.387" v="1462" actId="14100"/>
          <ac:picMkLst>
            <pc:docMk/>
            <pc:sldMk cId="3299870256" sldId="301"/>
            <ac:picMk id="209" creationId="{10C6B6B0-2782-E2D0-9480-48DD6CA69FB6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1" creationId="{3D276DC3-F7EE-8569-6F10-9547D39EEA9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3" creationId="{8A301B36-7C95-FC89-871D-2FC646B973C1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27" creationId="{66CB2C0A-997F-312D-14F9-BB43C1C08538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1" creationId="{6225382C-CEA2-8A07-48CD-77F6215A93A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4" creationId="{D28A80E1-93DF-7A66-672F-928AF1D2583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6" creationId="{36F5ED06-1E8C-AE34-A972-C9583CAC886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8" creationId="{7D80C03B-9C9D-84CF-DC28-048A337FAFC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0" creationId="{587F0235-90D0-252A-5423-E5932CB64E65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2" creationId="{A5809071-133E-E097-D812-5A37CE8B345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4" creationId="{CFE60308-241A-5B01-3D08-54807436726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6" creationId="{AFCE8761-4598-82BE-E608-94FFCDAFE02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8" creationId="{FA1EF86B-68DA-C21E-D921-80FF67C57DD5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2" creationId="{87F1EA15-F692-1978-7957-6C6030F0498E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4" creationId="{1D4D6272-457D-FE94-E6ED-36CDD0772A4A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6" creationId="{9C796707-8624-499A-3CD4-02B4748A8439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8" creationId="{C2DEF756-D200-98E0-7B7E-8C3F707BD047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90" creationId="{30D2A285-EC12-EDAC-1CB7-BF966DCA26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4" creationId="{A5C76721-20CE-E278-3628-37B247E667C8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6" creationId="{DD9A4FDD-EAC9-697D-851C-564C4ECEF525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8" creationId="{4C2DB0C2-9CBE-8800-69E1-C9546D4CAC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0" creationId="{C0752B75-EC16-5B4F-C37B-1BB57DAF4526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2" creationId="{2C0B7C10-41CD-6AF9-3FEF-6B44B3CCA843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2" creationId="{64E61B9D-ABF2-DE7F-925C-92920B46FACF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4" creationId="{4FDEBCD0-7D59-A5F4-FAD9-BA6DE364DDD8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6" creationId="{CA49994B-E184-710F-F726-327CBE43296C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8" creationId="{C814B21F-8DC9-978F-83D8-F85C32A134A7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30" creationId="{50AD55B5-1E68-D51D-B42E-75DC66E83D0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379" creationId="{D4146D48-93B6-2FF3-81E7-9C112A4B30F0}"/>
          </ac:picMkLst>
        </pc:picChg>
        <pc:picChg chg="add mod topLvl modCrop">
          <ac:chgData name="Go" userId="b11a5121-062d-4360-8951-d081ad96d999" providerId="ADAL" clId="{A37B11FE-7E2B-4B71-9282-AB38B86228CA}" dt="2022-10-14T01:44:56.252" v="1320" actId="14100"/>
          <ac:picMkLst>
            <pc:docMk/>
            <pc:sldMk cId="3299870256" sldId="301"/>
            <ac:picMk id="380" creationId="{52F0F89B-193D-9C05-F8CD-D3CE67ED10CC}"/>
          </ac:picMkLst>
        </pc:picChg>
        <pc:picChg chg="add del mod">
          <ac:chgData name="Go" userId="b11a5121-062d-4360-8951-d081ad96d999" providerId="ADAL" clId="{A37B11FE-7E2B-4B71-9282-AB38B86228CA}" dt="2022-10-14T01:32:09.215" v="1267" actId="478"/>
          <ac:picMkLst>
            <pc:docMk/>
            <pc:sldMk cId="3299870256" sldId="301"/>
            <ac:picMk id="384" creationId="{8F844B30-6FC6-CCC8-550D-FBE282D07090}"/>
          </ac:picMkLst>
        </pc:picChg>
        <pc:picChg chg="add del mod">
          <ac:chgData name="Go" userId="b11a5121-062d-4360-8951-d081ad96d999" providerId="ADAL" clId="{A37B11FE-7E2B-4B71-9282-AB38B86228CA}" dt="2022-10-14T01:33:20.994" v="1286" actId="478"/>
          <ac:picMkLst>
            <pc:docMk/>
            <pc:sldMk cId="3299870256" sldId="301"/>
            <ac:picMk id="385" creationId="{F44476F1-1B01-3154-6B83-BFD8E9F47CD8}"/>
          </ac:picMkLst>
        </pc:picChg>
        <pc:picChg chg="add mod modCrop">
          <ac:chgData name="Go" userId="b11a5121-062d-4360-8951-d081ad96d999" providerId="ADAL" clId="{A37B11FE-7E2B-4B71-9282-AB38B86228CA}" dt="2022-10-14T02:30:45.589" v="1464" actId="1076"/>
          <ac:picMkLst>
            <pc:docMk/>
            <pc:sldMk cId="3299870256" sldId="301"/>
            <ac:picMk id="399" creationId="{F9E2993B-1F21-94E2-522E-705FFE1F3AC0}"/>
          </ac:picMkLst>
        </pc:picChg>
        <pc:picChg chg="mod topLvl">
          <ac:chgData name="Go" userId="b11a5121-062d-4360-8951-d081ad96d999" providerId="ADAL" clId="{A37B11FE-7E2B-4B71-9282-AB38B86228CA}" dt="2022-10-14T01:36:07.890" v="1310" actId="164"/>
          <ac:picMkLst>
            <pc:docMk/>
            <pc:sldMk cId="3299870256" sldId="301"/>
            <ac:picMk id="575" creationId="{6BEBEA05-1D4B-5D31-DB0F-1C7C69F0773F}"/>
          </ac:picMkLst>
        </pc:picChg>
        <pc:picChg chg="mod topLvl">
          <ac:chgData name="Go" userId="b11a5121-062d-4360-8951-d081ad96d999" providerId="ADAL" clId="{A37B11FE-7E2B-4B71-9282-AB38B86228CA}" dt="2022-10-14T01:36:06.800" v="1309" actId="164"/>
          <ac:picMkLst>
            <pc:docMk/>
            <pc:sldMk cId="3299870256" sldId="301"/>
            <ac:picMk id="584" creationId="{65E099EC-DF37-0FB7-4855-75B080ABBDCC}"/>
          </ac:picMkLst>
        </pc:picChg>
        <pc:picChg chg="mod topLvl modCrop">
          <ac:chgData name="Go" userId="b11a5121-062d-4360-8951-d081ad96d999" providerId="ADAL" clId="{A37B11FE-7E2B-4B71-9282-AB38B86228CA}" dt="2022-10-14T01:36:21.436" v="1316" actId="164"/>
          <ac:picMkLst>
            <pc:docMk/>
            <pc:sldMk cId="3299870256" sldId="301"/>
            <ac:picMk id="587" creationId="{7D6F430A-1C5C-3112-B7CF-1E2590BBA0CB}"/>
          </ac:picMkLst>
        </pc:picChg>
        <pc:picChg chg="del mod topLvl">
          <ac:chgData name="Go" userId="b11a5121-062d-4360-8951-d081ad96d999" providerId="ADAL" clId="{A37B11FE-7E2B-4B71-9282-AB38B86228CA}" dt="2022-10-13T20:44:49.183" v="1173" actId="478"/>
          <ac:picMkLst>
            <pc:docMk/>
            <pc:sldMk cId="3299870256" sldId="301"/>
            <ac:picMk id="589" creationId="{2ABF06E6-EEAE-48EA-B11A-625F8C9B6298}"/>
          </ac:picMkLst>
        </pc:picChg>
        <pc:picChg chg="mod ord topLvl">
          <ac:chgData name="Go" userId="b11a5121-062d-4360-8951-d081ad96d999" providerId="ADAL" clId="{A37B11FE-7E2B-4B71-9282-AB38B86228CA}" dt="2022-10-14T01:44:51.858" v="1319" actId="553"/>
          <ac:picMkLst>
            <pc:docMk/>
            <pc:sldMk cId="3299870256" sldId="301"/>
            <ac:picMk id="598" creationId="{CEED833A-E64F-B880-BB0C-53F165B34A39}"/>
          </ac:picMkLst>
        </pc:picChg>
        <pc:picChg chg="mod topLvl">
          <ac:chgData name="Go" userId="b11a5121-062d-4360-8951-d081ad96d999" providerId="ADAL" clId="{A37B11FE-7E2B-4B71-9282-AB38B86228CA}" dt="2022-10-14T01:36:05.499" v="1308" actId="164"/>
          <ac:picMkLst>
            <pc:docMk/>
            <pc:sldMk cId="3299870256" sldId="301"/>
            <ac:picMk id="602" creationId="{9D32713A-E1E1-E4ED-0C5F-FDD66A6BC6DF}"/>
          </ac:picMkLst>
        </pc:pic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4" creationId="{DCDE6181-4EE4-4CE9-B87D-C2F223928381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5" creationId="{0B4D26CA-7184-4164-A7A0-395716A8AF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0" creationId="{38A7C430-3563-4774-A34C-6F184920A4E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1" creationId="{24ED3403-A14E-478B-B263-3A63A5EBF9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2" creationId="{FF7C67B4-2C73-4E59-8E93-1234143CAE77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3" creationId="{981C2F62-03F3-4054-A706-F5CF44248249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146" creationId="{E5A01E2F-D923-7B8A-4376-3E5510F5BDFB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4" creationId="{7B096F60-44C9-25BE-9B07-BA1E416D8E0F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5" creationId="{E1108CE8-330C-441F-3887-76B03A1F171A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8" creationId="{350D44BE-6AAA-F538-1181-644E2C63FC39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90" creationId="{6E185FA5-7462-299C-A473-2C31C4A61910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29" creationId="{3AFDC835-E16C-64C7-E36F-6D452494FB8A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0" creationId="{0B05E7E3-BC15-0A5C-DFA2-1FC65FB7D022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3" creationId="{8074A64F-CF67-37F1-DFDA-55A586A11E2F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8" creationId="{BF540BCA-E2DD-B7DC-1BE2-7963F369D77A}"/>
          </ac:cxnSpMkLst>
        </pc:cxnChg>
        <pc:cxnChg chg="mod topLvl">
          <ac:chgData name="Go" userId="b11a5121-062d-4360-8951-d081ad96d999" providerId="ADAL" clId="{A37B11FE-7E2B-4B71-9282-AB38B86228CA}" dt="2022-10-13T19:59:05.306" v="496" actId="164"/>
          <ac:cxnSpMkLst>
            <pc:docMk/>
            <pc:sldMk cId="3299870256" sldId="301"/>
            <ac:cxnSpMk id="280" creationId="{71483C28-169B-5E49-FB08-F99A8867EA06}"/>
          </ac:cxnSpMkLst>
        </pc:cxnChg>
        <pc:cxnChg chg="mod">
          <ac:chgData name="Go" userId="b11a5121-062d-4360-8951-d081ad96d999" providerId="ADAL" clId="{A37B11FE-7E2B-4B71-9282-AB38B86228CA}" dt="2022-10-13T20:09:45.203" v="626"/>
          <ac:cxnSpMkLst>
            <pc:docMk/>
            <pc:sldMk cId="3299870256" sldId="301"/>
            <ac:cxnSpMk id="302" creationId="{71E0DB69-8833-F8B1-EA78-2DD037215BB5}"/>
          </ac:cxnSpMkLst>
        </pc:cxnChg>
        <pc:cxnChg chg="mod topLvl">
          <ac:chgData name="Go" userId="b11a5121-062d-4360-8951-d081ad96d999" providerId="ADAL" clId="{A37B11FE-7E2B-4B71-9282-AB38B86228CA}" dt="2022-10-13T20:11:40.162" v="640" actId="164"/>
          <ac:cxnSpMkLst>
            <pc:docMk/>
            <pc:sldMk cId="3299870256" sldId="301"/>
            <ac:cxnSpMk id="320" creationId="{6B53738C-27BF-CB34-A15A-246E1FE637F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1" creationId="{B69216E1-6575-1489-2D44-322046CBC33E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2" creationId="{9DF3C598-777D-BD61-9BD4-03BEBD85A8E2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4" creationId="{AA9A303D-7650-CB52-AC81-F0A6C13F7B6D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5" creationId="{9669EB3B-99E7-D90C-92BE-9B049A8DB7AA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5" creationId="{77F25675-7B55-4E09-01E1-94D6922AF56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6" creationId="{BEA321F4-F52F-6980-814F-CE03E2BD8E99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7" creationId="{7BADAB79-F454-2B66-6A91-7858FEAB433C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8" creationId="{6D1A51C3-C35B-30B8-E518-25E26BC7DB78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632" creationId="{9CF49B4E-790A-93D5-9972-4C45B0E7B7D5}"/>
          </ac:cxnSpMkLst>
        </pc:cxnChg>
      </pc:sldChg>
      <pc:sldChg chg="addSp delSp modSp new mod">
        <pc:chgData name="Go" userId="b11a5121-062d-4360-8951-d081ad96d999" providerId="ADAL" clId="{A37B11FE-7E2B-4B71-9282-AB38B86228CA}" dt="2022-10-14T02:00:56.036" v="1429" actId="164"/>
        <pc:sldMkLst>
          <pc:docMk/>
          <pc:sldMk cId="2069005311" sldId="302"/>
        </pc:sldMkLst>
        <pc:spChg chg="del">
          <ac:chgData name="Go" userId="b11a5121-062d-4360-8951-d081ad96d999" providerId="ADAL" clId="{A37B11FE-7E2B-4B71-9282-AB38B86228CA}" dt="2022-10-14T01:00:46.363" v="1251" actId="478"/>
          <ac:spMkLst>
            <pc:docMk/>
            <pc:sldMk cId="2069005311" sldId="302"/>
            <ac:spMk id="2" creationId="{F5B0F420-CC21-AA5A-9C72-9B1A9F298217}"/>
          </ac:spMkLst>
        </pc:spChg>
        <pc:spChg chg="del">
          <ac:chgData name="Go" userId="b11a5121-062d-4360-8951-d081ad96d999" providerId="ADAL" clId="{A37B11FE-7E2B-4B71-9282-AB38B86228CA}" dt="2022-10-14T01:00:43.390" v="1250" actId="478"/>
          <ac:spMkLst>
            <pc:docMk/>
            <pc:sldMk cId="2069005311" sldId="302"/>
            <ac:spMk id="3" creationId="{6F6B9B75-AA43-B4DE-F78A-7A92AB44B191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6" creationId="{7201332A-CE8F-EA78-8E01-D352071260E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8" creationId="{6E80E716-1388-DECF-371E-1E392B8503AB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3" creationId="{BC5672E3-3BA2-B802-B7F1-90B4FB27945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4" creationId="{C2994E3F-B475-77BB-DBB3-2C19C32EA91C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16" creationId="{962959EC-F6B9-E811-2B9D-A1CB077C647C}"/>
          </ac:spMkLst>
        </pc:spChg>
        <pc:spChg chg="mod topLvl">
          <ac:chgData name="Go" userId="b11a5121-062d-4360-8951-d081ad96d999" providerId="ADAL" clId="{A37B11FE-7E2B-4B71-9282-AB38B86228CA}" dt="2022-10-14T02:00:14.628" v="1412" actId="164"/>
          <ac:spMkLst>
            <pc:docMk/>
            <pc:sldMk cId="2069005311" sldId="302"/>
            <ac:spMk id="19" creationId="{85CDD789-3BE1-362E-4568-93BA3716E071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1" creationId="{3A3DFD42-FE4F-DC52-19DB-CA29A22880F9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2" creationId="{3257A8D9-033C-AED0-D1F9-500BCDFA786C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5" creationId="{5ADBB3AB-5C13-C5BE-B1A0-5A1EEF2BEFD4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6" creationId="{D96734F8-7CF1-631D-EEA1-981B62643BD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5" creationId="{990E21BF-643A-FE04-7F24-DBEDF1AA0CE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6" creationId="{D085FA2B-7379-A06A-D3A7-BA7A4A01617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7" creationId="{E30FEDBC-F209-55FC-778A-62D805167E0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8" creationId="{DF0470C2-60E4-D51E-8465-F38B205F6C6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9" creationId="{CD906AC6-3905-2824-E358-1E4D36142C1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0" creationId="{85BE65DA-0172-A046-B3A3-B5CEC8D5DCD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2" creationId="{A1D8E731-A41D-E180-AB69-9ECC77E2C6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3" creationId="{3486CAEF-F6AF-E62D-FFF8-E1C327F3EDB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4" creationId="{5D30EA5C-AD57-474C-A22F-F5AF1758EE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5" creationId="{66471B26-CE17-0F2D-086B-5F2111ABB1D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6" creationId="{AD3955E4-6EF6-C950-CE16-996185F2FC3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7" creationId="{450AC69B-3CA4-9D10-5236-5D79AC52A68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8" creationId="{489B0A1C-2B10-01EB-C7FD-C6C68F719DE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9" creationId="{D335B55C-D172-A17B-786C-B9C1A79C0D0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1" creationId="{D01F265F-7FA6-B3B7-6E4D-9237581EB86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2" creationId="{3D6D1C42-0510-CE8D-BFEE-A6D06F83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3" creationId="{C6034425-8B38-65C5-5B72-1F10F325EB1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4" creationId="{D6752323-53E9-C894-1419-64E4EC9FEE4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5" creationId="{A4A883A5-A35F-773E-A346-59F2C8B30AB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6" creationId="{8329FDA3-6515-FE52-68A5-41EBF455CF5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8" creationId="{54B3961D-901F-D9B1-7E5A-0AA991923ED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9" creationId="{3E7F6FE1-7A7E-AFD2-DB0D-35A8FD4C0C3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0" creationId="{CC878395-538B-7D90-96CD-B5E8243335B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1" creationId="{DA072248-5DB0-BBB1-8D19-CEEE979BB3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2" creationId="{2F00770D-E276-E49E-6F6C-C0247F738D7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3" creationId="{CA763550-89D3-AC2A-1F98-69B3C8BCAE6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5" creationId="{754CD4D9-DFD0-437F-D36F-4B5B6A667D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6" creationId="{D1C4BD5B-3085-977D-B1B4-7D1FA6FE0D9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7" creationId="{6DA05AB2-AD48-C63B-A9E2-68AB67ED94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8" creationId="{9359E7F3-2980-0BE4-CDE5-FAFBBCC4959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9" creationId="{D02B7B17-A300-614A-7083-C43DFC94761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0" creationId="{6B37E447-A62F-8A61-370E-08D171850B5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2" creationId="{3CD7D238-4606-A32D-0119-56C3E96DB18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3" creationId="{AEAF8A22-51E8-FBA0-7F25-B82302684A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4" creationId="{7A30CEC7-F23A-624F-C204-CB2684297EC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5" creationId="{E36C9280-06B0-7BAE-2C23-C45EFE46E9E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6" creationId="{67F8F2EF-DBB8-BADE-B4B4-EF285298B0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7" creationId="{F786F93A-241C-4B79-A49E-B81760D2DDD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9" creationId="{695B351B-56E7-9F0B-544D-666A38F4D1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0" creationId="{563B0552-675D-47C2-509A-69C4FD63559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1" creationId="{B39F3217-B036-CCE3-65EC-EF2A32AC2A1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2" creationId="{1094859F-7BA8-FBAE-0D20-F39ED965238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3" creationId="{3796D51C-34A9-D375-3315-911CF8BEB65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4" creationId="{2C4D0FCE-D400-0B8F-3920-EBD2F4A1712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5" creationId="{2E8E5CB3-C8BC-CE4B-ABD9-1E17BAED0FD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6" creationId="{45721C41-34FA-8890-9B55-630B95D43CA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7" creationId="{E6821FDF-FE3E-B109-B7AD-5AD5FA59522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8" creationId="{B83E925D-4F73-D5EC-CBBE-04D5905384C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9" creationId="{CC84A8AC-7B60-0300-BE57-74415D4793F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0" creationId="{DEF632F5-1469-EA83-BA38-34A37EE2955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2" creationId="{8657E0E6-9449-8149-1174-5F1A8090710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3" creationId="{771D689C-E772-D6A0-8875-56A5EDBAA52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4" creationId="{157D474E-1990-92AB-766A-01677A3BB2C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5" creationId="{6F963894-C4E9-BDBE-42F7-B092E5CCF30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6" creationId="{4510D476-D187-4342-750F-0E613A0D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7" creationId="{BDDE968E-775E-67FF-1FBD-DFF9D69308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8" creationId="{247E4D9D-7EB0-25B0-806A-E6774F4A0C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9" creationId="{589927D1-050A-E38B-438F-9BD492E3363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0" creationId="{535C0306-F684-C4C3-07BA-1257E02DA86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1" creationId="{B9274B0D-A7C2-9865-A478-C37C5D04CC5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2" creationId="{343C84E6-E602-12B9-C9F4-E16819C0F5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3" creationId="{FCB4D65B-6EFB-AEFD-6951-23765D5265B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6" creationId="{1437D720-A9F5-08B9-E445-301CB5A5809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8" creationId="{4DF76A7C-4BF2-9F69-EFDA-789588C9BB1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4" creationId="{4FA7B592-DC9E-6A8B-BFDF-D378238ADE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6" creationId="{30E7A49A-DFB1-0E00-A6D6-0BFB7B883B0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18" creationId="{B41C5022-BF0F-0D95-3304-07B520EADA7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0" creationId="{E262D6C8-1DD9-CBEA-EB09-51B4CD7C70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1" creationId="{E7A7D6E1-C9E1-0D34-BAA1-9395985EE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2" creationId="{46FBC6D1-03DF-8AF3-28F1-9D7FF671AD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3" creationId="{B5098512-E7FA-7D63-0092-517CCFA9D2B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4" creationId="{0821E1FA-4FD1-C4B9-DF91-DFD34EA6E71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5" creationId="{4B5B55CA-62E4-EDB3-CFF4-81C4E29C728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6" creationId="{CF2A0B3F-4EC3-3A0B-F6C9-19237171F97D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7" creationId="{80475976-F4A4-6322-AFBA-DE5CFC5D076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0" creationId="{EE0FB00B-48D6-68A9-2954-80AE065AE6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1" creationId="{7E122340-3C67-713D-7BFF-A56EAA119FB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2" creationId="{B28F7F8D-10F4-54CF-CA11-4E53A4D207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3" creationId="{CBCCE842-5339-4946-FF45-B19E588DE3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4" creationId="{56299C0F-3983-3E2B-619A-DB927529364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5" creationId="{8B22EE08-C08E-C88A-4A69-E39506A390E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7" creationId="{B19613A5-CC54-74F7-302E-CBC0BD1373F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8" creationId="{859B2DB3-399D-9460-D440-BF52F0A9A76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9" creationId="{DA50130C-B28A-1C20-606E-B7CA547E44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0" creationId="{24ADBB4F-4607-9821-0D3A-92816655EBE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1" creationId="{2A91B6C1-FA2A-8E6E-A9CB-C7F6BBA80F50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2" creationId="{B4CDD664-F9D3-9035-66DB-449EA6919B4E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3" creationId="{1B376F4B-8B0C-4DEB-C6A3-14E3ECD7729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6" creationId="{912F7C55-E987-09F1-BAF9-36EF5130E98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7" creationId="{55D9929E-0AAC-B682-84B3-C58E9431DA1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8" creationId="{F120EE07-D48B-EA4D-077C-2D70280AAD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9" creationId="{33B352AA-3AD7-BEC6-0E28-6BAD300488B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0" creationId="{2AF75B7B-135C-1119-62FC-30D67A9097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1" creationId="{657A2EC8-689B-8520-1323-C61C120B727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2" creationId="{3B6E4C18-7944-96BE-E7A6-9CBC6D8FB9C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5" creationId="{7023C2A0-744D-C8A8-D64F-B76D8A57A7B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6" creationId="{5029A15A-7712-DB1E-2ADD-2F4F089063B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7" creationId="{7E6907D6-BE47-8954-7DA4-428CE8A9BD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8" creationId="{7178E0A6-7898-EF17-F27C-5CCC0CE46D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9" creationId="{DD46448E-E289-D2F2-A21F-76AA38B61DD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0" creationId="{0D216BA3-AFA3-02A8-D15B-1FD5698E4F8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3" creationId="{56B14904-4730-1337-B317-DB93EEECAD0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4" creationId="{50B3BBFC-1FF5-026C-914B-439EDDB55D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5" creationId="{75E826F8-7110-7734-47B1-386FE54D4B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6" creationId="{57C8B1EE-8DBC-D792-1BD6-6A830446FE3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7" creationId="{3B3283CC-4FEB-57D8-BC0E-F3E2DF1B95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8" creationId="{221FE9DC-1A0B-2833-D190-E97D6284C77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1" creationId="{073232C0-2BA2-23E7-060A-A0CC73585A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2" creationId="{D7C1B412-33BD-1377-DFE2-5E1CDA17B12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3" creationId="{8622AD26-67FD-53E4-6230-960A1C526C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4" creationId="{78AEF689-D798-61B4-6A93-27EBF5FD0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5" creationId="{0E763800-7189-9A3E-9C7B-178AD446B8C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6" creationId="{9366B754-B59E-7137-11B5-8F9A431CE0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9" creationId="{D2A01D62-EAE0-8278-FCB3-3CB4EE9B9AF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0" creationId="{18947320-E5FB-26D2-6AFA-C4A41C34CAD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1" creationId="{009CBB73-663D-6433-C04E-5331179488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2" creationId="{9FF40825-3CD6-E345-64C7-D4292F4512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3" creationId="{6B6A32A5-E6F3-B267-DE3C-1F5C7AB721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4" creationId="{618CD8A1-2D46-7F9E-B650-F172B6CBC5B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7" creationId="{40243990-F929-8991-4A00-AB38535DDF2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8" creationId="{27F888B5-289A-ACD8-28BD-875AB20D2F2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9" creationId="{11AFBFE8-2AEF-3D21-6418-FFEC890FADB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0" creationId="{F1C971F6-A71C-14A5-1A8C-DC33E9E828A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1" creationId="{98FB049C-8B13-28C7-B2D2-3BF8E519689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2" creationId="{FCCAE40E-9AB7-D86A-6A5F-34083FCE96E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3" creationId="{6BE0124E-12A2-9B52-D357-BE6C1ED3A9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4" creationId="{B1621662-1A7C-76D7-01D6-0913EA3F660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7" creationId="{8C254A4F-7533-A5F9-5666-ABE4C1798E50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8" creationId="{FE3A19C0-0477-B81F-137B-E87280379E1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9" creationId="{523C51D0-C8A5-625E-59FD-C3BD23968F9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0" creationId="{3519AF80-15AF-3A6E-13F6-58A45AD469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1" creationId="{B7570C76-ECE1-8AF6-E835-BB491EB7D7C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2" creationId="{AF94A8A6-0493-9F07-082F-0CBBB01310A5}"/>
          </ac:spMkLst>
        </pc:spChg>
        <pc:grpChg chg="add del 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4" creationId="{C3849621-DD9F-0DB9-5825-2507AAFE7B5D}"/>
          </ac:grpSpMkLst>
        </pc:grpChg>
        <pc:grpChg chg="mod topLvl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5" creationId="{0EC23BB4-87EB-1AD7-BA76-3269B16E747F}"/>
          </ac:grpSpMkLst>
        </pc:grpChg>
        <pc:grpChg chg="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7" creationId="{67B8ECF3-A538-66E8-630B-03C836938949}"/>
          </ac:grpSpMkLst>
        </pc:grpChg>
        <pc:grpChg chg="add del 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5" creationId="{7AEE8FC5-55C4-F5B1-63AB-CCE15B0FF694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18" creationId="{AF41BC5C-DA99-EFB9-8A21-81E15F68E70B}"/>
          </ac:grpSpMkLst>
        </pc:grpChg>
        <pc:grpChg chg="mod topLvl">
          <ac:chgData name="Go" userId="b11a5121-062d-4360-8951-d081ad96d999" providerId="ADAL" clId="{A37B11FE-7E2B-4B71-9282-AB38B86228CA}" dt="2022-10-14T01:57:27.303" v="1356" actId="164"/>
          <ac:grpSpMkLst>
            <pc:docMk/>
            <pc:sldMk cId="2069005311" sldId="302"/>
            <ac:grpSpMk id="20" creationId="{8F6E9110-7CDD-27C6-B975-00903B1ADEF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3" creationId="{FCB647DD-AF09-F9BD-BDA8-CB3C91BFFD45}"/>
          </ac:grpSpMkLst>
        </pc:grpChg>
        <pc:grpChg chg="mod topLvl">
          <ac:chgData name="Go" userId="b11a5121-062d-4360-8951-d081ad96d999" providerId="ADAL" clId="{A37B11FE-7E2B-4B71-9282-AB38B86228CA}" dt="2022-10-14T01:57:48.729" v="1367" actId="164"/>
          <ac:grpSpMkLst>
            <pc:docMk/>
            <pc:sldMk cId="2069005311" sldId="302"/>
            <ac:grpSpMk id="24" creationId="{A213AD11-B9D4-BAB6-6E36-CD4F6A539C4F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7" creationId="{EDC85F66-A07E-088A-90C6-6900DCC67206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8" creationId="{417E5F6C-8E0D-FF8D-2808-899F3170F1D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9" creationId="{F1255727-C642-9DE2-60CB-C19030A5C721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0" creationId="{278DD3FC-FB74-194D-F710-A51F619A067D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1" creationId="{4EEF8E52-F6C0-408B-4485-1531AC633B68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2" creationId="{85E9B832-6CD4-D44D-66C6-84A23CF5AE9C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3" creationId="{B9D88745-0902-F72C-A7AE-C656A8EC3A8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34" creationId="{7EF258CF-409D-98B0-97EC-A615C184C8C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41" creationId="{9761E88E-A145-EEB2-48F9-8164E52551D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0" creationId="{1C28B119-F2D4-72EB-BE0C-74B6FB0D445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7" creationId="{ED3FFD80-C963-A86F-0769-5D33DE54383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64" creationId="{20DF0136-A542-DF51-303E-A959FBEE4A0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1" creationId="{6E6F0B05-BAF0-E896-A86F-83DE1E68EC0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8" creationId="{DF1F77A6-AAA3-5F16-1DDD-FC2C592268C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91" creationId="{7BDB70FA-6C97-55D8-7653-4C5C762C4165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4" creationId="{D0527D6C-87BC-97CD-B5EC-AC8475FA6D7F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5" creationId="{6DF74160-508F-DE47-AC28-BBDFE42CFC8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1" creationId="{F81B2595-D2C7-0A8C-8552-B24F1B115B4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2" creationId="{6AA53046-45BB-BCA9-15AE-EA0CD4A2B560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3" creationId="{6FFF429B-8A6C-086D-EAD6-D2A2791CD87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9" creationId="{612A3924-990A-8BF2-BE9B-973DE32EF8D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28" creationId="{FC312000-D161-DA87-4459-DE20FBB61403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29" creationId="{73DBCFCA-69D7-9649-D63D-ABCB774A42F5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36" creationId="{96E51CB4-047C-B979-CA7B-DC083C4AF75A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44" creationId="{55D84FE4-4F29-2C39-8725-A9FE38B0915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45" creationId="{82699D60-E13F-83B9-2447-35793F5A6FF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53" creationId="{A7CCE16A-5D32-86E3-9784-6B7EE230312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54" creationId="{341B43BC-D7D9-5F13-208E-2AA53E05915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1" creationId="{4C3C5DFD-809A-3481-1924-A934C9897448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62" creationId="{11D8DF77-424B-C1C6-9839-A23B5DAC35C0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9" creationId="{F4A8060A-870A-19E5-0352-9660E4DFE2C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0" creationId="{130A6559-6EB2-DBB8-2749-24C753F1F51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77" creationId="{3A24F3D6-5245-C241-9FCB-2755DBA4592D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8" creationId="{AE9CBF8C-0F00-49E2-E2E8-D017B8088DFB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85" creationId="{BCBBADD2-863B-600A-129D-B7B746E85F3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86" creationId="{3A8A2F8A-F114-B539-528B-32E2C15A4E71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95" creationId="{DC346F9D-77BB-CA20-D95E-FF116420FEB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96" creationId="{3E5D6C8C-61CC-5750-35DE-2C11D3AD8CFA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3" creationId="{AFCD7569-C5C4-93D2-6BD0-BA8EF33FDC28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4" creationId="{4B5E5729-03DE-3FEF-8B47-D7D87BC7B5ED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5" creationId="{6206298C-51E2-0754-767A-59D1994CECE4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6" creationId="{808F4ADD-1290-A296-D5A7-6A3A95FB60BD}"/>
          </ac:grpSpMkLst>
        </pc:grpChg>
        <pc:graphicFrameChg chg="mod topLvl">
          <ac:chgData name="Go" userId="b11a5121-062d-4360-8951-d081ad96d999" providerId="ADAL" clId="{A37B11FE-7E2B-4B71-9282-AB38B86228CA}" dt="2022-10-14T02:00:14.628" v="1412" actId="164"/>
          <ac:graphicFrameMkLst>
            <pc:docMk/>
            <pc:sldMk cId="2069005311" sldId="302"/>
            <ac:graphicFrameMk id="17" creationId="{BB7F2A5C-42B8-54BA-B27C-AEC1D83E16F1}"/>
          </ac:graphicFrameMkLst>
        </pc:graphicFrameChg>
        <pc:graphicFrameChg chg="add del mod">
          <ac:chgData name="Go" userId="b11a5121-062d-4360-8951-d081ad96d999" providerId="ADAL" clId="{A37B11FE-7E2B-4B71-9282-AB38B86228CA}" dt="2022-10-14T02:00:28.341" v="1418" actId="478"/>
          <ac:graphicFrameMkLst>
            <pc:docMk/>
            <pc:sldMk cId="2069005311" sldId="302"/>
            <ac:graphicFrameMk id="110" creationId="{0F721F0E-B92A-84E7-000F-5019C3A93A01}"/>
          </ac:graphicFrameMkLst>
        </pc:graphicFrame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9" creationId="{22DFC33F-2FDB-A6EC-9D74-D956F1D3C8A4}"/>
          </ac:picMkLst>
        </pc:pic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11" creationId="{AB2EEDC1-E87B-7A6A-6355-8C52B4B045BB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7" creationId="{962758D2-FE5B-66E4-6B4E-ED1CBD8BD1D2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9" creationId="{CEF6DDD1-7EB7-B8ED-90D8-535831AA95FC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5" creationId="{341854E8-53F7-0362-A7A9-1A8B79CC8B34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7" creationId="{4DE979B2-73B5-43B8-6F8D-9F1D04723FC7}"/>
          </ac:picMkLst>
        </pc:pic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0" creationId="{B55FE84F-E429-1A1A-6E65-62BCD8CCD83E}"/>
          </ac:cxnSpMkLst>
        </pc:cxn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2" creationId="{8066251B-B99C-AE74-6E40-D4549950E730}"/>
          </ac:cxnSpMkLst>
        </pc:cxnChg>
      </pc:sldChg>
      <pc:sldChg chg="addSp delSp modSp add mod ord">
        <pc:chgData name="Go" userId="b11a5121-062d-4360-8951-d081ad96d999" providerId="ADAL" clId="{A37B11FE-7E2B-4B71-9282-AB38B86228CA}" dt="2022-10-15T01:47:19.882" v="1511" actId="20577"/>
        <pc:sldMkLst>
          <pc:docMk/>
          <pc:sldMk cId="1909606739" sldId="303"/>
        </pc:sldMkLst>
        <pc:spChg chg="add mod">
          <ac:chgData name="Go" userId="b11a5121-062d-4360-8951-d081ad96d999" providerId="ADAL" clId="{A37B11FE-7E2B-4B71-9282-AB38B86228CA}" dt="2022-10-14T01:53:19.704" v="1343" actId="1076"/>
          <ac:spMkLst>
            <pc:docMk/>
            <pc:sldMk cId="1909606739" sldId="303"/>
            <ac:spMk id="8" creationId="{35991093-AFCF-2F1A-6BD6-85DAEAF37A4A}"/>
          </ac:spMkLst>
        </pc:spChg>
        <pc:spChg chg="mod">
          <ac:chgData name="Go" userId="b11a5121-062d-4360-8951-d081ad96d999" providerId="ADAL" clId="{A37B11FE-7E2B-4B71-9282-AB38B86228CA}" dt="2022-10-14T01:53:15.884" v="1342" actId="553"/>
          <ac:spMkLst>
            <pc:docMk/>
            <pc:sldMk cId="1909606739" sldId="303"/>
            <ac:spMk id="20" creationId="{1E5638A1-D88D-1784-8C3B-1B8361927869}"/>
          </ac:spMkLst>
        </pc:spChg>
        <pc:spChg chg="mod">
          <ac:chgData name="Go" userId="b11a5121-062d-4360-8951-d081ad96d999" providerId="ADAL" clId="{A37B11FE-7E2B-4B71-9282-AB38B86228CA}" dt="2022-10-15T01:47:19.882" v="1511" actId="20577"/>
          <ac:spMkLst>
            <pc:docMk/>
            <pc:sldMk cId="1909606739" sldId="303"/>
            <ac:spMk id="33" creationId="{2C118948-231F-1F9D-09C3-4B4F5BA9B6A0}"/>
          </ac:spMkLst>
        </pc:spChg>
        <pc:spChg chg="mod">
          <ac:chgData name="Go" userId="b11a5121-062d-4360-8951-d081ad96d999" providerId="ADAL" clId="{A37B11FE-7E2B-4B71-9282-AB38B86228CA}" dt="2022-10-15T01:47:17.279" v="1508" actId="20577"/>
          <ac:spMkLst>
            <pc:docMk/>
            <pc:sldMk cId="1909606739" sldId="303"/>
            <ac:spMk id="36" creationId="{7FF9410D-73F7-EB65-E0FF-E2112266A595}"/>
          </ac:spMkLst>
        </pc:spChg>
        <pc:spChg chg="mod">
          <ac:chgData name="Go" userId="b11a5121-062d-4360-8951-d081ad96d999" providerId="ADAL" clId="{A37B11FE-7E2B-4B71-9282-AB38B86228CA}" dt="2022-10-13T20:38:27.550" v="1083" actId="20577"/>
          <ac:spMkLst>
            <pc:docMk/>
            <pc:sldMk cId="1909606739" sldId="303"/>
            <ac:spMk id="44" creationId="{4EBA0680-77E2-2ABD-9B13-E3E33B2FEBA0}"/>
          </ac:spMkLst>
        </pc:spChg>
        <pc:spChg chg="del">
          <ac:chgData name="Go" userId="b11a5121-062d-4360-8951-d081ad96d999" providerId="ADAL" clId="{A37B11FE-7E2B-4B71-9282-AB38B86228CA}" dt="2022-10-14T01:45:54.813" v="1325" actId="478"/>
          <ac:spMkLst>
            <pc:docMk/>
            <pc:sldMk cId="1909606739" sldId="303"/>
            <ac:spMk id="59" creationId="{638D4131-CD65-E2A2-5377-7594633FFA79}"/>
          </ac:spMkLst>
        </pc:spChg>
        <pc:grpChg chg="del">
          <ac:chgData name="Go" userId="b11a5121-062d-4360-8951-d081ad96d999" providerId="ADAL" clId="{A37B11FE-7E2B-4B71-9282-AB38B86228CA}" dt="2022-10-13T20:38:22.428" v="1079" actId="478"/>
          <ac:grpSpMkLst>
            <pc:docMk/>
            <pc:sldMk cId="1909606739" sldId="303"/>
            <ac:grpSpMk id="2" creationId="{B2FD1FFB-4E78-0C3D-A641-8046DE08B520}"/>
          </ac:grpSpMkLst>
        </pc:grpChg>
        <pc:picChg chg="add mod modCrop">
          <ac:chgData name="Go" userId="b11a5121-062d-4360-8951-d081ad96d999" providerId="ADAL" clId="{A37B11FE-7E2B-4B71-9282-AB38B86228CA}" dt="2022-10-14T01:52:48.015" v="1338" actId="1076"/>
          <ac:picMkLst>
            <pc:docMk/>
            <pc:sldMk cId="1909606739" sldId="303"/>
            <ac:picMk id="3" creationId="{A16858AB-8E93-7BAF-8E79-AE98E8A5C72A}"/>
          </ac:picMkLst>
        </pc:picChg>
        <pc:picChg chg="mod">
          <ac:chgData name="Go" userId="b11a5121-062d-4360-8951-d081ad96d999" providerId="ADAL" clId="{A37B11FE-7E2B-4B71-9282-AB38B86228CA}" dt="2022-10-13T20:39:14.173" v="1121"/>
          <ac:picMkLst>
            <pc:docMk/>
            <pc:sldMk cId="1909606739" sldId="303"/>
            <ac:picMk id="13" creationId="{6384335C-79AE-8172-D5DF-7529DDE9B744}"/>
          </ac:picMkLst>
        </pc:picChg>
        <pc:picChg chg="mod">
          <ac:chgData name="Go" userId="b11a5121-062d-4360-8951-d081ad96d999" providerId="ADAL" clId="{A37B11FE-7E2B-4B71-9282-AB38B86228CA}" dt="2022-10-14T01:52:43.067" v="1337" actId="552"/>
          <ac:picMkLst>
            <pc:docMk/>
            <pc:sldMk cId="1909606739" sldId="303"/>
            <ac:picMk id="17" creationId="{C2F012C9-F323-36DA-07F4-CEA68E0FBAF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0DD7FB43-A9C4-4FF1-B87C-61A7EFB972BB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720725"/>
            <a:ext cx="27781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AD29BE89-A6B3-40AF-AC57-A963D4802B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697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2613223"/>
            <a:ext cx="5518944" cy="18031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3931" y="4766892"/>
            <a:ext cx="4545013" cy="21497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07334" y="336877"/>
            <a:ext cx="1460897" cy="71776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4644" y="336877"/>
            <a:ext cx="4274476" cy="71776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2892" y="5405594"/>
            <a:ext cx="5518944" cy="167074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892" y="3565434"/>
            <a:ext cx="5518944" cy="184016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4644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00545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883001"/>
            <a:ext cx="2868814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644" y="2667746"/>
            <a:ext cx="2868814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98291" y="1883001"/>
            <a:ext cx="2869941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98291" y="2667746"/>
            <a:ext cx="2869941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644" y="334929"/>
            <a:ext cx="2136111" cy="142539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38534" y="334929"/>
            <a:ext cx="3629697" cy="717954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4644" y="1760323"/>
            <a:ext cx="2136111" cy="575415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2649" y="5888514"/>
            <a:ext cx="3895725" cy="6951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72649" y="751642"/>
            <a:ext cx="3895725" cy="504729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72649" y="6583687"/>
            <a:ext cx="3895725" cy="98726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4644" y="336877"/>
            <a:ext cx="5843588" cy="14020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962839"/>
            <a:ext cx="5843588" cy="55516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4644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8399" y="7796829"/>
            <a:ext cx="2056077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3227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01" name="Straight Connector 600">
            <a:extLst>
              <a:ext uri="{FF2B5EF4-FFF2-40B4-BE49-F238E27FC236}">
                <a16:creationId xmlns:a16="http://schemas.microsoft.com/office/drawing/2014/main" id="{C50B1154-E776-0259-E7DF-A969B7854B62}"/>
              </a:ext>
            </a:extLst>
          </p:cNvPr>
          <p:cNvCxnSpPr>
            <a:cxnSpLocks/>
          </p:cNvCxnSpPr>
          <p:nvPr/>
        </p:nvCxnSpPr>
        <p:spPr>
          <a:xfrm>
            <a:off x="4547811" y="863208"/>
            <a:ext cx="1831397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6" name="Straight Connector 635">
            <a:extLst>
              <a:ext uri="{FF2B5EF4-FFF2-40B4-BE49-F238E27FC236}">
                <a16:creationId xmlns:a16="http://schemas.microsoft.com/office/drawing/2014/main" id="{52859023-B1DA-29F8-BA95-DB7DBE7C7B58}"/>
              </a:ext>
            </a:extLst>
          </p:cNvPr>
          <p:cNvCxnSpPr>
            <a:cxnSpLocks/>
          </p:cNvCxnSpPr>
          <p:nvPr/>
        </p:nvCxnSpPr>
        <p:spPr>
          <a:xfrm>
            <a:off x="4547811" y="1722299"/>
            <a:ext cx="1831397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7" name="Straight Connector 636">
            <a:extLst>
              <a:ext uri="{FF2B5EF4-FFF2-40B4-BE49-F238E27FC236}">
                <a16:creationId xmlns:a16="http://schemas.microsoft.com/office/drawing/2014/main" id="{A5AAEE22-78C2-B56A-04DB-536CF811A053}"/>
              </a:ext>
            </a:extLst>
          </p:cNvPr>
          <p:cNvCxnSpPr>
            <a:cxnSpLocks/>
          </p:cNvCxnSpPr>
          <p:nvPr/>
        </p:nvCxnSpPr>
        <p:spPr>
          <a:xfrm>
            <a:off x="4565324" y="2410533"/>
            <a:ext cx="1831397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2" name="Straight Connector 671">
            <a:extLst>
              <a:ext uri="{FF2B5EF4-FFF2-40B4-BE49-F238E27FC236}">
                <a16:creationId xmlns:a16="http://schemas.microsoft.com/office/drawing/2014/main" id="{6501C5A8-B91D-5C1B-8521-734F14B43EC4}"/>
              </a:ext>
            </a:extLst>
          </p:cNvPr>
          <p:cNvCxnSpPr>
            <a:cxnSpLocks/>
          </p:cNvCxnSpPr>
          <p:nvPr/>
        </p:nvCxnSpPr>
        <p:spPr>
          <a:xfrm>
            <a:off x="4547811" y="3136900"/>
            <a:ext cx="1831397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6" name="Straight Connector 545">
            <a:extLst>
              <a:ext uri="{FF2B5EF4-FFF2-40B4-BE49-F238E27FC236}">
                <a16:creationId xmlns:a16="http://schemas.microsoft.com/office/drawing/2014/main" id="{A9F4E458-A127-B290-6A70-9F9BCA12BC76}"/>
              </a:ext>
            </a:extLst>
          </p:cNvPr>
          <p:cNvCxnSpPr>
            <a:cxnSpLocks/>
          </p:cNvCxnSpPr>
          <p:nvPr/>
        </p:nvCxnSpPr>
        <p:spPr>
          <a:xfrm>
            <a:off x="2481341" y="728837"/>
            <a:ext cx="1828800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4" name="Straight Connector 563">
            <a:extLst>
              <a:ext uri="{FF2B5EF4-FFF2-40B4-BE49-F238E27FC236}">
                <a16:creationId xmlns:a16="http://schemas.microsoft.com/office/drawing/2014/main" id="{977625C9-5788-4E65-34D2-AD1FD992DC46}"/>
              </a:ext>
            </a:extLst>
          </p:cNvPr>
          <p:cNvCxnSpPr>
            <a:cxnSpLocks/>
          </p:cNvCxnSpPr>
          <p:nvPr/>
        </p:nvCxnSpPr>
        <p:spPr>
          <a:xfrm>
            <a:off x="2481341" y="1488646"/>
            <a:ext cx="1828800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2" name="Straight Connector 581">
            <a:extLst>
              <a:ext uri="{FF2B5EF4-FFF2-40B4-BE49-F238E27FC236}">
                <a16:creationId xmlns:a16="http://schemas.microsoft.com/office/drawing/2014/main" id="{0A3F75E6-EFAD-5884-3A78-E00A95C036F6}"/>
              </a:ext>
            </a:extLst>
          </p:cNvPr>
          <p:cNvCxnSpPr>
            <a:cxnSpLocks/>
          </p:cNvCxnSpPr>
          <p:nvPr/>
        </p:nvCxnSpPr>
        <p:spPr>
          <a:xfrm>
            <a:off x="2481341" y="2477291"/>
            <a:ext cx="1828800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0" name="Straight Connector 599">
            <a:extLst>
              <a:ext uri="{FF2B5EF4-FFF2-40B4-BE49-F238E27FC236}">
                <a16:creationId xmlns:a16="http://schemas.microsoft.com/office/drawing/2014/main" id="{D7A1DB00-312A-1438-1C1E-0B9EAB1F9B21}"/>
              </a:ext>
            </a:extLst>
          </p:cNvPr>
          <p:cNvCxnSpPr>
            <a:cxnSpLocks/>
          </p:cNvCxnSpPr>
          <p:nvPr/>
        </p:nvCxnSpPr>
        <p:spPr>
          <a:xfrm>
            <a:off x="2481341" y="3083937"/>
            <a:ext cx="1828800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8" name="Straight Connector 337">
            <a:extLst>
              <a:ext uri="{FF2B5EF4-FFF2-40B4-BE49-F238E27FC236}">
                <a16:creationId xmlns:a16="http://schemas.microsoft.com/office/drawing/2014/main" id="{FA87417F-8DA2-94CD-D396-823EF320A97F}"/>
              </a:ext>
            </a:extLst>
          </p:cNvPr>
          <p:cNvCxnSpPr>
            <a:cxnSpLocks/>
          </p:cNvCxnSpPr>
          <p:nvPr/>
        </p:nvCxnSpPr>
        <p:spPr>
          <a:xfrm>
            <a:off x="396460" y="1488646"/>
            <a:ext cx="1828800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8" name="Straight Connector 357">
            <a:extLst>
              <a:ext uri="{FF2B5EF4-FFF2-40B4-BE49-F238E27FC236}">
                <a16:creationId xmlns:a16="http://schemas.microsoft.com/office/drawing/2014/main" id="{82037755-90D7-3135-763B-6B7D86F92132}"/>
              </a:ext>
            </a:extLst>
          </p:cNvPr>
          <p:cNvCxnSpPr>
            <a:cxnSpLocks/>
          </p:cNvCxnSpPr>
          <p:nvPr/>
        </p:nvCxnSpPr>
        <p:spPr>
          <a:xfrm>
            <a:off x="396460" y="3232865"/>
            <a:ext cx="1828800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7" name="Straight Connector 356">
            <a:extLst>
              <a:ext uri="{FF2B5EF4-FFF2-40B4-BE49-F238E27FC236}">
                <a16:creationId xmlns:a16="http://schemas.microsoft.com/office/drawing/2014/main" id="{BC2B77B8-DDC7-B358-5E26-2DB2FCA35E35}"/>
              </a:ext>
            </a:extLst>
          </p:cNvPr>
          <p:cNvCxnSpPr>
            <a:cxnSpLocks/>
          </p:cNvCxnSpPr>
          <p:nvPr/>
        </p:nvCxnSpPr>
        <p:spPr>
          <a:xfrm>
            <a:off x="396460" y="2245506"/>
            <a:ext cx="1828800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7" name="TextBox 247">
            <a:extLst>
              <a:ext uri="{FF2B5EF4-FFF2-40B4-BE49-F238E27FC236}">
                <a16:creationId xmlns:a16="http://schemas.microsoft.com/office/drawing/2014/main" id="{CE1C5279-ACE1-F2BA-8D57-8C7399B369B1}"/>
              </a:ext>
            </a:extLst>
          </p:cNvPr>
          <p:cNvSpPr txBox="1"/>
          <p:nvPr/>
        </p:nvSpPr>
        <p:spPr>
          <a:xfrm>
            <a:off x="-43127" y="0"/>
            <a:ext cx="26875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itchFamily="34" charset="0"/>
              </a:rPr>
              <a:t>Figure S5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83A79A0-05C0-7BDE-389D-92F0BFAFA6C0}"/>
              </a:ext>
            </a:extLst>
          </p:cNvPr>
          <p:cNvCxnSpPr>
            <a:cxnSpLocks/>
          </p:cNvCxnSpPr>
          <p:nvPr/>
        </p:nvCxnSpPr>
        <p:spPr>
          <a:xfrm>
            <a:off x="396460" y="728837"/>
            <a:ext cx="1828800" cy="0"/>
          </a:xfrm>
          <a:prstGeom prst="line">
            <a:avLst/>
          </a:prstGeom>
          <a:ln w="952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0527C3C8-1A42-5BF4-7D6F-9D8414CF88C0}"/>
              </a:ext>
            </a:extLst>
          </p:cNvPr>
          <p:cNvGrpSpPr/>
          <p:nvPr/>
        </p:nvGrpSpPr>
        <p:grpSpPr>
          <a:xfrm>
            <a:off x="-43127" y="266637"/>
            <a:ext cx="6600460" cy="3804408"/>
            <a:chOff x="-45672" y="472155"/>
            <a:chExt cx="6600460" cy="3804408"/>
          </a:xfrm>
        </p:grpSpPr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CA5EDC27-0818-98F6-3B0A-77C44DA7AEC0}"/>
                </a:ext>
              </a:extLst>
            </p:cNvPr>
            <p:cNvGrpSpPr/>
            <p:nvPr/>
          </p:nvGrpSpPr>
          <p:grpSpPr>
            <a:xfrm>
              <a:off x="54573" y="472155"/>
              <a:ext cx="6500215" cy="3804408"/>
              <a:chOff x="8853" y="472155"/>
              <a:chExt cx="6500215" cy="3804408"/>
            </a:xfrm>
          </p:grpSpPr>
          <p:graphicFrame>
            <p:nvGraphicFramePr>
              <p:cNvPr id="5" name="Object 6">
                <a:extLst>
                  <a:ext uri="{FF2B5EF4-FFF2-40B4-BE49-F238E27FC236}">
                    <a16:creationId xmlns:a16="http://schemas.microsoft.com/office/drawing/2014/main" id="{88861EB9-C280-C1F1-9A58-C6F93DA9EF5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01520170"/>
                  </p:ext>
                </p:extLst>
              </p:nvPr>
            </p:nvGraphicFramePr>
            <p:xfrm>
              <a:off x="135255" y="472155"/>
              <a:ext cx="6373813" cy="32956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2" imgW="6932160" imgH="3585600" progId="Prism5.Document">
                      <p:embed/>
                    </p:oleObj>
                  </mc:Choice>
                  <mc:Fallback>
                    <p:oleObj name="Prism 5" r:id="rId2" imgW="6932160" imgH="3585600" progId="Prism5.Document">
                      <p:embed/>
                      <p:pic>
                        <p:nvPicPr>
                          <p:cNvPr id="5" name="Object 6">
                            <a:extLst>
                              <a:ext uri="{FF2B5EF4-FFF2-40B4-BE49-F238E27FC236}">
                                <a16:creationId xmlns:a16="http://schemas.microsoft.com/office/drawing/2014/main" id="{88861EB9-C280-C1F1-9A58-C6F93DA9EF56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135255" y="472155"/>
                            <a:ext cx="6373813" cy="32956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75" name="テキスト ボックス 250">
                <a:extLst>
                  <a:ext uri="{FF2B5EF4-FFF2-40B4-BE49-F238E27FC236}">
                    <a16:creationId xmlns:a16="http://schemas.microsoft.com/office/drawing/2014/main" id="{45FAABBF-E267-75E4-A8D5-C6B7519F12AB}"/>
                  </a:ext>
                </a:extLst>
              </p:cNvPr>
              <p:cNvSpPr txBox="1"/>
              <p:nvPr/>
            </p:nvSpPr>
            <p:spPr>
              <a:xfrm>
                <a:off x="5101010" y="1312324"/>
                <a:ext cx="604992" cy="2185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CYP3A4</a:t>
                </a:r>
              </a:p>
            </p:txBody>
          </p:sp>
          <p:sp>
            <p:nvSpPr>
              <p:cNvPr id="230" name="テキスト ボックス 250">
                <a:extLst>
                  <a:ext uri="{FF2B5EF4-FFF2-40B4-BE49-F238E27FC236}">
                    <a16:creationId xmlns:a16="http://schemas.microsoft.com/office/drawing/2014/main" id="{DB172472-48BE-10F4-AEE7-725E91D591F1}"/>
                  </a:ext>
                </a:extLst>
              </p:cNvPr>
              <p:cNvSpPr txBox="1"/>
              <p:nvPr/>
            </p:nvSpPr>
            <p:spPr>
              <a:xfrm>
                <a:off x="3024695" y="1312324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ALDH2</a:t>
                </a:r>
              </a:p>
            </p:txBody>
          </p:sp>
          <p:sp>
            <p:nvSpPr>
              <p:cNvPr id="207" name="テキスト ボックス 250">
                <a:extLst>
                  <a:ext uri="{FF2B5EF4-FFF2-40B4-BE49-F238E27FC236}">
                    <a16:creationId xmlns:a16="http://schemas.microsoft.com/office/drawing/2014/main" id="{6632BA2F-5F73-D39C-BDE9-9CD1765939A2}"/>
                  </a:ext>
                </a:extLst>
              </p:cNvPr>
              <p:cNvSpPr txBox="1"/>
              <p:nvPr/>
            </p:nvSpPr>
            <p:spPr>
              <a:xfrm>
                <a:off x="945004" y="1312324"/>
                <a:ext cx="6270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ADH1B</a:t>
                </a:r>
              </a:p>
            </p:txBody>
          </p:sp>
          <p:sp>
            <p:nvSpPr>
              <p:cNvPr id="274" name="テキスト ボックス 250">
                <a:extLst>
                  <a:ext uri="{FF2B5EF4-FFF2-40B4-BE49-F238E27FC236}">
                    <a16:creationId xmlns:a16="http://schemas.microsoft.com/office/drawing/2014/main" id="{2FE9F1E4-0086-A62C-B680-4882024CC3E2}"/>
                  </a:ext>
                </a:extLst>
              </p:cNvPr>
              <p:cNvSpPr txBox="1"/>
              <p:nvPr/>
            </p:nvSpPr>
            <p:spPr>
              <a:xfrm>
                <a:off x="1059212" y="550135"/>
                <a:ext cx="398680" cy="2185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ALB</a:t>
                </a:r>
              </a:p>
            </p:txBody>
          </p:sp>
          <p:sp>
            <p:nvSpPr>
              <p:cNvPr id="253" name="テキスト ボックス 250">
                <a:extLst>
                  <a:ext uri="{FF2B5EF4-FFF2-40B4-BE49-F238E27FC236}">
                    <a16:creationId xmlns:a16="http://schemas.microsoft.com/office/drawing/2014/main" id="{3ABC7BC5-EBD6-0EA7-AE25-5BA13ADF0329}"/>
                  </a:ext>
                </a:extLst>
              </p:cNvPr>
              <p:cNvSpPr txBox="1"/>
              <p:nvPr/>
            </p:nvSpPr>
            <p:spPr>
              <a:xfrm>
                <a:off x="5136445" y="550135"/>
                <a:ext cx="5341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CDH1</a:t>
                </a:r>
              </a:p>
            </p:txBody>
          </p:sp>
          <p:sp>
            <p:nvSpPr>
              <p:cNvPr id="186" name="テキスト ボックス 250">
                <a:extLst>
                  <a:ext uri="{FF2B5EF4-FFF2-40B4-BE49-F238E27FC236}">
                    <a16:creationId xmlns:a16="http://schemas.microsoft.com/office/drawing/2014/main" id="{D96D2C5B-9BBB-25F2-4584-AE10FCC698A2}"/>
                  </a:ext>
                </a:extLst>
              </p:cNvPr>
              <p:cNvSpPr txBox="1"/>
              <p:nvPr/>
            </p:nvSpPr>
            <p:spPr>
              <a:xfrm>
                <a:off x="3024695" y="550135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HNF4A</a:t>
                </a:r>
              </a:p>
            </p:txBody>
          </p:sp>
          <p:grpSp>
            <p:nvGrpSpPr>
              <p:cNvPr id="233" name="グループ化 422">
                <a:extLst>
                  <a:ext uri="{FF2B5EF4-FFF2-40B4-BE49-F238E27FC236}">
                    <a16:creationId xmlns:a16="http://schemas.microsoft.com/office/drawing/2014/main" id="{23252D83-D28C-8A78-72E7-1017B2E79EA0}"/>
                  </a:ext>
                </a:extLst>
              </p:cNvPr>
              <p:cNvGrpSpPr/>
              <p:nvPr/>
            </p:nvGrpSpPr>
            <p:grpSpPr>
              <a:xfrm>
                <a:off x="23143" y="697235"/>
                <a:ext cx="285332" cy="636518"/>
                <a:chOff x="7107335" y="4060466"/>
                <a:chExt cx="246222" cy="717118"/>
              </a:xfrm>
            </p:grpSpPr>
            <p:sp>
              <p:nvSpPr>
                <p:cNvPr id="530" name="TextBox 51">
                  <a:extLst>
                    <a:ext uri="{FF2B5EF4-FFF2-40B4-BE49-F238E27FC236}">
                      <a16:creationId xmlns:a16="http://schemas.microsoft.com/office/drawing/2014/main" id="{F63BF667-F145-D4CB-7B31-31C20276779F}"/>
                    </a:ext>
                  </a:extLst>
                </p:cNvPr>
                <p:cNvSpPr txBox="1"/>
                <p:nvPr/>
              </p:nvSpPr>
              <p:spPr>
                <a:xfrm>
                  <a:off x="7159391" y="4248209"/>
                  <a:ext cx="19416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531" name="TextBox 51">
                  <a:extLst>
                    <a:ext uri="{FF2B5EF4-FFF2-40B4-BE49-F238E27FC236}">
                      <a16:creationId xmlns:a16="http://schemas.microsoft.com/office/drawing/2014/main" id="{AC22E39C-B0A1-214C-A0D1-A434675EFA3F}"/>
                    </a:ext>
                  </a:extLst>
                </p:cNvPr>
                <p:cNvSpPr txBox="1"/>
                <p:nvPr/>
              </p:nvSpPr>
              <p:spPr>
                <a:xfrm>
                  <a:off x="7107339" y="4623697"/>
                  <a:ext cx="246218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2" name="TextBox 61">
                  <a:extLst>
                    <a:ext uri="{FF2B5EF4-FFF2-40B4-BE49-F238E27FC236}">
                      <a16:creationId xmlns:a16="http://schemas.microsoft.com/office/drawing/2014/main" id="{62DF5276-DBEB-5B73-983A-AFD29FD8D183}"/>
                    </a:ext>
                  </a:extLst>
                </p:cNvPr>
                <p:cNvSpPr txBox="1"/>
                <p:nvPr/>
              </p:nvSpPr>
              <p:spPr>
                <a:xfrm>
                  <a:off x="7107335" y="4435954"/>
                  <a:ext cx="24622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3" name="TextBox 51">
                  <a:extLst>
                    <a:ext uri="{FF2B5EF4-FFF2-40B4-BE49-F238E27FC236}">
                      <a16:creationId xmlns:a16="http://schemas.microsoft.com/office/drawing/2014/main" id="{0B650ABE-D16C-E255-67C4-456CD8D51C5E}"/>
                    </a:ext>
                  </a:extLst>
                </p:cNvPr>
                <p:cNvSpPr txBox="1"/>
                <p:nvPr/>
              </p:nvSpPr>
              <p:spPr>
                <a:xfrm>
                  <a:off x="7159391" y="4060466"/>
                  <a:ext cx="194166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</p:grpSp>
          <p:grpSp>
            <p:nvGrpSpPr>
              <p:cNvPr id="242" name="グループ化 432">
                <a:extLst>
                  <a:ext uri="{FF2B5EF4-FFF2-40B4-BE49-F238E27FC236}">
                    <a16:creationId xmlns:a16="http://schemas.microsoft.com/office/drawing/2014/main" id="{1D25CDEA-499C-EDEE-579C-E500FB41DB50}"/>
                  </a:ext>
                </a:extLst>
              </p:cNvPr>
              <p:cNvGrpSpPr/>
              <p:nvPr/>
            </p:nvGrpSpPr>
            <p:grpSpPr>
              <a:xfrm>
                <a:off x="4153970" y="1448739"/>
                <a:ext cx="299622" cy="658334"/>
                <a:chOff x="7095004" y="4058061"/>
                <a:chExt cx="258553" cy="741692"/>
              </a:xfrm>
            </p:grpSpPr>
            <p:sp>
              <p:nvSpPr>
                <p:cNvPr id="524" name="TextBox 51">
                  <a:extLst>
                    <a:ext uri="{FF2B5EF4-FFF2-40B4-BE49-F238E27FC236}">
                      <a16:creationId xmlns:a16="http://schemas.microsoft.com/office/drawing/2014/main" id="{07074415-5218-0DA5-EEE0-E6E08BC6565A}"/>
                    </a:ext>
                  </a:extLst>
                </p:cNvPr>
                <p:cNvSpPr txBox="1"/>
                <p:nvPr/>
              </p:nvSpPr>
              <p:spPr>
                <a:xfrm>
                  <a:off x="7159391" y="4171723"/>
                  <a:ext cx="194166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0</a:t>
                  </a:r>
                </a:p>
              </p:txBody>
            </p:sp>
            <p:sp>
              <p:nvSpPr>
                <p:cNvPr id="525" name="TextBox 61">
                  <a:extLst>
                    <a:ext uri="{FF2B5EF4-FFF2-40B4-BE49-F238E27FC236}">
                      <a16:creationId xmlns:a16="http://schemas.microsoft.com/office/drawing/2014/main" id="{EE5EB39D-4D41-CC54-C975-D4CD499053C1}"/>
                    </a:ext>
                  </a:extLst>
                </p:cNvPr>
                <p:cNvSpPr txBox="1"/>
                <p:nvPr/>
              </p:nvSpPr>
              <p:spPr>
                <a:xfrm>
                  <a:off x="7107335" y="4285388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</a:p>
              </p:txBody>
            </p:sp>
            <p:sp>
              <p:nvSpPr>
                <p:cNvPr id="526" name="TextBox 51">
                  <a:extLst>
                    <a:ext uri="{FF2B5EF4-FFF2-40B4-BE49-F238E27FC236}">
                      <a16:creationId xmlns:a16="http://schemas.microsoft.com/office/drawing/2014/main" id="{5EDE79ED-AC23-8756-B6DE-1C525000A20B}"/>
                    </a:ext>
                  </a:extLst>
                </p:cNvPr>
                <p:cNvSpPr txBox="1"/>
                <p:nvPr/>
              </p:nvSpPr>
              <p:spPr>
                <a:xfrm>
                  <a:off x="7095004" y="4512717"/>
                  <a:ext cx="258553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7" name="TextBox 51">
                  <a:extLst>
                    <a:ext uri="{FF2B5EF4-FFF2-40B4-BE49-F238E27FC236}">
                      <a16:creationId xmlns:a16="http://schemas.microsoft.com/office/drawing/2014/main" id="{FC481002-8CF3-3E30-9A56-AABA342ECDDF}"/>
                    </a:ext>
                  </a:extLst>
                </p:cNvPr>
                <p:cNvSpPr txBox="1"/>
                <p:nvPr/>
              </p:nvSpPr>
              <p:spPr>
                <a:xfrm>
                  <a:off x="7107339" y="4626380"/>
                  <a:ext cx="246218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8" name="TextBox 61">
                  <a:extLst>
                    <a:ext uri="{FF2B5EF4-FFF2-40B4-BE49-F238E27FC236}">
                      <a16:creationId xmlns:a16="http://schemas.microsoft.com/office/drawing/2014/main" id="{0CA312B7-7556-B463-E82C-6A619B624D81}"/>
                    </a:ext>
                  </a:extLst>
                </p:cNvPr>
                <p:cNvSpPr txBox="1"/>
                <p:nvPr/>
              </p:nvSpPr>
              <p:spPr>
                <a:xfrm>
                  <a:off x="7107335" y="4399053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9" name="TextBox 51">
                  <a:extLst>
                    <a:ext uri="{FF2B5EF4-FFF2-40B4-BE49-F238E27FC236}">
                      <a16:creationId xmlns:a16="http://schemas.microsoft.com/office/drawing/2014/main" id="{226EE45B-DA42-5CF6-1EC9-21D9E386ECBA}"/>
                    </a:ext>
                  </a:extLst>
                </p:cNvPr>
                <p:cNvSpPr txBox="1"/>
                <p:nvPr/>
              </p:nvSpPr>
              <p:spPr>
                <a:xfrm>
                  <a:off x="7159391" y="4058061"/>
                  <a:ext cx="194166" cy="17337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0</a:t>
                  </a:r>
                </a:p>
              </p:txBody>
            </p:sp>
          </p:grpSp>
          <p:grpSp>
            <p:nvGrpSpPr>
              <p:cNvPr id="246" name="グループ化 422">
                <a:extLst>
                  <a:ext uri="{FF2B5EF4-FFF2-40B4-BE49-F238E27FC236}">
                    <a16:creationId xmlns:a16="http://schemas.microsoft.com/office/drawing/2014/main" id="{ED2420D4-4AA1-1763-8CD8-308BE029B528}"/>
                  </a:ext>
                </a:extLst>
              </p:cNvPr>
              <p:cNvGrpSpPr/>
              <p:nvPr/>
            </p:nvGrpSpPr>
            <p:grpSpPr>
              <a:xfrm>
                <a:off x="2088556" y="697235"/>
                <a:ext cx="285332" cy="636518"/>
                <a:chOff x="7107335" y="4060466"/>
                <a:chExt cx="246222" cy="717118"/>
              </a:xfrm>
            </p:grpSpPr>
            <p:sp>
              <p:nvSpPr>
                <p:cNvPr id="511" name="TextBox 51">
                  <a:extLst>
                    <a:ext uri="{FF2B5EF4-FFF2-40B4-BE49-F238E27FC236}">
                      <a16:creationId xmlns:a16="http://schemas.microsoft.com/office/drawing/2014/main" id="{E4B99F41-359C-762E-AA5F-83A9582C012C}"/>
                    </a:ext>
                  </a:extLst>
                </p:cNvPr>
                <p:cNvSpPr txBox="1"/>
                <p:nvPr/>
              </p:nvSpPr>
              <p:spPr>
                <a:xfrm>
                  <a:off x="7159391" y="4248209"/>
                  <a:ext cx="19416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512" name="TextBox 51">
                  <a:extLst>
                    <a:ext uri="{FF2B5EF4-FFF2-40B4-BE49-F238E27FC236}">
                      <a16:creationId xmlns:a16="http://schemas.microsoft.com/office/drawing/2014/main" id="{AE9D4FB3-4AFE-BA3A-DCDE-B98A4F6CB655}"/>
                    </a:ext>
                  </a:extLst>
                </p:cNvPr>
                <p:cNvSpPr txBox="1"/>
                <p:nvPr/>
              </p:nvSpPr>
              <p:spPr>
                <a:xfrm>
                  <a:off x="7107339" y="4623697"/>
                  <a:ext cx="246218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3" name="TextBox 61">
                  <a:extLst>
                    <a:ext uri="{FF2B5EF4-FFF2-40B4-BE49-F238E27FC236}">
                      <a16:creationId xmlns:a16="http://schemas.microsoft.com/office/drawing/2014/main" id="{E4608614-22BF-1A86-733C-17941B04C488}"/>
                    </a:ext>
                  </a:extLst>
                </p:cNvPr>
                <p:cNvSpPr txBox="1"/>
                <p:nvPr/>
              </p:nvSpPr>
              <p:spPr>
                <a:xfrm>
                  <a:off x="7107335" y="4435954"/>
                  <a:ext cx="24622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4" name="TextBox 51">
                  <a:extLst>
                    <a:ext uri="{FF2B5EF4-FFF2-40B4-BE49-F238E27FC236}">
                      <a16:creationId xmlns:a16="http://schemas.microsoft.com/office/drawing/2014/main" id="{430492DF-1FA6-D2BE-46C6-03F4A47A222A}"/>
                    </a:ext>
                  </a:extLst>
                </p:cNvPr>
                <p:cNvSpPr txBox="1"/>
                <p:nvPr/>
              </p:nvSpPr>
              <p:spPr>
                <a:xfrm>
                  <a:off x="7159391" y="4060466"/>
                  <a:ext cx="194166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</p:grpSp>
          <p:grpSp>
            <p:nvGrpSpPr>
              <p:cNvPr id="247" name="グループ化 432">
                <a:extLst>
                  <a:ext uri="{FF2B5EF4-FFF2-40B4-BE49-F238E27FC236}">
                    <a16:creationId xmlns:a16="http://schemas.microsoft.com/office/drawing/2014/main" id="{05019721-FE73-30FE-FA0F-086917877B18}"/>
                  </a:ext>
                </a:extLst>
              </p:cNvPr>
              <p:cNvGrpSpPr/>
              <p:nvPr/>
            </p:nvGrpSpPr>
            <p:grpSpPr>
              <a:xfrm>
                <a:off x="4153970" y="675419"/>
                <a:ext cx="299622" cy="658334"/>
                <a:chOff x="7095004" y="4058061"/>
                <a:chExt cx="258553" cy="741692"/>
              </a:xfrm>
            </p:grpSpPr>
            <p:sp>
              <p:nvSpPr>
                <p:cNvPr id="505" name="TextBox 51">
                  <a:extLst>
                    <a:ext uri="{FF2B5EF4-FFF2-40B4-BE49-F238E27FC236}">
                      <a16:creationId xmlns:a16="http://schemas.microsoft.com/office/drawing/2014/main" id="{BC292B01-9A8A-03F2-0275-520B9FFF841A}"/>
                    </a:ext>
                  </a:extLst>
                </p:cNvPr>
                <p:cNvSpPr txBox="1"/>
                <p:nvPr/>
              </p:nvSpPr>
              <p:spPr>
                <a:xfrm>
                  <a:off x="7159391" y="4171723"/>
                  <a:ext cx="194166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</p:txBody>
            </p:sp>
            <p:sp>
              <p:nvSpPr>
                <p:cNvPr id="506" name="TextBox 61">
                  <a:extLst>
                    <a:ext uri="{FF2B5EF4-FFF2-40B4-BE49-F238E27FC236}">
                      <a16:creationId xmlns:a16="http://schemas.microsoft.com/office/drawing/2014/main" id="{8CA27208-ECAF-50A0-9662-BA5AB3964B35}"/>
                    </a:ext>
                  </a:extLst>
                </p:cNvPr>
                <p:cNvSpPr txBox="1"/>
                <p:nvPr/>
              </p:nvSpPr>
              <p:spPr>
                <a:xfrm>
                  <a:off x="7107335" y="4285388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7" name="TextBox 51">
                  <a:extLst>
                    <a:ext uri="{FF2B5EF4-FFF2-40B4-BE49-F238E27FC236}">
                      <a16:creationId xmlns:a16="http://schemas.microsoft.com/office/drawing/2014/main" id="{52E934ED-A495-C763-A9D7-9FA0B4E156DF}"/>
                    </a:ext>
                  </a:extLst>
                </p:cNvPr>
                <p:cNvSpPr txBox="1"/>
                <p:nvPr/>
              </p:nvSpPr>
              <p:spPr>
                <a:xfrm>
                  <a:off x="7095004" y="4512717"/>
                  <a:ext cx="258553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8" name="TextBox 51">
                  <a:extLst>
                    <a:ext uri="{FF2B5EF4-FFF2-40B4-BE49-F238E27FC236}">
                      <a16:creationId xmlns:a16="http://schemas.microsoft.com/office/drawing/2014/main" id="{4321B40D-3253-369D-4C65-0A39629355D0}"/>
                    </a:ext>
                  </a:extLst>
                </p:cNvPr>
                <p:cNvSpPr txBox="1"/>
                <p:nvPr/>
              </p:nvSpPr>
              <p:spPr>
                <a:xfrm>
                  <a:off x="7107339" y="4626380"/>
                  <a:ext cx="246218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9" name="TextBox 61">
                  <a:extLst>
                    <a:ext uri="{FF2B5EF4-FFF2-40B4-BE49-F238E27FC236}">
                      <a16:creationId xmlns:a16="http://schemas.microsoft.com/office/drawing/2014/main" id="{48CDA583-EFB5-B7E6-957D-7DA5219B0464}"/>
                    </a:ext>
                  </a:extLst>
                </p:cNvPr>
                <p:cNvSpPr txBox="1"/>
                <p:nvPr/>
              </p:nvSpPr>
              <p:spPr>
                <a:xfrm>
                  <a:off x="7107335" y="4399053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10" name="TextBox 51">
                  <a:extLst>
                    <a:ext uri="{FF2B5EF4-FFF2-40B4-BE49-F238E27FC236}">
                      <a16:creationId xmlns:a16="http://schemas.microsoft.com/office/drawing/2014/main" id="{3D9F3348-C73A-E934-8AC9-D7D3921879EB}"/>
                    </a:ext>
                  </a:extLst>
                </p:cNvPr>
                <p:cNvSpPr txBox="1"/>
                <p:nvPr/>
              </p:nvSpPr>
              <p:spPr>
                <a:xfrm>
                  <a:off x="7159391" y="4058061"/>
                  <a:ext cx="194166" cy="17337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5</a:t>
                  </a:r>
                </a:p>
              </p:txBody>
            </p:sp>
          </p:grpSp>
          <p:grpSp>
            <p:nvGrpSpPr>
              <p:cNvPr id="248" name="グループ化 422">
                <a:extLst>
                  <a:ext uri="{FF2B5EF4-FFF2-40B4-BE49-F238E27FC236}">
                    <a16:creationId xmlns:a16="http://schemas.microsoft.com/office/drawing/2014/main" id="{E04B3430-AA96-D2B5-1F4A-5B0B87C89BBC}"/>
                  </a:ext>
                </a:extLst>
              </p:cNvPr>
              <p:cNvGrpSpPr/>
              <p:nvPr/>
            </p:nvGrpSpPr>
            <p:grpSpPr>
              <a:xfrm>
                <a:off x="23143" y="1448739"/>
                <a:ext cx="285332" cy="636518"/>
                <a:chOff x="7107335" y="4060466"/>
                <a:chExt cx="246222" cy="717118"/>
              </a:xfrm>
            </p:grpSpPr>
            <p:sp>
              <p:nvSpPr>
                <p:cNvPr id="501" name="TextBox 51">
                  <a:extLst>
                    <a:ext uri="{FF2B5EF4-FFF2-40B4-BE49-F238E27FC236}">
                      <a16:creationId xmlns:a16="http://schemas.microsoft.com/office/drawing/2014/main" id="{4F07F9A4-5346-8830-8483-A2C4C5064EFE}"/>
                    </a:ext>
                  </a:extLst>
                </p:cNvPr>
                <p:cNvSpPr txBox="1"/>
                <p:nvPr/>
              </p:nvSpPr>
              <p:spPr>
                <a:xfrm>
                  <a:off x="7159391" y="4248209"/>
                  <a:ext cx="19416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502" name="TextBox 51">
                  <a:extLst>
                    <a:ext uri="{FF2B5EF4-FFF2-40B4-BE49-F238E27FC236}">
                      <a16:creationId xmlns:a16="http://schemas.microsoft.com/office/drawing/2014/main" id="{B6826D19-AC63-F278-1A41-FE589EF205B6}"/>
                    </a:ext>
                  </a:extLst>
                </p:cNvPr>
                <p:cNvSpPr txBox="1"/>
                <p:nvPr/>
              </p:nvSpPr>
              <p:spPr>
                <a:xfrm>
                  <a:off x="7107339" y="4623697"/>
                  <a:ext cx="246218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3" name="TextBox 61">
                  <a:extLst>
                    <a:ext uri="{FF2B5EF4-FFF2-40B4-BE49-F238E27FC236}">
                      <a16:creationId xmlns:a16="http://schemas.microsoft.com/office/drawing/2014/main" id="{A82C19E4-B16D-749D-8264-8CD1178E08C3}"/>
                    </a:ext>
                  </a:extLst>
                </p:cNvPr>
                <p:cNvSpPr txBox="1"/>
                <p:nvPr/>
              </p:nvSpPr>
              <p:spPr>
                <a:xfrm>
                  <a:off x="7107335" y="4435954"/>
                  <a:ext cx="24622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4" name="TextBox 51">
                  <a:extLst>
                    <a:ext uri="{FF2B5EF4-FFF2-40B4-BE49-F238E27FC236}">
                      <a16:creationId xmlns:a16="http://schemas.microsoft.com/office/drawing/2014/main" id="{8B429553-FE51-AE52-A84A-58CAF7E2BD7A}"/>
                    </a:ext>
                  </a:extLst>
                </p:cNvPr>
                <p:cNvSpPr txBox="1"/>
                <p:nvPr/>
              </p:nvSpPr>
              <p:spPr>
                <a:xfrm>
                  <a:off x="7159391" y="4060466"/>
                  <a:ext cx="194166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</p:grpSp>
          <p:grpSp>
            <p:nvGrpSpPr>
              <p:cNvPr id="249" name="グループ化 422">
                <a:extLst>
                  <a:ext uri="{FF2B5EF4-FFF2-40B4-BE49-F238E27FC236}">
                    <a16:creationId xmlns:a16="http://schemas.microsoft.com/office/drawing/2014/main" id="{3021CC65-1862-FB88-6DE2-3B0CAF32A4B5}"/>
                  </a:ext>
                </a:extLst>
              </p:cNvPr>
              <p:cNvGrpSpPr/>
              <p:nvPr/>
            </p:nvGrpSpPr>
            <p:grpSpPr>
              <a:xfrm>
                <a:off x="2088556" y="1448739"/>
                <a:ext cx="285332" cy="636518"/>
                <a:chOff x="7107335" y="4060466"/>
                <a:chExt cx="246222" cy="717118"/>
              </a:xfrm>
            </p:grpSpPr>
            <p:sp>
              <p:nvSpPr>
                <p:cNvPr id="497" name="TextBox 51">
                  <a:extLst>
                    <a:ext uri="{FF2B5EF4-FFF2-40B4-BE49-F238E27FC236}">
                      <a16:creationId xmlns:a16="http://schemas.microsoft.com/office/drawing/2014/main" id="{A85DCB4E-DFD9-A71E-8A55-5A6181DC7978}"/>
                    </a:ext>
                  </a:extLst>
                </p:cNvPr>
                <p:cNvSpPr txBox="1"/>
                <p:nvPr/>
              </p:nvSpPr>
              <p:spPr>
                <a:xfrm>
                  <a:off x="7159391" y="4248209"/>
                  <a:ext cx="19416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498" name="TextBox 51">
                  <a:extLst>
                    <a:ext uri="{FF2B5EF4-FFF2-40B4-BE49-F238E27FC236}">
                      <a16:creationId xmlns:a16="http://schemas.microsoft.com/office/drawing/2014/main" id="{8329CE19-0758-F4BD-4229-9B6C6F2E4EA9}"/>
                    </a:ext>
                  </a:extLst>
                </p:cNvPr>
                <p:cNvSpPr txBox="1"/>
                <p:nvPr/>
              </p:nvSpPr>
              <p:spPr>
                <a:xfrm>
                  <a:off x="7107339" y="4623697"/>
                  <a:ext cx="246218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9" name="TextBox 61">
                  <a:extLst>
                    <a:ext uri="{FF2B5EF4-FFF2-40B4-BE49-F238E27FC236}">
                      <a16:creationId xmlns:a16="http://schemas.microsoft.com/office/drawing/2014/main" id="{F1016611-F6B5-C6B3-826F-BA2A57F9AEB4}"/>
                    </a:ext>
                  </a:extLst>
                </p:cNvPr>
                <p:cNvSpPr txBox="1"/>
                <p:nvPr/>
              </p:nvSpPr>
              <p:spPr>
                <a:xfrm>
                  <a:off x="7107335" y="4435954"/>
                  <a:ext cx="24622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0" name="TextBox 51">
                  <a:extLst>
                    <a:ext uri="{FF2B5EF4-FFF2-40B4-BE49-F238E27FC236}">
                      <a16:creationId xmlns:a16="http://schemas.microsoft.com/office/drawing/2014/main" id="{2725508D-9028-D313-352D-63B31659A0BD}"/>
                    </a:ext>
                  </a:extLst>
                </p:cNvPr>
                <p:cNvSpPr txBox="1"/>
                <p:nvPr/>
              </p:nvSpPr>
              <p:spPr>
                <a:xfrm>
                  <a:off x="7159391" y="4060466"/>
                  <a:ext cx="194166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</p:grpSp>
          <p:grpSp>
            <p:nvGrpSpPr>
              <p:cNvPr id="250" name="グループ化 422">
                <a:extLst>
                  <a:ext uri="{FF2B5EF4-FFF2-40B4-BE49-F238E27FC236}">
                    <a16:creationId xmlns:a16="http://schemas.microsoft.com/office/drawing/2014/main" id="{AF47420C-DEB3-C8A3-BF8E-9763474BD7F5}"/>
                  </a:ext>
                </a:extLst>
              </p:cNvPr>
              <p:cNvGrpSpPr/>
              <p:nvPr/>
            </p:nvGrpSpPr>
            <p:grpSpPr>
              <a:xfrm>
                <a:off x="23143" y="2210960"/>
                <a:ext cx="285332" cy="636518"/>
                <a:chOff x="7107335" y="4060466"/>
                <a:chExt cx="246222" cy="717118"/>
              </a:xfrm>
            </p:grpSpPr>
            <p:sp>
              <p:nvSpPr>
                <p:cNvPr id="493" name="TextBox 51">
                  <a:extLst>
                    <a:ext uri="{FF2B5EF4-FFF2-40B4-BE49-F238E27FC236}">
                      <a16:creationId xmlns:a16="http://schemas.microsoft.com/office/drawing/2014/main" id="{29479E86-B4C2-D6BA-A1FC-9D84AEB1905E}"/>
                    </a:ext>
                  </a:extLst>
                </p:cNvPr>
                <p:cNvSpPr txBox="1"/>
                <p:nvPr/>
              </p:nvSpPr>
              <p:spPr>
                <a:xfrm>
                  <a:off x="7159391" y="4248209"/>
                  <a:ext cx="19416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494" name="TextBox 51">
                  <a:extLst>
                    <a:ext uri="{FF2B5EF4-FFF2-40B4-BE49-F238E27FC236}">
                      <a16:creationId xmlns:a16="http://schemas.microsoft.com/office/drawing/2014/main" id="{5E1A0CFF-89C1-AE6C-9524-7CE2E9D02BAC}"/>
                    </a:ext>
                  </a:extLst>
                </p:cNvPr>
                <p:cNvSpPr txBox="1"/>
                <p:nvPr/>
              </p:nvSpPr>
              <p:spPr>
                <a:xfrm>
                  <a:off x="7107339" y="4623697"/>
                  <a:ext cx="246218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5" name="TextBox 61">
                  <a:extLst>
                    <a:ext uri="{FF2B5EF4-FFF2-40B4-BE49-F238E27FC236}">
                      <a16:creationId xmlns:a16="http://schemas.microsoft.com/office/drawing/2014/main" id="{376AB06A-83D1-BE04-99D2-0B02C5D94C91}"/>
                    </a:ext>
                  </a:extLst>
                </p:cNvPr>
                <p:cNvSpPr txBox="1"/>
                <p:nvPr/>
              </p:nvSpPr>
              <p:spPr>
                <a:xfrm>
                  <a:off x="7107335" y="4435954"/>
                  <a:ext cx="24622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6" name="TextBox 51">
                  <a:extLst>
                    <a:ext uri="{FF2B5EF4-FFF2-40B4-BE49-F238E27FC236}">
                      <a16:creationId xmlns:a16="http://schemas.microsoft.com/office/drawing/2014/main" id="{DFB9B61B-BACE-2466-AEB9-C631ECEBADD2}"/>
                    </a:ext>
                  </a:extLst>
                </p:cNvPr>
                <p:cNvSpPr txBox="1"/>
                <p:nvPr/>
              </p:nvSpPr>
              <p:spPr>
                <a:xfrm>
                  <a:off x="7159391" y="4060466"/>
                  <a:ext cx="194166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</p:grpSp>
          <p:grpSp>
            <p:nvGrpSpPr>
              <p:cNvPr id="252" name="グループ化 422">
                <a:extLst>
                  <a:ext uri="{FF2B5EF4-FFF2-40B4-BE49-F238E27FC236}">
                    <a16:creationId xmlns:a16="http://schemas.microsoft.com/office/drawing/2014/main" id="{12F24C87-FC06-8589-2D00-F8679C7AB4D8}"/>
                  </a:ext>
                </a:extLst>
              </p:cNvPr>
              <p:cNvGrpSpPr/>
              <p:nvPr/>
            </p:nvGrpSpPr>
            <p:grpSpPr>
              <a:xfrm>
                <a:off x="4163795" y="2210960"/>
                <a:ext cx="285332" cy="636518"/>
                <a:chOff x="7107335" y="4060466"/>
                <a:chExt cx="246222" cy="717118"/>
              </a:xfrm>
            </p:grpSpPr>
            <p:sp>
              <p:nvSpPr>
                <p:cNvPr id="489" name="TextBox 51">
                  <a:extLst>
                    <a:ext uri="{FF2B5EF4-FFF2-40B4-BE49-F238E27FC236}">
                      <a16:creationId xmlns:a16="http://schemas.microsoft.com/office/drawing/2014/main" id="{E475E645-21B6-08FA-F4C7-E2104FCD6073}"/>
                    </a:ext>
                  </a:extLst>
                </p:cNvPr>
                <p:cNvSpPr txBox="1"/>
                <p:nvPr/>
              </p:nvSpPr>
              <p:spPr>
                <a:xfrm>
                  <a:off x="7159391" y="4248209"/>
                  <a:ext cx="194166" cy="17337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</p:txBody>
            </p:sp>
            <p:sp>
              <p:nvSpPr>
                <p:cNvPr id="490" name="TextBox 51">
                  <a:extLst>
                    <a:ext uri="{FF2B5EF4-FFF2-40B4-BE49-F238E27FC236}">
                      <a16:creationId xmlns:a16="http://schemas.microsoft.com/office/drawing/2014/main" id="{27DAF2C5-934B-33F6-5AC6-96F6C1959EBB}"/>
                    </a:ext>
                  </a:extLst>
                </p:cNvPr>
                <p:cNvSpPr txBox="1"/>
                <p:nvPr/>
              </p:nvSpPr>
              <p:spPr>
                <a:xfrm>
                  <a:off x="7107339" y="4623697"/>
                  <a:ext cx="246218" cy="153887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1" name="TextBox 61">
                  <a:extLst>
                    <a:ext uri="{FF2B5EF4-FFF2-40B4-BE49-F238E27FC236}">
                      <a16:creationId xmlns:a16="http://schemas.microsoft.com/office/drawing/2014/main" id="{FC164118-D2F9-14B5-BC1A-E4FB96D9C99E}"/>
                    </a:ext>
                  </a:extLst>
                </p:cNvPr>
                <p:cNvSpPr txBox="1"/>
                <p:nvPr/>
              </p:nvSpPr>
              <p:spPr>
                <a:xfrm>
                  <a:off x="7107335" y="4435954"/>
                  <a:ext cx="246222" cy="17337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2" name="TextBox 51">
                  <a:extLst>
                    <a:ext uri="{FF2B5EF4-FFF2-40B4-BE49-F238E27FC236}">
                      <a16:creationId xmlns:a16="http://schemas.microsoft.com/office/drawing/2014/main" id="{EA6DC9E0-EDFD-BC76-3344-380E85AE89A9}"/>
                    </a:ext>
                  </a:extLst>
                </p:cNvPr>
                <p:cNvSpPr txBox="1"/>
                <p:nvPr/>
              </p:nvSpPr>
              <p:spPr>
                <a:xfrm>
                  <a:off x="7159391" y="4060466"/>
                  <a:ext cx="194166" cy="17337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</a:p>
              </p:txBody>
            </p:sp>
          </p:grpSp>
          <p:grpSp>
            <p:nvGrpSpPr>
              <p:cNvPr id="255" name="グループ化 432">
                <a:extLst>
                  <a:ext uri="{FF2B5EF4-FFF2-40B4-BE49-F238E27FC236}">
                    <a16:creationId xmlns:a16="http://schemas.microsoft.com/office/drawing/2014/main" id="{B709CEA8-7823-3DB7-1F3F-3BDC5BDA40FE}"/>
                  </a:ext>
                </a:extLst>
              </p:cNvPr>
              <p:cNvGrpSpPr/>
              <p:nvPr/>
            </p:nvGrpSpPr>
            <p:grpSpPr>
              <a:xfrm>
                <a:off x="2088556" y="2956003"/>
                <a:ext cx="285332" cy="655953"/>
                <a:chOff x="7107335" y="4058061"/>
                <a:chExt cx="246222" cy="739009"/>
              </a:xfrm>
            </p:grpSpPr>
            <p:sp>
              <p:nvSpPr>
                <p:cNvPr id="478" name="TextBox 51">
                  <a:extLst>
                    <a:ext uri="{FF2B5EF4-FFF2-40B4-BE49-F238E27FC236}">
                      <a16:creationId xmlns:a16="http://schemas.microsoft.com/office/drawing/2014/main" id="{D006FE6F-6FE1-4A19-17F9-C78E25565C81}"/>
                    </a:ext>
                  </a:extLst>
                </p:cNvPr>
                <p:cNvSpPr txBox="1"/>
                <p:nvPr/>
              </p:nvSpPr>
              <p:spPr>
                <a:xfrm>
                  <a:off x="7159391" y="4199469"/>
                  <a:ext cx="194166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</a:p>
              </p:txBody>
            </p:sp>
            <p:sp>
              <p:nvSpPr>
                <p:cNvPr id="479" name="TextBox 61">
                  <a:extLst>
                    <a:ext uri="{FF2B5EF4-FFF2-40B4-BE49-F238E27FC236}">
                      <a16:creationId xmlns:a16="http://schemas.microsoft.com/office/drawing/2014/main" id="{8F8D1E58-B1EA-FAD1-6164-050D2DE84BB3}"/>
                    </a:ext>
                  </a:extLst>
                </p:cNvPr>
                <p:cNvSpPr txBox="1"/>
                <p:nvPr/>
              </p:nvSpPr>
              <p:spPr>
                <a:xfrm>
                  <a:off x="7107335" y="4340878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</a:p>
              </p:txBody>
            </p:sp>
            <p:sp>
              <p:nvSpPr>
                <p:cNvPr id="480" name="TextBox 51">
                  <a:extLst>
                    <a:ext uri="{FF2B5EF4-FFF2-40B4-BE49-F238E27FC236}">
                      <a16:creationId xmlns:a16="http://schemas.microsoft.com/office/drawing/2014/main" id="{63A56018-243F-E472-7B4B-CD32780B98A6}"/>
                    </a:ext>
                  </a:extLst>
                </p:cNvPr>
                <p:cNvSpPr txBox="1"/>
                <p:nvPr/>
              </p:nvSpPr>
              <p:spPr>
                <a:xfrm>
                  <a:off x="7107339" y="4623697"/>
                  <a:ext cx="246218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1" name="TextBox 61">
                  <a:extLst>
                    <a:ext uri="{FF2B5EF4-FFF2-40B4-BE49-F238E27FC236}">
                      <a16:creationId xmlns:a16="http://schemas.microsoft.com/office/drawing/2014/main" id="{A70F3164-F1D2-BE5E-4C98-8EE14879C073}"/>
                    </a:ext>
                  </a:extLst>
                </p:cNvPr>
                <p:cNvSpPr txBox="1"/>
                <p:nvPr/>
              </p:nvSpPr>
              <p:spPr>
                <a:xfrm>
                  <a:off x="7107335" y="4482288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2" name="TextBox 51">
                  <a:extLst>
                    <a:ext uri="{FF2B5EF4-FFF2-40B4-BE49-F238E27FC236}">
                      <a16:creationId xmlns:a16="http://schemas.microsoft.com/office/drawing/2014/main" id="{E893BED1-6F4C-07B0-4E9F-F5EED40041D5}"/>
                    </a:ext>
                  </a:extLst>
                </p:cNvPr>
                <p:cNvSpPr txBox="1"/>
                <p:nvPr/>
              </p:nvSpPr>
              <p:spPr>
                <a:xfrm>
                  <a:off x="7159391" y="4058061"/>
                  <a:ext cx="194166" cy="17337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</p:txBody>
            </p:sp>
          </p:grpSp>
          <p:sp>
            <p:nvSpPr>
              <p:cNvPr id="231" name="テキスト ボックス 250">
                <a:extLst>
                  <a:ext uri="{FF2B5EF4-FFF2-40B4-BE49-F238E27FC236}">
                    <a16:creationId xmlns:a16="http://schemas.microsoft.com/office/drawing/2014/main" id="{3B77D337-5C9B-6E43-46C9-F19589DA2736}"/>
                  </a:ext>
                </a:extLst>
              </p:cNvPr>
              <p:cNvSpPr txBox="1"/>
              <p:nvPr/>
            </p:nvSpPr>
            <p:spPr>
              <a:xfrm>
                <a:off x="3103242" y="2836703"/>
                <a:ext cx="4555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OTC</a:t>
                </a:r>
              </a:p>
            </p:txBody>
          </p:sp>
          <p:sp>
            <p:nvSpPr>
              <p:cNvPr id="205" name="テキスト ボックス 250">
                <a:extLst>
                  <a:ext uri="{FF2B5EF4-FFF2-40B4-BE49-F238E27FC236}">
                    <a16:creationId xmlns:a16="http://schemas.microsoft.com/office/drawing/2014/main" id="{F4C92420-F67E-D978-421E-7FA1401048F9}"/>
                  </a:ext>
                </a:extLst>
              </p:cNvPr>
              <p:cNvSpPr txBox="1"/>
              <p:nvPr/>
            </p:nvSpPr>
            <p:spPr>
              <a:xfrm>
                <a:off x="992293" y="2836703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BSEP</a:t>
                </a:r>
              </a:p>
            </p:txBody>
          </p:sp>
          <p:sp>
            <p:nvSpPr>
              <p:cNvPr id="534" name="テキスト ボックス 250">
                <a:extLst>
                  <a:ext uri="{FF2B5EF4-FFF2-40B4-BE49-F238E27FC236}">
                    <a16:creationId xmlns:a16="http://schemas.microsoft.com/office/drawing/2014/main" id="{E6BAFBCD-913A-8FE2-8045-94EC723B79E6}"/>
                  </a:ext>
                </a:extLst>
              </p:cNvPr>
              <p:cNvSpPr txBox="1"/>
              <p:nvPr/>
            </p:nvSpPr>
            <p:spPr>
              <a:xfrm>
                <a:off x="5133239" y="2836703"/>
                <a:ext cx="5405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ARG1</a:t>
                </a:r>
              </a:p>
            </p:txBody>
          </p:sp>
          <p:sp>
            <p:nvSpPr>
              <p:cNvPr id="251" name="テキスト ボックス 250">
                <a:extLst>
                  <a:ext uri="{FF2B5EF4-FFF2-40B4-BE49-F238E27FC236}">
                    <a16:creationId xmlns:a16="http://schemas.microsoft.com/office/drawing/2014/main" id="{127AC22B-C751-7974-3957-CBF6BE973C72}"/>
                  </a:ext>
                </a:extLst>
              </p:cNvPr>
              <p:cNvSpPr txBox="1"/>
              <p:nvPr/>
            </p:nvSpPr>
            <p:spPr>
              <a:xfrm>
                <a:off x="5133239" y="2074513"/>
                <a:ext cx="5405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MRP2</a:t>
                </a:r>
              </a:p>
            </p:txBody>
          </p:sp>
          <p:sp>
            <p:nvSpPr>
              <p:cNvPr id="185" name="テキスト ボックス 250">
                <a:extLst>
                  <a:ext uri="{FF2B5EF4-FFF2-40B4-BE49-F238E27FC236}">
                    <a16:creationId xmlns:a16="http://schemas.microsoft.com/office/drawing/2014/main" id="{E64F215A-AC1C-FCD9-7C31-903BFC26E000}"/>
                  </a:ext>
                </a:extLst>
              </p:cNvPr>
              <p:cNvSpPr txBox="1"/>
              <p:nvPr/>
            </p:nvSpPr>
            <p:spPr>
              <a:xfrm>
                <a:off x="921761" y="2074513"/>
                <a:ext cx="67358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CYP2E1</a:t>
                </a:r>
              </a:p>
            </p:txBody>
          </p:sp>
          <p:sp>
            <p:nvSpPr>
              <p:cNvPr id="535" name="テキスト ボックス 250">
                <a:extLst>
                  <a:ext uri="{FF2B5EF4-FFF2-40B4-BE49-F238E27FC236}">
                    <a16:creationId xmlns:a16="http://schemas.microsoft.com/office/drawing/2014/main" id="{F768904E-D86E-9F63-1D03-EFF52D07F101}"/>
                  </a:ext>
                </a:extLst>
              </p:cNvPr>
              <p:cNvSpPr txBox="1"/>
              <p:nvPr/>
            </p:nvSpPr>
            <p:spPr>
              <a:xfrm>
                <a:off x="2986223" y="2074513"/>
                <a:ext cx="6896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UGT1A1</a:t>
                </a:r>
              </a:p>
            </p:txBody>
          </p:sp>
          <p:grpSp>
            <p:nvGrpSpPr>
              <p:cNvPr id="1112" name="グループ化 1111">
                <a:extLst>
                  <a:ext uri="{FF2B5EF4-FFF2-40B4-BE49-F238E27FC236}">
                    <a16:creationId xmlns:a16="http://schemas.microsoft.com/office/drawing/2014/main" id="{558D7D6D-BE22-DBBB-B5F5-3D519871804C}"/>
                  </a:ext>
                </a:extLst>
              </p:cNvPr>
              <p:cNvGrpSpPr/>
              <p:nvPr/>
            </p:nvGrpSpPr>
            <p:grpSpPr>
              <a:xfrm>
                <a:off x="323741" y="3594896"/>
                <a:ext cx="1867010" cy="681667"/>
                <a:chOff x="4539642" y="2997523"/>
                <a:chExt cx="1867010" cy="681667"/>
              </a:xfrm>
            </p:grpSpPr>
            <p:sp>
              <p:nvSpPr>
                <p:cNvPr id="1113" name="TextBox 51">
                  <a:extLst>
                    <a:ext uri="{FF2B5EF4-FFF2-40B4-BE49-F238E27FC236}">
                      <a16:creationId xmlns:a16="http://schemas.microsoft.com/office/drawing/2014/main" id="{39F2BCD9-900F-01E9-1717-5DA5F4D4C967}"/>
                    </a:ext>
                  </a:extLst>
                </p:cNvPr>
                <p:cNvSpPr txBox="1"/>
                <p:nvPr/>
              </p:nvSpPr>
              <p:spPr>
                <a:xfrm rot="16200000">
                  <a:off x="4402317" y="3134848"/>
                  <a:ext cx="428537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S</a:t>
                  </a:r>
                  <a:endParaRPr lang="en-US" sz="1000" b="1" dirty="0"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4" name="TextBox 61">
                  <a:extLst>
                    <a:ext uri="{FF2B5EF4-FFF2-40B4-BE49-F238E27FC236}">
                      <a16:creationId xmlns:a16="http://schemas.microsoft.com/office/drawing/2014/main" id="{74D9476A-AE42-5929-3AC3-7B098170EFB9}"/>
                    </a:ext>
                  </a:extLst>
                </p:cNvPr>
                <p:cNvSpPr txBox="1"/>
                <p:nvPr/>
              </p:nvSpPr>
              <p:spPr>
                <a:xfrm rot="16200000">
                  <a:off x="4496427" y="3146012"/>
                  <a:ext cx="445642" cy="14866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5" name="TextBox 51">
                  <a:extLst>
                    <a:ext uri="{FF2B5EF4-FFF2-40B4-BE49-F238E27FC236}">
                      <a16:creationId xmlns:a16="http://schemas.microsoft.com/office/drawing/2014/main" id="{E9026D5C-EFE3-9A51-ED92-AA9FFDC22A54}"/>
                    </a:ext>
                  </a:extLst>
                </p:cNvPr>
                <p:cNvSpPr txBox="1"/>
                <p:nvPr/>
              </p:nvSpPr>
              <p:spPr>
                <a:xfrm rot="16200000">
                  <a:off x="4607641" y="3137460"/>
                  <a:ext cx="428537" cy="14866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N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6" name="TextBox 51">
                  <a:extLst>
                    <a:ext uri="{FF2B5EF4-FFF2-40B4-BE49-F238E27FC236}">
                      <a16:creationId xmlns:a16="http://schemas.microsoft.com/office/drawing/2014/main" id="{163CEA74-85E5-1A60-1B71-DC15FA2A20CA}"/>
                    </a:ext>
                  </a:extLst>
                </p:cNvPr>
                <p:cNvSpPr txBox="1"/>
                <p:nvPr/>
              </p:nvSpPr>
              <p:spPr>
                <a:xfrm rot="16200000">
                  <a:off x="4687978" y="3159785"/>
                  <a:ext cx="47841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Y</a:t>
                  </a:r>
                </a:p>
              </p:txBody>
            </p:sp>
            <p:sp>
              <p:nvSpPr>
                <p:cNvPr id="1117" name="TextBox 51">
                  <a:extLst>
                    <a:ext uri="{FF2B5EF4-FFF2-40B4-BE49-F238E27FC236}">
                      <a16:creationId xmlns:a16="http://schemas.microsoft.com/office/drawing/2014/main" id="{62D91438-C456-2E2B-5E3B-CBC0C2418B92}"/>
                    </a:ext>
                  </a:extLst>
                </p:cNvPr>
                <p:cNvSpPr txBox="1"/>
                <p:nvPr/>
              </p:nvSpPr>
              <p:spPr>
                <a:xfrm rot="16200000">
                  <a:off x="4815741" y="3139908"/>
                  <a:ext cx="43865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YH</a:t>
                  </a:r>
                </a:p>
              </p:txBody>
            </p:sp>
            <p:sp>
              <p:nvSpPr>
                <p:cNvPr id="1118" name="TextBox 51">
                  <a:extLst>
                    <a:ext uri="{FF2B5EF4-FFF2-40B4-BE49-F238E27FC236}">
                      <a16:creationId xmlns:a16="http://schemas.microsoft.com/office/drawing/2014/main" id="{C74F6D4D-27F3-BA90-F90C-D8780FD21033}"/>
                    </a:ext>
                  </a:extLst>
                </p:cNvPr>
                <p:cNvSpPr txBox="1"/>
                <p:nvPr/>
              </p:nvSpPr>
              <p:spPr>
                <a:xfrm rot="16200000">
                  <a:off x="4903750" y="3159785"/>
                  <a:ext cx="47841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TA</a:t>
                  </a:r>
                </a:p>
              </p:txBody>
            </p:sp>
            <p:sp>
              <p:nvSpPr>
                <p:cNvPr id="1119" name="TextBox 51">
                  <a:extLst>
                    <a:ext uri="{FF2B5EF4-FFF2-40B4-BE49-F238E27FC236}">
                      <a16:creationId xmlns:a16="http://schemas.microsoft.com/office/drawing/2014/main" id="{396E836D-637D-AD95-A9BD-41EA049FEA33}"/>
                    </a:ext>
                  </a:extLst>
                </p:cNvPr>
                <p:cNvSpPr txBox="1"/>
                <p:nvPr/>
              </p:nvSpPr>
              <p:spPr>
                <a:xfrm rot="16200000">
                  <a:off x="4951364" y="3220058"/>
                  <a:ext cx="59895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GDME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0" name="TextBox 51">
                  <a:extLst>
                    <a:ext uri="{FF2B5EF4-FFF2-40B4-BE49-F238E27FC236}">
                      <a16:creationId xmlns:a16="http://schemas.microsoft.com/office/drawing/2014/main" id="{E21C0728-8275-31CE-8DA7-E68F21779BA1}"/>
                    </a:ext>
                  </a:extLst>
                </p:cNvPr>
                <p:cNvSpPr txBox="1"/>
                <p:nvPr/>
              </p:nvSpPr>
              <p:spPr>
                <a:xfrm rot="16200000">
                  <a:off x="5059250" y="3220058"/>
                  <a:ext cx="59895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E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1" name="TextBox 51">
                  <a:extLst>
                    <a:ext uri="{FF2B5EF4-FFF2-40B4-BE49-F238E27FC236}">
                      <a16:creationId xmlns:a16="http://schemas.microsoft.com/office/drawing/2014/main" id="{C35BB0EE-C045-5232-BB3C-35336532B8F0}"/>
                    </a:ext>
                  </a:extLst>
                </p:cNvPr>
                <p:cNvSpPr txBox="1"/>
                <p:nvPr/>
              </p:nvSpPr>
              <p:spPr>
                <a:xfrm rot="16200000">
                  <a:off x="5195163" y="3192030"/>
                  <a:ext cx="54290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G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2" name="TextBox 51">
                  <a:extLst>
                    <a:ext uri="{FF2B5EF4-FFF2-40B4-BE49-F238E27FC236}">
                      <a16:creationId xmlns:a16="http://schemas.microsoft.com/office/drawing/2014/main" id="{FE884217-E1E9-0142-FF19-2EF300F1BC24}"/>
                    </a:ext>
                  </a:extLst>
                </p:cNvPr>
                <p:cNvSpPr txBox="1"/>
                <p:nvPr/>
              </p:nvSpPr>
              <p:spPr>
                <a:xfrm rot="16200000">
                  <a:off x="5360231" y="3134848"/>
                  <a:ext cx="428537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O</a:t>
                  </a:r>
                  <a:endParaRPr lang="en-US" sz="1000" b="1" dirty="0"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3" name="TextBox 61">
                  <a:extLst>
                    <a:ext uri="{FF2B5EF4-FFF2-40B4-BE49-F238E27FC236}">
                      <a16:creationId xmlns:a16="http://schemas.microsoft.com/office/drawing/2014/main" id="{E1427BF3-6283-A9A1-8BA1-EEF78B48ABEC}"/>
                    </a:ext>
                  </a:extLst>
                </p:cNvPr>
                <p:cNvSpPr txBox="1"/>
                <p:nvPr/>
              </p:nvSpPr>
              <p:spPr>
                <a:xfrm rot="16200000">
                  <a:off x="5341553" y="3261412"/>
                  <a:ext cx="681665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mall-PEG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4" name="TextBox 51">
                  <a:extLst>
                    <a:ext uri="{FF2B5EF4-FFF2-40B4-BE49-F238E27FC236}">
                      <a16:creationId xmlns:a16="http://schemas.microsoft.com/office/drawing/2014/main" id="{BC402932-3A24-D3C3-E671-E705E2B4A7EB}"/>
                    </a:ext>
                  </a:extLst>
                </p:cNvPr>
                <p:cNvSpPr txBox="1"/>
                <p:nvPr/>
              </p:nvSpPr>
              <p:spPr>
                <a:xfrm rot="16200000">
                  <a:off x="5449439" y="3261413"/>
                  <a:ext cx="68166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rge-PEG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5" name="TextBox 51">
                  <a:extLst>
                    <a:ext uri="{FF2B5EF4-FFF2-40B4-BE49-F238E27FC236}">
                      <a16:creationId xmlns:a16="http://schemas.microsoft.com/office/drawing/2014/main" id="{F04FC282-3672-A650-F27D-20642F1B05C1}"/>
                    </a:ext>
                  </a:extLst>
                </p:cNvPr>
                <p:cNvSpPr txBox="1"/>
                <p:nvPr/>
              </p:nvSpPr>
              <p:spPr>
                <a:xfrm rot="16200000">
                  <a:off x="5557325" y="3261412"/>
                  <a:ext cx="681665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VA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6" name="TextBox 51">
                  <a:extLst>
                    <a:ext uri="{FF2B5EF4-FFF2-40B4-BE49-F238E27FC236}">
                      <a16:creationId xmlns:a16="http://schemas.microsoft.com/office/drawing/2014/main" id="{4488C993-31A2-E8FC-17DE-817352D46A29}"/>
                    </a:ext>
                  </a:extLst>
                </p:cNvPr>
                <p:cNvSpPr txBox="1"/>
                <p:nvPr/>
              </p:nvSpPr>
              <p:spPr>
                <a:xfrm rot="16200000">
                  <a:off x="5786715" y="3139909"/>
                  <a:ext cx="43865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u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7" name="TextBox 51">
                  <a:extLst>
                    <a:ext uri="{FF2B5EF4-FFF2-40B4-BE49-F238E27FC236}">
                      <a16:creationId xmlns:a16="http://schemas.microsoft.com/office/drawing/2014/main" id="{4F53333B-4C76-443F-1315-DCC5AD497D40}"/>
                    </a:ext>
                  </a:extLst>
                </p:cNvPr>
                <p:cNvSpPr txBox="1"/>
                <p:nvPr/>
              </p:nvSpPr>
              <p:spPr>
                <a:xfrm rot="16200000">
                  <a:off x="5874724" y="3159785"/>
                  <a:ext cx="47841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SO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8" name="TextBox 51">
                  <a:extLst>
                    <a:ext uri="{FF2B5EF4-FFF2-40B4-BE49-F238E27FC236}">
                      <a16:creationId xmlns:a16="http://schemas.microsoft.com/office/drawing/2014/main" id="{D1151F17-37EA-A43F-6D09-A4AA90ED0623}"/>
                    </a:ext>
                  </a:extLst>
                </p:cNvPr>
                <p:cNvSpPr txBox="1"/>
                <p:nvPr/>
              </p:nvSpPr>
              <p:spPr>
                <a:xfrm rot="16200000">
                  <a:off x="6002487" y="3139909"/>
                  <a:ext cx="43865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etO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9" name="TextBox 51">
                  <a:extLst>
                    <a:ext uri="{FF2B5EF4-FFF2-40B4-BE49-F238E27FC236}">
                      <a16:creationId xmlns:a16="http://schemas.microsoft.com/office/drawing/2014/main" id="{E3A8F0E1-F759-EB6D-F153-732B1C8E5EAE}"/>
                    </a:ext>
                  </a:extLst>
                </p:cNvPr>
                <p:cNvSpPr txBox="1"/>
                <p:nvPr/>
              </p:nvSpPr>
              <p:spPr>
                <a:xfrm rot="16200000">
                  <a:off x="6065075" y="3185212"/>
                  <a:ext cx="529265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M</a:t>
                  </a:r>
                </a:p>
              </p:txBody>
            </p:sp>
          </p:grpSp>
          <p:grpSp>
            <p:nvGrpSpPr>
              <p:cNvPr id="1184" name="グループ化 1183">
                <a:extLst>
                  <a:ext uri="{FF2B5EF4-FFF2-40B4-BE49-F238E27FC236}">
                    <a16:creationId xmlns:a16="http://schemas.microsoft.com/office/drawing/2014/main" id="{64B61592-4260-6944-8649-651DACABDDED}"/>
                  </a:ext>
                </a:extLst>
              </p:cNvPr>
              <p:cNvGrpSpPr/>
              <p:nvPr/>
            </p:nvGrpSpPr>
            <p:grpSpPr>
              <a:xfrm>
                <a:off x="2396218" y="3594896"/>
                <a:ext cx="1867010" cy="681667"/>
                <a:chOff x="4539642" y="2997523"/>
                <a:chExt cx="1867010" cy="681667"/>
              </a:xfrm>
            </p:grpSpPr>
            <p:sp>
              <p:nvSpPr>
                <p:cNvPr id="1185" name="TextBox 51">
                  <a:extLst>
                    <a:ext uri="{FF2B5EF4-FFF2-40B4-BE49-F238E27FC236}">
                      <a16:creationId xmlns:a16="http://schemas.microsoft.com/office/drawing/2014/main" id="{D9F5002C-825F-FC50-D3F7-F7E1E66A74B0}"/>
                    </a:ext>
                  </a:extLst>
                </p:cNvPr>
                <p:cNvSpPr txBox="1"/>
                <p:nvPr/>
              </p:nvSpPr>
              <p:spPr>
                <a:xfrm rot="16200000">
                  <a:off x="4402317" y="3134848"/>
                  <a:ext cx="428537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S</a:t>
                  </a:r>
                </a:p>
              </p:txBody>
            </p:sp>
            <p:sp>
              <p:nvSpPr>
                <p:cNvPr id="1186" name="TextBox 61">
                  <a:extLst>
                    <a:ext uri="{FF2B5EF4-FFF2-40B4-BE49-F238E27FC236}">
                      <a16:creationId xmlns:a16="http://schemas.microsoft.com/office/drawing/2014/main" id="{5363F779-5C5E-7E69-5BE6-BBCE1595C597}"/>
                    </a:ext>
                  </a:extLst>
                </p:cNvPr>
                <p:cNvSpPr txBox="1"/>
                <p:nvPr/>
              </p:nvSpPr>
              <p:spPr>
                <a:xfrm rot="16200000">
                  <a:off x="4496427" y="3146012"/>
                  <a:ext cx="445642" cy="14866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7" name="TextBox 51">
                  <a:extLst>
                    <a:ext uri="{FF2B5EF4-FFF2-40B4-BE49-F238E27FC236}">
                      <a16:creationId xmlns:a16="http://schemas.microsoft.com/office/drawing/2014/main" id="{AB73E784-95C7-EBE9-E7B3-BA1747FAE89D}"/>
                    </a:ext>
                  </a:extLst>
                </p:cNvPr>
                <p:cNvSpPr txBox="1"/>
                <p:nvPr/>
              </p:nvSpPr>
              <p:spPr>
                <a:xfrm rot="16200000">
                  <a:off x="4607641" y="3137460"/>
                  <a:ext cx="428537" cy="14866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N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8" name="TextBox 51">
                  <a:extLst>
                    <a:ext uri="{FF2B5EF4-FFF2-40B4-BE49-F238E27FC236}">
                      <a16:creationId xmlns:a16="http://schemas.microsoft.com/office/drawing/2014/main" id="{0A67BA10-4E6E-20BC-BDB9-938B2B216623}"/>
                    </a:ext>
                  </a:extLst>
                </p:cNvPr>
                <p:cNvSpPr txBox="1"/>
                <p:nvPr/>
              </p:nvSpPr>
              <p:spPr>
                <a:xfrm rot="16200000">
                  <a:off x="4687978" y="3159785"/>
                  <a:ext cx="47841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Y</a:t>
                  </a:r>
                </a:p>
              </p:txBody>
            </p:sp>
            <p:sp>
              <p:nvSpPr>
                <p:cNvPr id="1189" name="TextBox 51">
                  <a:extLst>
                    <a:ext uri="{FF2B5EF4-FFF2-40B4-BE49-F238E27FC236}">
                      <a16:creationId xmlns:a16="http://schemas.microsoft.com/office/drawing/2014/main" id="{1DB3DB8D-6483-DE58-804D-30F60E16FE61}"/>
                    </a:ext>
                  </a:extLst>
                </p:cNvPr>
                <p:cNvSpPr txBox="1"/>
                <p:nvPr/>
              </p:nvSpPr>
              <p:spPr>
                <a:xfrm rot="16200000">
                  <a:off x="4815741" y="3139908"/>
                  <a:ext cx="43865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YH</a:t>
                  </a:r>
                </a:p>
              </p:txBody>
            </p:sp>
            <p:sp>
              <p:nvSpPr>
                <p:cNvPr id="1190" name="TextBox 51">
                  <a:extLst>
                    <a:ext uri="{FF2B5EF4-FFF2-40B4-BE49-F238E27FC236}">
                      <a16:creationId xmlns:a16="http://schemas.microsoft.com/office/drawing/2014/main" id="{59C5C311-945F-7496-327C-6189538368A8}"/>
                    </a:ext>
                  </a:extLst>
                </p:cNvPr>
                <p:cNvSpPr txBox="1"/>
                <p:nvPr/>
              </p:nvSpPr>
              <p:spPr>
                <a:xfrm rot="16200000">
                  <a:off x="4903750" y="3159785"/>
                  <a:ext cx="47841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TA</a:t>
                  </a:r>
                </a:p>
              </p:txBody>
            </p:sp>
            <p:sp>
              <p:nvSpPr>
                <p:cNvPr id="1191" name="TextBox 51">
                  <a:extLst>
                    <a:ext uri="{FF2B5EF4-FFF2-40B4-BE49-F238E27FC236}">
                      <a16:creationId xmlns:a16="http://schemas.microsoft.com/office/drawing/2014/main" id="{861B657F-5B8C-978F-526E-2373B9D19315}"/>
                    </a:ext>
                  </a:extLst>
                </p:cNvPr>
                <p:cNvSpPr txBox="1"/>
                <p:nvPr/>
              </p:nvSpPr>
              <p:spPr>
                <a:xfrm rot="16200000">
                  <a:off x="4951364" y="3220058"/>
                  <a:ext cx="59895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GDME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2" name="TextBox 51">
                  <a:extLst>
                    <a:ext uri="{FF2B5EF4-FFF2-40B4-BE49-F238E27FC236}">
                      <a16:creationId xmlns:a16="http://schemas.microsoft.com/office/drawing/2014/main" id="{F067C699-E0AB-504E-7291-999CB1A66C17}"/>
                    </a:ext>
                  </a:extLst>
                </p:cNvPr>
                <p:cNvSpPr txBox="1"/>
                <p:nvPr/>
              </p:nvSpPr>
              <p:spPr>
                <a:xfrm rot="16200000">
                  <a:off x="5059250" y="3220058"/>
                  <a:ext cx="59895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E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3" name="TextBox 51">
                  <a:extLst>
                    <a:ext uri="{FF2B5EF4-FFF2-40B4-BE49-F238E27FC236}">
                      <a16:creationId xmlns:a16="http://schemas.microsoft.com/office/drawing/2014/main" id="{03C553ED-AE24-264F-3C10-0F2FFE8E3514}"/>
                    </a:ext>
                  </a:extLst>
                </p:cNvPr>
                <p:cNvSpPr txBox="1"/>
                <p:nvPr/>
              </p:nvSpPr>
              <p:spPr>
                <a:xfrm rot="16200000">
                  <a:off x="5195163" y="3192030"/>
                  <a:ext cx="54290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G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4" name="TextBox 51">
                  <a:extLst>
                    <a:ext uri="{FF2B5EF4-FFF2-40B4-BE49-F238E27FC236}">
                      <a16:creationId xmlns:a16="http://schemas.microsoft.com/office/drawing/2014/main" id="{B0DFA0B5-7FCC-8DB3-01D4-4BF341F73EBC}"/>
                    </a:ext>
                  </a:extLst>
                </p:cNvPr>
                <p:cNvSpPr txBox="1"/>
                <p:nvPr/>
              </p:nvSpPr>
              <p:spPr>
                <a:xfrm rot="16200000">
                  <a:off x="5360231" y="3134848"/>
                  <a:ext cx="428537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O</a:t>
                  </a:r>
                  <a:endParaRPr lang="en-US" sz="1000" b="1" dirty="0"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5" name="TextBox 61">
                  <a:extLst>
                    <a:ext uri="{FF2B5EF4-FFF2-40B4-BE49-F238E27FC236}">
                      <a16:creationId xmlns:a16="http://schemas.microsoft.com/office/drawing/2014/main" id="{2BD14E03-03BC-D6DC-6F5B-F8998B0F4DA0}"/>
                    </a:ext>
                  </a:extLst>
                </p:cNvPr>
                <p:cNvSpPr txBox="1"/>
                <p:nvPr/>
              </p:nvSpPr>
              <p:spPr>
                <a:xfrm rot="16200000">
                  <a:off x="5341553" y="3261412"/>
                  <a:ext cx="681665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mall-PEG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6" name="TextBox 51">
                  <a:extLst>
                    <a:ext uri="{FF2B5EF4-FFF2-40B4-BE49-F238E27FC236}">
                      <a16:creationId xmlns:a16="http://schemas.microsoft.com/office/drawing/2014/main" id="{A47DA45E-EE70-2B90-A8D1-0140DAC199ED}"/>
                    </a:ext>
                  </a:extLst>
                </p:cNvPr>
                <p:cNvSpPr txBox="1"/>
                <p:nvPr/>
              </p:nvSpPr>
              <p:spPr>
                <a:xfrm rot="16200000">
                  <a:off x="5449439" y="3261413"/>
                  <a:ext cx="68166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rge-PEG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7" name="TextBox 51">
                  <a:extLst>
                    <a:ext uri="{FF2B5EF4-FFF2-40B4-BE49-F238E27FC236}">
                      <a16:creationId xmlns:a16="http://schemas.microsoft.com/office/drawing/2014/main" id="{C022B49E-AD20-7F51-7895-21A21D848A6A}"/>
                    </a:ext>
                  </a:extLst>
                </p:cNvPr>
                <p:cNvSpPr txBox="1"/>
                <p:nvPr/>
              </p:nvSpPr>
              <p:spPr>
                <a:xfrm rot="16200000">
                  <a:off x="5557325" y="3261412"/>
                  <a:ext cx="681665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VA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8" name="TextBox 51">
                  <a:extLst>
                    <a:ext uri="{FF2B5EF4-FFF2-40B4-BE49-F238E27FC236}">
                      <a16:creationId xmlns:a16="http://schemas.microsoft.com/office/drawing/2014/main" id="{B4E03A83-3E5A-20DA-006D-1FE957883D18}"/>
                    </a:ext>
                  </a:extLst>
                </p:cNvPr>
                <p:cNvSpPr txBox="1"/>
                <p:nvPr/>
              </p:nvSpPr>
              <p:spPr>
                <a:xfrm rot="16200000">
                  <a:off x="5786715" y="3139909"/>
                  <a:ext cx="43865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u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9" name="TextBox 51">
                  <a:extLst>
                    <a:ext uri="{FF2B5EF4-FFF2-40B4-BE49-F238E27FC236}">
                      <a16:creationId xmlns:a16="http://schemas.microsoft.com/office/drawing/2014/main" id="{FF0C6757-5CB9-4DBD-EDC5-D67A76313A27}"/>
                    </a:ext>
                  </a:extLst>
                </p:cNvPr>
                <p:cNvSpPr txBox="1"/>
                <p:nvPr/>
              </p:nvSpPr>
              <p:spPr>
                <a:xfrm rot="16200000">
                  <a:off x="5874724" y="3159785"/>
                  <a:ext cx="47841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SO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0" name="TextBox 51">
                  <a:extLst>
                    <a:ext uri="{FF2B5EF4-FFF2-40B4-BE49-F238E27FC236}">
                      <a16:creationId xmlns:a16="http://schemas.microsoft.com/office/drawing/2014/main" id="{97DBDD80-FABD-E93D-DB56-853A0DC807C5}"/>
                    </a:ext>
                  </a:extLst>
                </p:cNvPr>
                <p:cNvSpPr txBox="1"/>
                <p:nvPr/>
              </p:nvSpPr>
              <p:spPr>
                <a:xfrm rot="16200000">
                  <a:off x="6002487" y="3139909"/>
                  <a:ext cx="43865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etO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1" name="TextBox 51">
                  <a:extLst>
                    <a:ext uri="{FF2B5EF4-FFF2-40B4-BE49-F238E27FC236}">
                      <a16:creationId xmlns:a16="http://schemas.microsoft.com/office/drawing/2014/main" id="{3184B2A4-3FF2-C783-57F7-CE99657F7824}"/>
                    </a:ext>
                  </a:extLst>
                </p:cNvPr>
                <p:cNvSpPr txBox="1"/>
                <p:nvPr/>
              </p:nvSpPr>
              <p:spPr>
                <a:xfrm rot="16200000">
                  <a:off x="6065075" y="3185212"/>
                  <a:ext cx="529265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M</a:t>
                  </a:r>
                </a:p>
              </p:txBody>
            </p:sp>
          </p:grpSp>
          <p:grpSp>
            <p:nvGrpSpPr>
              <p:cNvPr id="1220" name="グループ化 1219">
                <a:extLst>
                  <a:ext uri="{FF2B5EF4-FFF2-40B4-BE49-F238E27FC236}">
                    <a16:creationId xmlns:a16="http://schemas.microsoft.com/office/drawing/2014/main" id="{6054001B-1191-C2B3-EF88-BEF6300AF8C5}"/>
                  </a:ext>
                </a:extLst>
              </p:cNvPr>
              <p:cNvGrpSpPr/>
              <p:nvPr/>
            </p:nvGrpSpPr>
            <p:grpSpPr>
              <a:xfrm>
                <a:off x="4468695" y="3594896"/>
                <a:ext cx="1867010" cy="681667"/>
                <a:chOff x="4539642" y="2997523"/>
                <a:chExt cx="1867010" cy="681667"/>
              </a:xfrm>
            </p:grpSpPr>
            <p:sp>
              <p:nvSpPr>
                <p:cNvPr id="1221" name="TextBox 51">
                  <a:extLst>
                    <a:ext uri="{FF2B5EF4-FFF2-40B4-BE49-F238E27FC236}">
                      <a16:creationId xmlns:a16="http://schemas.microsoft.com/office/drawing/2014/main" id="{596C9DE2-9098-44CD-FA87-981A8ED98497}"/>
                    </a:ext>
                  </a:extLst>
                </p:cNvPr>
                <p:cNvSpPr txBox="1"/>
                <p:nvPr/>
              </p:nvSpPr>
              <p:spPr>
                <a:xfrm rot="16200000">
                  <a:off x="4402317" y="3134848"/>
                  <a:ext cx="428537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S</a:t>
                  </a:r>
                  <a:endParaRPr lang="en-US" sz="1000" b="1" dirty="0"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2" name="TextBox 61">
                  <a:extLst>
                    <a:ext uri="{FF2B5EF4-FFF2-40B4-BE49-F238E27FC236}">
                      <a16:creationId xmlns:a16="http://schemas.microsoft.com/office/drawing/2014/main" id="{16B3D7BD-87BF-079E-386F-4AC5AC14359F}"/>
                    </a:ext>
                  </a:extLst>
                </p:cNvPr>
                <p:cNvSpPr txBox="1"/>
                <p:nvPr/>
              </p:nvSpPr>
              <p:spPr>
                <a:xfrm rot="16200000">
                  <a:off x="4496427" y="3146012"/>
                  <a:ext cx="445642" cy="14866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3" name="TextBox 51">
                  <a:extLst>
                    <a:ext uri="{FF2B5EF4-FFF2-40B4-BE49-F238E27FC236}">
                      <a16:creationId xmlns:a16="http://schemas.microsoft.com/office/drawing/2014/main" id="{344CAFF4-E5A8-270C-BF5C-BF708DF4EADA}"/>
                    </a:ext>
                  </a:extLst>
                </p:cNvPr>
                <p:cNvSpPr txBox="1"/>
                <p:nvPr/>
              </p:nvSpPr>
              <p:spPr>
                <a:xfrm rot="16200000">
                  <a:off x="4607641" y="3137460"/>
                  <a:ext cx="428537" cy="14866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N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4" name="TextBox 51">
                  <a:extLst>
                    <a:ext uri="{FF2B5EF4-FFF2-40B4-BE49-F238E27FC236}">
                      <a16:creationId xmlns:a16="http://schemas.microsoft.com/office/drawing/2014/main" id="{A585CCD1-F715-4C84-A653-1ECA1129885B}"/>
                    </a:ext>
                  </a:extLst>
                </p:cNvPr>
                <p:cNvSpPr txBox="1"/>
                <p:nvPr/>
              </p:nvSpPr>
              <p:spPr>
                <a:xfrm rot="16200000">
                  <a:off x="4687978" y="3159785"/>
                  <a:ext cx="47841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Y</a:t>
                  </a:r>
                </a:p>
              </p:txBody>
            </p:sp>
            <p:sp>
              <p:nvSpPr>
                <p:cNvPr id="1225" name="TextBox 51">
                  <a:extLst>
                    <a:ext uri="{FF2B5EF4-FFF2-40B4-BE49-F238E27FC236}">
                      <a16:creationId xmlns:a16="http://schemas.microsoft.com/office/drawing/2014/main" id="{A42C185E-BDC4-5315-07BB-9505DCEEC794}"/>
                    </a:ext>
                  </a:extLst>
                </p:cNvPr>
                <p:cNvSpPr txBox="1"/>
                <p:nvPr/>
              </p:nvSpPr>
              <p:spPr>
                <a:xfrm rot="16200000">
                  <a:off x="4815741" y="3139908"/>
                  <a:ext cx="43865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YH</a:t>
                  </a:r>
                </a:p>
              </p:txBody>
            </p:sp>
            <p:sp>
              <p:nvSpPr>
                <p:cNvPr id="1226" name="TextBox 51">
                  <a:extLst>
                    <a:ext uri="{FF2B5EF4-FFF2-40B4-BE49-F238E27FC236}">
                      <a16:creationId xmlns:a16="http://schemas.microsoft.com/office/drawing/2014/main" id="{F90F4069-81AE-1D42-2C88-ADD6771F7189}"/>
                    </a:ext>
                  </a:extLst>
                </p:cNvPr>
                <p:cNvSpPr txBox="1"/>
                <p:nvPr/>
              </p:nvSpPr>
              <p:spPr>
                <a:xfrm rot="16200000">
                  <a:off x="4903750" y="3159785"/>
                  <a:ext cx="47841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TA</a:t>
                  </a:r>
                </a:p>
              </p:txBody>
            </p:sp>
            <p:sp>
              <p:nvSpPr>
                <p:cNvPr id="1227" name="TextBox 51">
                  <a:extLst>
                    <a:ext uri="{FF2B5EF4-FFF2-40B4-BE49-F238E27FC236}">
                      <a16:creationId xmlns:a16="http://schemas.microsoft.com/office/drawing/2014/main" id="{E629ECD6-FB17-E528-132B-CC95DF7405C0}"/>
                    </a:ext>
                  </a:extLst>
                </p:cNvPr>
                <p:cNvSpPr txBox="1"/>
                <p:nvPr/>
              </p:nvSpPr>
              <p:spPr>
                <a:xfrm rot="16200000">
                  <a:off x="4951364" y="3220058"/>
                  <a:ext cx="59895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GDME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8" name="TextBox 51">
                  <a:extLst>
                    <a:ext uri="{FF2B5EF4-FFF2-40B4-BE49-F238E27FC236}">
                      <a16:creationId xmlns:a16="http://schemas.microsoft.com/office/drawing/2014/main" id="{F490EEDE-4A71-DCCB-6794-03EC457201F7}"/>
                    </a:ext>
                  </a:extLst>
                </p:cNvPr>
                <p:cNvSpPr txBox="1"/>
                <p:nvPr/>
              </p:nvSpPr>
              <p:spPr>
                <a:xfrm rot="16200000">
                  <a:off x="5059250" y="3220058"/>
                  <a:ext cx="59895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E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9" name="TextBox 51">
                  <a:extLst>
                    <a:ext uri="{FF2B5EF4-FFF2-40B4-BE49-F238E27FC236}">
                      <a16:creationId xmlns:a16="http://schemas.microsoft.com/office/drawing/2014/main" id="{9EFD8A17-EECD-880C-597D-3BA0E72580A3}"/>
                    </a:ext>
                  </a:extLst>
                </p:cNvPr>
                <p:cNvSpPr txBox="1"/>
                <p:nvPr/>
              </p:nvSpPr>
              <p:spPr>
                <a:xfrm rot="16200000">
                  <a:off x="5195163" y="3192030"/>
                  <a:ext cx="54290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G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0" name="TextBox 51">
                  <a:extLst>
                    <a:ext uri="{FF2B5EF4-FFF2-40B4-BE49-F238E27FC236}">
                      <a16:creationId xmlns:a16="http://schemas.microsoft.com/office/drawing/2014/main" id="{870E75DA-BF78-2541-9392-3FE7C62EC038}"/>
                    </a:ext>
                  </a:extLst>
                </p:cNvPr>
                <p:cNvSpPr txBox="1"/>
                <p:nvPr/>
              </p:nvSpPr>
              <p:spPr>
                <a:xfrm rot="16200000">
                  <a:off x="5360231" y="3134848"/>
                  <a:ext cx="428537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O</a:t>
                  </a:r>
                  <a:endParaRPr lang="en-US" sz="1000" b="1" dirty="0">
                    <a:highlight>
                      <a:srgbClr val="FFFF00"/>
                    </a:highlight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1" name="TextBox 61">
                  <a:extLst>
                    <a:ext uri="{FF2B5EF4-FFF2-40B4-BE49-F238E27FC236}">
                      <a16:creationId xmlns:a16="http://schemas.microsoft.com/office/drawing/2014/main" id="{0E2A77C5-A5C8-D71D-5A5B-B2855BF7456D}"/>
                    </a:ext>
                  </a:extLst>
                </p:cNvPr>
                <p:cNvSpPr txBox="1"/>
                <p:nvPr/>
              </p:nvSpPr>
              <p:spPr>
                <a:xfrm rot="16200000">
                  <a:off x="5341553" y="3261412"/>
                  <a:ext cx="681665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mall-PEG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2" name="TextBox 51">
                  <a:extLst>
                    <a:ext uri="{FF2B5EF4-FFF2-40B4-BE49-F238E27FC236}">
                      <a16:creationId xmlns:a16="http://schemas.microsoft.com/office/drawing/2014/main" id="{14C0FF9A-6212-EC87-46F9-AFC172F4AC91}"/>
                    </a:ext>
                  </a:extLst>
                </p:cNvPr>
                <p:cNvSpPr txBox="1"/>
                <p:nvPr/>
              </p:nvSpPr>
              <p:spPr>
                <a:xfrm rot="16200000">
                  <a:off x="5449439" y="3261413"/>
                  <a:ext cx="681666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arge-PEG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3" name="TextBox 51">
                  <a:extLst>
                    <a:ext uri="{FF2B5EF4-FFF2-40B4-BE49-F238E27FC236}">
                      <a16:creationId xmlns:a16="http://schemas.microsoft.com/office/drawing/2014/main" id="{2BB19122-CA98-F789-11A2-83F520C7D25D}"/>
                    </a:ext>
                  </a:extLst>
                </p:cNvPr>
                <p:cNvSpPr txBox="1"/>
                <p:nvPr/>
              </p:nvSpPr>
              <p:spPr>
                <a:xfrm rot="16200000">
                  <a:off x="5557325" y="3261412"/>
                  <a:ext cx="681665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VA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4" name="TextBox 51">
                  <a:extLst>
                    <a:ext uri="{FF2B5EF4-FFF2-40B4-BE49-F238E27FC236}">
                      <a16:creationId xmlns:a16="http://schemas.microsoft.com/office/drawing/2014/main" id="{751C11A3-17BC-1321-2BFF-832D29E168D9}"/>
                    </a:ext>
                  </a:extLst>
                </p:cNvPr>
                <p:cNvSpPr txBox="1"/>
                <p:nvPr/>
              </p:nvSpPr>
              <p:spPr>
                <a:xfrm rot="16200000">
                  <a:off x="5786715" y="3139909"/>
                  <a:ext cx="43865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u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5" name="TextBox 51">
                  <a:extLst>
                    <a:ext uri="{FF2B5EF4-FFF2-40B4-BE49-F238E27FC236}">
                      <a16:creationId xmlns:a16="http://schemas.microsoft.com/office/drawing/2014/main" id="{17CA6895-E458-43B1-397E-ABDCE8BA5888}"/>
                    </a:ext>
                  </a:extLst>
                </p:cNvPr>
                <p:cNvSpPr txBox="1"/>
                <p:nvPr/>
              </p:nvSpPr>
              <p:spPr>
                <a:xfrm rot="16200000">
                  <a:off x="5874724" y="3159785"/>
                  <a:ext cx="47841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SO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6" name="TextBox 51">
                  <a:extLst>
                    <a:ext uri="{FF2B5EF4-FFF2-40B4-BE49-F238E27FC236}">
                      <a16:creationId xmlns:a16="http://schemas.microsoft.com/office/drawing/2014/main" id="{E27369B1-FAC6-D1BC-B073-C60B0F7F02DC}"/>
                    </a:ext>
                  </a:extLst>
                </p:cNvPr>
                <p:cNvSpPr txBox="1"/>
                <p:nvPr/>
              </p:nvSpPr>
              <p:spPr>
                <a:xfrm rot="16200000">
                  <a:off x="6002487" y="3139909"/>
                  <a:ext cx="438658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etO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7" name="TextBox 51">
                  <a:extLst>
                    <a:ext uri="{FF2B5EF4-FFF2-40B4-BE49-F238E27FC236}">
                      <a16:creationId xmlns:a16="http://schemas.microsoft.com/office/drawing/2014/main" id="{AD5A531A-5F05-588C-A286-CF9556C8D226}"/>
                    </a:ext>
                  </a:extLst>
                </p:cNvPr>
                <p:cNvSpPr txBox="1"/>
                <p:nvPr/>
              </p:nvSpPr>
              <p:spPr>
                <a:xfrm rot="16200000">
                  <a:off x="6065075" y="3185212"/>
                  <a:ext cx="529265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M</a:t>
                  </a:r>
                </a:p>
              </p:txBody>
            </p:sp>
          </p:grpSp>
          <p:grpSp>
            <p:nvGrpSpPr>
              <p:cNvPr id="1238" name="グループ化 432">
                <a:extLst>
                  <a:ext uri="{FF2B5EF4-FFF2-40B4-BE49-F238E27FC236}">
                    <a16:creationId xmlns:a16="http://schemas.microsoft.com/office/drawing/2014/main" id="{83B2B521-6FAA-EBA7-A07F-60F808BBD8AB}"/>
                  </a:ext>
                </a:extLst>
              </p:cNvPr>
              <p:cNvGrpSpPr/>
              <p:nvPr/>
            </p:nvGrpSpPr>
            <p:grpSpPr>
              <a:xfrm>
                <a:off x="8853" y="2954812"/>
                <a:ext cx="299622" cy="658334"/>
                <a:chOff x="7095004" y="4058061"/>
                <a:chExt cx="258553" cy="741692"/>
              </a:xfrm>
            </p:grpSpPr>
            <p:sp>
              <p:nvSpPr>
                <p:cNvPr id="1239" name="TextBox 51">
                  <a:extLst>
                    <a:ext uri="{FF2B5EF4-FFF2-40B4-BE49-F238E27FC236}">
                      <a16:creationId xmlns:a16="http://schemas.microsoft.com/office/drawing/2014/main" id="{40279AEA-405E-9AFE-2556-05C2FF52691F}"/>
                    </a:ext>
                  </a:extLst>
                </p:cNvPr>
                <p:cNvSpPr txBox="1"/>
                <p:nvPr/>
              </p:nvSpPr>
              <p:spPr>
                <a:xfrm>
                  <a:off x="7159391" y="4171723"/>
                  <a:ext cx="194166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0</a:t>
                  </a:r>
                </a:p>
              </p:txBody>
            </p:sp>
            <p:sp>
              <p:nvSpPr>
                <p:cNvPr id="1240" name="TextBox 61">
                  <a:extLst>
                    <a:ext uri="{FF2B5EF4-FFF2-40B4-BE49-F238E27FC236}">
                      <a16:creationId xmlns:a16="http://schemas.microsoft.com/office/drawing/2014/main" id="{DF3E57FD-71A0-F030-88B9-723F3A866E3E}"/>
                    </a:ext>
                  </a:extLst>
                </p:cNvPr>
                <p:cNvSpPr txBox="1"/>
                <p:nvPr/>
              </p:nvSpPr>
              <p:spPr>
                <a:xfrm>
                  <a:off x="7107335" y="4285388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</a:p>
              </p:txBody>
            </p:sp>
            <p:sp>
              <p:nvSpPr>
                <p:cNvPr id="1241" name="TextBox 51">
                  <a:extLst>
                    <a:ext uri="{FF2B5EF4-FFF2-40B4-BE49-F238E27FC236}">
                      <a16:creationId xmlns:a16="http://schemas.microsoft.com/office/drawing/2014/main" id="{44BB4993-49D3-DBD9-41D7-76D3F7FB7322}"/>
                    </a:ext>
                  </a:extLst>
                </p:cNvPr>
                <p:cNvSpPr txBox="1"/>
                <p:nvPr/>
              </p:nvSpPr>
              <p:spPr>
                <a:xfrm>
                  <a:off x="7095004" y="4512717"/>
                  <a:ext cx="258553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2" name="TextBox 51">
                  <a:extLst>
                    <a:ext uri="{FF2B5EF4-FFF2-40B4-BE49-F238E27FC236}">
                      <a16:creationId xmlns:a16="http://schemas.microsoft.com/office/drawing/2014/main" id="{4C204F1E-6316-6847-09A5-F5FF1E5F3E44}"/>
                    </a:ext>
                  </a:extLst>
                </p:cNvPr>
                <p:cNvSpPr txBox="1"/>
                <p:nvPr/>
              </p:nvSpPr>
              <p:spPr>
                <a:xfrm>
                  <a:off x="7107339" y="4626380"/>
                  <a:ext cx="246218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3" name="TextBox 61">
                  <a:extLst>
                    <a:ext uri="{FF2B5EF4-FFF2-40B4-BE49-F238E27FC236}">
                      <a16:creationId xmlns:a16="http://schemas.microsoft.com/office/drawing/2014/main" id="{4149E8BB-9BD8-E0B2-2FCE-E203CA519341}"/>
                    </a:ext>
                  </a:extLst>
                </p:cNvPr>
                <p:cNvSpPr txBox="1"/>
                <p:nvPr/>
              </p:nvSpPr>
              <p:spPr>
                <a:xfrm>
                  <a:off x="7107335" y="4399053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4" name="TextBox 51">
                  <a:extLst>
                    <a:ext uri="{FF2B5EF4-FFF2-40B4-BE49-F238E27FC236}">
                      <a16:creationId xmlns:a16="http://schemas.microsoft.com/office/drawing/2014/main" id="{62268968-E0AA-641A-6782-21BD7B0AEB81}"/>
                    </a:ext>
                  </a:extLst>
                </p:cNvPr>
                <p:cNvSpPr txBox="1"/>
                <p:nvPr/>
              </p:nvSpPr>
              <p:spPr>
                <a:xfrm>
                  <a:off x="7159391" y="4058061"/>
                  <a:ext cx="194166" cy="17337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0</a:t>
                  </a:r>
                </a:p>
              </p:txBody>
            </p:sp>
          </p:grpSp>
          <p:grpSp>
            <p:nvGrpSpPr>
              <p:cNvPr id="1245" name="グループ化 432">
                <a:extLst>
                  <a:ext uri="{FF2B5EF4-FFF2-40B4-BE49-F238E27FC236}">
                    <a16:creationId xmlns:a16="http://schemas.microsoft.com/office/drawing/2014/main" id="{19EA3FCA-D6B2-2449-F2BF-64A0E5FD80ED}"/>
                  </a:ext>
                </a:extLst>
              </p:cNvPr>
              <p:cNvGrpSpPr/>
              <p:nvPr/>
            </p:nvGrpSpPr>
            <p:grpSpPr>
              <a:xfrm>
                <a:off x="4153970" y="2954812"/>
                <a:ext cx="299622" cy="658334"/>
                <a:chOff x="7095004" y="4058061"/>
                <a:chExt cx="258553" cy="741692"/>
              </a:xfrm>
            </p:grpSpPr>
            <p:sp>
              <p:nvSpPr>
                <p:cNvPr id="1246" name="TextBox 51">
                  <a:extLst>
                    <a:ext uri="{FF2B5EF4-FFF2-40B4-BE49-F238E27FC236}">
                      <a16:creationId xmlns:a16="http://schemas.microsoft.com/office/drawing/2014/main" id="{C2442E5C-F62C-35C1-44D2-3DCE0481B390}"/>
                    </a:ext>
                  </a:extLst>
                </p:cNvPr>
                <p:cNvSpPr txBox="1"/>
                <p:nvPr/>
              </p:nvSpPr>
              <p:spPr>
                <a:xfrm>
                  <a:off x="7159391" y="4171723"/>
                  <a:ext cx="194166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</a:p>
              </p:txBody>
            </p:sp>
            <p:sp>
              <p:nvSpPr>
                <p:cNvPr id="1247" name="TextBox 61">
                  <a:extLst>
                    <a:ext uri="{FF2B5EF4-FFF2-40B4-BE49-F238E27FC236}">
                      <a16:creationId xmlns:a16="http://schemas.microsoft.com/office/drawing/2014/main" id="{4F0725A6-9662-B35C-D493-BE05481D40ED}"/>
                    </a:ext>
                  </a:extLst>
                </p:cNvPr>
                <p:cNvSpPr txBox="1"/>
                <p:nvPr/>
              </p:nvSpPr>
              <p:spPr>
                <a:xfrm>
                  <a:off x="7107335" y="4285388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8" name="TextBox 51">
                  <a:extLst>
                    <a:ext uri="{FF2B5EF4-FFF2-40B4-BE49-F238E27FC236}">
                      <a16:creationId xmlns:a16="http://schemas.microsoft.com/office/drawing/2014/main" id="{3E10880A-0EB9-FA77-7527-153DAF9C1080}"/>
                    </a:ext>
                  </a:extLst>
                </p:cNvPr>
                <p:cNvSpPr txBox="1"/>
                <p:nvPr/>
              </p:nvSpPr>
              <p:spPr>
                <a:xfrm>
                  <a:off x="7095004" y="4512717"/>
                  <a:ext cx="258553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9" name="TextBox 51">
                  <a:extLst>
                    <a:ext uri="{FF2B5EF4-FFF2-40B4-BE49-F238E27FC236}">
                      <a16:creationId xmlns:a16="http://schemas.microsoft.com/office/drawing/2014/main" id="{CF3A81CE-84EF-EB06-0D5D-547FC885689F}"/>
                    </a:ext>
                  </a:extLst>
                </p:cNvPr>
                <p:cNvSpPr txBox="1"/>
                <p:nvPr/>
              </p:nvSpPr>
              <p:spPr>
                <a:xfrm>
                  <a:off x="7107339" y="4626380"/>
                  <a:ext cx="246218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0" name="TextBox 61">
                  <a:extLst>
                    <a:ext uri="{FF2B5EF4-FFF2-40B4-BE49-F238E27FC236}">
                      <a16:creationId xmlns:a16="http://schemas.microsoft.com/office/drawing/2014/main" id="{388FECF0-749E-47DB-C254-6F63A1DCFDFC}"/>
                    </a:ext>
                  </a:extLst>
                </p:cNvPr>
                <p:cNvSpPr txBox="1"/>
                <p:nvPr/>
              </p:nvSpPr>
              <p:spPr>
                <a:xfrm>
                  <a:off x="7107335" y="4399053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1" name="TextBox 51">
                  <a:extLst>
                    <a:ext uri="{FF2B5EF4-FFF2-40B4-BE49-F238E27FC236}">
                      <a16:creationId xmlns:a16="http://schemas.microsoft.com/office/drawing/2014/main" id="{FA8874BF-EB5D-EE8D-C511-A98727079A2D}"/>
                    </a:ext>
                  </a:extLst>
                </p:cNvPr>
                <p:cNvSpPr txBox="1"/>
                <p:nvPr/>
              </p:nvSpPr>
              <p:spPr>
                <a:xfrm>
                  <a:off x="7159391" y="4058061"/>
                  <a:ext cx="194166" cy="17337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5</a:t>
                  </a:r>
                </a:p>
              </p:txBody>
            </p:sp>
          </p:grpSp>
          <p:grpSp>
            <p:nvGrpSpPr>
              <p:cNvPr id="1252" name="グループ化 432">
                <a:extLst>
                  <a:ext uri="{FF2B5EF4-FFF2-40B4-BE49-F238E27FC236}">
                    <a16:creationId xmlns:a16="http://schemas.microsoft.com/office/drawing/2014/main" id="{A6470887-4642-F8FF-CC93-00E054A04C51}"/>
                  </a:ext>
                </a:extLst>
              </p:cNvPr>
              <p:cNvGrpSpPr/>
              <p:nvPr/>
            </p:nvGrpSpPr>
            <p:grpSpPr>
              <a:xfrm>
                <a:off x="2088556" y="2200052"/>
                <a:ext cx="299622" cy="658334"/>
                <a:chOff x="7095004" y="4058061"/>
                <a:chExt cx="258553" cy="741692"/>
              </a:xfrm>
            </p:grpSpPr>
            <p:sp>
              <p:nvSpPr>
                <p:cNvPr id="1253" name="TextBox 51">
                  <a:extLst>
                    <a:ext uri="{FF2B5EF4-FFF2-40B4-BE49-F238E27FC236}">
                      <a16:creationId xmlns:a16="http://schemas.microsoft.com/office/drawing/2014/main" id="{D86F456B-7E1D-8566-B650-9E2905D4A2A4}"/>
                    </a:ext>
                  </a:extLst>
                </p:cNvPr>
                <p:cNvSpPr txBox="1"/>
                <p:nvPr/>
              </p:nvSpPr>
              <p:spPr>
                <a:xfrm>
                  <a:off x="7159391" y="4171723"/>
                  <a:ext cx="194166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.0</a:t>
                  </a:r>
                </a:p>
              </p:txBody>
            </p:sp>
            <p:sp>
              <p:nvSpPr>
                <p:cNvPr id="1254" name="TextBox 61">
                  <a:extLst>
                    <a:ext uri="{FF2B5EF4-FFF2-40B4-BE49-F238E27FC236}">
                      <a16:creationId xmlns:a16="http://schemas.microsoft.com/office/drawing/2014/main" id="{DF3D9BA2-FB6E-9F57-8BB1-55049A514C4E}"/>
                    </a:ext>
                  </a:extLst>
                </p:cNvPr>
                <p:cNvSpPr txBox="1"/>
                <p:nvPr/>
              </p:nvSpPr>
              <p:spPr>
                <a:xfrm>
                  <a:off x="7107335" y="4285388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.0</a:t>
                  </a:r>
                </a:p>
              </p:txBody>
            </p:sp>
            <p:sp>
              <p:nvSpPr>
                <p:cNvPr id="1255" name="TextBox 51">
                  <a:extLst>
                    <a:ext uri="{FF2B5EF4-FFF2-40B4-BE49-F238E27FC236}">
                      <a16:creationId xmlns:a16="http://schemas.microsoft.com/office/drawing/2014/main" id="{63F40E71-C63F-E4CA-D57D-B3F3AA0BBF7E}"/>
                    </a:ext>
                  </a:extLst>
                </p:cNvPr>
                <p:cNvSpPr txBox="1"/>
                <p:nvPr/>
              </p:nvSpPr>
              <p:spPr>
                <a:xfrm>
                  <a:off x="7095004" y="4512717"/>
                  <a:ext cx="258553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6" name="TextBox 51">
                  <a:extLst>
                    <a:ext uri="{FF2B5EF4-FFF2-40B4-BE49-F238E27FC236}">
                      <a16:creationId xmlns:a16="http://schemas.microsoft.com/office/drawing/2014/main" id="{C0418615-F5D6-D319-9007-EC115540A370}"/>
                    </a:ext>
                  </a:extLst>
                </p:cNvPr>
                <p:cNvSpPr txBox="1"/>
                <p:nvPr/>
              </p:nvSpPr>
              <p:spPr>
                <a:xfrm>
                  <a:off x="7107339" y="4626380"/>
                  <a:ext cx="246218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7" name="TextBox 61">
                  <a:extLst>
                    <a:ext uri="{FF2B5EF4-FFF2-40B4-BE49-F238E27FC236}">
                      <a16:creationId xmlns:a16="http://schemas.microsoft.com/office/drawing/2014/main" id="{4BCD811C-C75E-D9B0-022E-3473B342B23D}"/>
                    </a:ext>
                  </a:extLst>
                </p:cNvPr>
                <p:cNvSpPr txBox="1"/>
                <p:nvPr/>
              </p:nvSpPr>
              <p:spPr>
                <a:xfrm>
                  <a:off x="7107335" y="4399053"/>
                  <a:ext cx="246222" cy="173373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 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8" name="TextBox 51">
                  <a:extLst>
                    <a:ext uri="{FF2B5EF4-FFF2-40B4-BE49-F238E27FC236}">
                      <a16:creationId xmlns:a16="http://schemas.microsoft.com/office/drawing/2014/main" id="{D40A8F2D-787C-6935-7077-837508CE533C}"/>
                    </a:ext>
                  </a:extLst>
                </p:cNvPr>
                <p:cNvSpPr txBox="1"/>
                <p:nvPr/>
              </p:nvSpPr>
              <p:spPr>
                <a:xfrm>
                  <a:off x="7159391" y="4058061"/>
                  <a:ext cx="194166" cy="17337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.0</a:t>
                  </a:r>
                </a:p>
              </p:txBody>
            </p:sp>
          </p:grpSp>
        </p:grpSp>
        <p:sp>
          <p:nvSpPr>
            <p:cNvPr id="1259" name="テキスト ボックス 1258">
              <a:extLst>
                <a:ext uri="{FF2B5EF4-FFF2-40B4-BE49-F238E27FC236}">
                  <a16:creationId xmlns:a16="http://schemas.microsoft.com/office/drawing/2014/main" id="{01702844-8094-3B6B-3F15-D8E301E41DB3}"/>
                </a:ext>
              </a:extLst>
            </p:cNvPr>
            <p:cNvSpPr txBox="1"/>
            <p:nvPr/>
          </p:nvSpPr>
          <p:spPr>
            <a:xfrm rot="16200000">
              <a:off x="-625367" y="2250915"/>
              <a:ext cx="14056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itchFamily="34" charset="0"/>
                  <a:cs typeface="Arial" pitchFamily="34" charset="0"/>
                </a:rPr>
                <a:t>Fold index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5FC4AA4D-6C75-5D65-45E6-A9B233E2C062}"/>
              </a:ext>
            </a:extLst>
          </p:cNvPr>
          <p:cNvGrpSpPr/>
          <p:nvPr/>
        </p:nvGrpSpPr>
        <p:grpSpPr>
          <a:xfrm>
            <a:off x="352944" y="551600"/>
            <a:ext cx="1905389" cy="546400"/>
            <a:chOff x="352944" y="570648"/>
            <a:chExt cx="1905389" cy="546400"/>
          </a:xfrm>
        </p:grpSpPr>
        <p:sp>
          <p:nvSpPr>
            <p:cNvPr id="295" name="TextBox 51">
              <a:extLst>
                <a:ext uri="{FF2B5EF4-FFF2-40B4-BE49-F238E27FC236}">
                  <a16:creationId xmlns:a16="http://schemas.microsoft.com/office/drawing/2014/main" id="{C30DD6F5-470D-4F44-8485-5318997D34EF}"/>
                </a:ext>
              </a:extLst>
            </p:cNvPr>
            <p:cNvSpPr txBox="1"/>
            <p:nvPr/>
          </p:nvSpPr>
          <p:spPr>
            <a:xfrm>
              <a:off x="565205" y="70468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00" name="TextBox 51">
              <a:extLst>
                <a:ext uri="{FF2B5EF4-FFF2-40B4-BE49-F238E27FC236}">
                  <a16:creationId xmlns:a16="http://schemas.microsoft.com/office/drawing/2014/main" id="{8E012169-C2CB-2691-0FAD-6B3BBC8BD360}"/>
                </a:ext>
              </a:extLst>
            </p:cNvPr>
            <p:cNvSpPr txBox="1"/>
            <p:nvPr/>
          </p:nvSpPr>
          <p:spPr>
            <a:xfrm>
              <a:off x="884274" y="78548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01" name="TextBox 51">
              <a:extLst>
                <a:ext uri="{FF2B5EF4-FFF2-40B4-BE49-F238E27FC236}">
                  <a16:creationId xmlns:a16="http://schemas.microsoft.com/office/drawing/2014/main" id="{A361AA6C-4001-C501-305F-D522FF3F8DDD}"/>
                </a:ext>
              </a:extLst>
            </p:cNvPr>
            <p:cNvSpPr txBox="1"/>
            <p:nvPr/>
          </p:nvSpPr>
          <p:spPr>
            <a:xfrm>
              <a:off x="778176" y="57064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03" name="TextBox 51">
              <a:extLst>
                <a:ext uri="{FF2B5EF4-FFF2-40B4-BE49-F238E27FC236}">
                  <a16:creationId xmlns:a16="http://schemas.microsoft.com/office/drawing/2014/main" id="{8957D15B-4843-B3E8-BE8E-1A74147EDB44}"/>
                </a:ext>
              </a:extLst>
            </p:cNvPr>
            <p:cNvSpPr txBox="1"/>
            <p:nvPr/>
          </p:nvSpPr>
          <p:spPr>
            <a:xfrm>
              <a:off x="352944" y="82234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04" name="TextBox 51">
              <a:extLst>
                <a:ext uri="{FF2B5EF4-FFF2-40B4-BE49-F238E27FC236}">
                  <a16:creationId xmlns:a16="http://schemas.microsoft.com/office/drawing/2014/main" id="{DE78EEED-E44C-1C25-C63C-DFF0AC28BB63}"/>
                </a:ext>
              </a:extLst>
            </p:cNvPr>
            <p:cNvSpPr txBox="1"/>
            <p:nvPr/>
          </p:nvSpPr>
          <p:spPr>
            <a:xfrm>
              <a:off x="993336" y="83017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05" name="TextBox 51">
              <a:extLst>
                <a:ext uri="{FF2B5EF4-FFF2-40B4-BE49-F238E27FC236}">
                  <a16:creationId xmlns:a16="http://schemas.microsoft.com/office/drawing/2014/main" id="{BA2F238D-A16E-CA93-F54B-87800E47C58D}"/>
                </a:ext>
              </a:extLst>
            </p:cNvPr>
            <p:cNvSpPr txBox="1"/>
            <p:nvPr/>
          </p:nvSpPr>
          <p:spPr>
            <a:xfrm>
              <a:off x="1100208" y="71741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06" name="TextBox 51">
              <a:extLst>
                <a:ext uri="{FF2B5EF4-FFF2-40B4-BE49-F238E27FC236}">
                  <a16:creationId xmlns:a16="http://schemas.microsoft.com/office/drawing/2014/main" id="{C10E8359-CF5C-A419-973D-7764D8EAA9AC}"/>
                </a:ext>
              </a:extLst>
            </p:cNvPr>
            <p:cNvSpPr txBox="1"/>
            <p:nvPr/>
          </p:nvSpPr>
          <p:spPr>
            <a:xfrm>
              <a:off x="1206950" y="59337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07" name="TextBox 51">
              <a:extLst>
                <a:ext uri="{FF2B5EF4-FFF2-40B4-BE49-F238E27FC236}">
                  <a16:creationId xmlns:a16="http://schemas.microsoft.com/office/drawing/2014/main" id="{EDACC3A5-2A5A-59B2-A4FC-5EAFCEADFA54}"/>
                </a:ext>
              </a:extLst>
            </p:cNvPr>
            <p:cNvSpPr txBox="1"/>
            <p:nvPr/>
          </p:nvSpPr>
          <p:spPr>
            <a:xfrm>
              <a:off x="1421293" y="83505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08" name="TextBox 51">
              <a:extLst>
                <a:ext uri="{FF2B5EF4-FFF2-40B4-BE49-F238E27FC236}">
                  <a16:creationId xmlns:a16="http://schemas.microsoft.com/office/drawing/2014/main" id="{748BA514-15AD-AFD5-A75E-083ABA56EC45}"/>
                </a:ext>
              </a:extLst>
            </p:cNvPr>
            <p:cNvSpPr txBox="1"/>
            <p:nvPr/>
          </p:nvSpPr>
          <p:spPr>
            <a:xfrm>
              <a:off x="1637630" y="89104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09" name="TextBox 51">
              <a:extLst>
                <a:ext uri="{FF2B5EF4-FFF2-40B4-BE49-F238E27FC236}">
                  <a16:creationId xmlns:a16="http://schemas.microsoft.com/office/drawing/2014/main" id="{6F3BA0B8-F803-3695-E7EF-FBA78EAD1EF4}"/>
                </a:ext>
              </a:extLst>
            </p:cNvPr>
            <p:cNvSpPr txBox="1"/>
            <p:nvPr/>
          </p:nvSpPr>
          <p:spPr>
            <a:xfrm>
              <a:off x="1531019" y="85637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10" name="TextBox 51">
              <a:extLst>
                <a:ext uri="{FF2B5EF4-FFF2-40B4-BE49-F238E27FC236}">
                  <a16:creationId xmlns:a16="http://schemas.microsoft.com/office/drawing/2014/main" id="{3E9F1BA3-6DCE-F2A9-F1C1-4B9D2797164D}"/>
                </a:ext>
              </a:extLst>
            </p:cNvPr>
            <p:cNvSpPr txBox="1"/>
            <p:nvPr/>
          </p:nvSpPr>
          <p:spPr>
            <a:xfrm>
              <a:off x="1313411" y="74683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11" name="TextBox 51">
              <a:extLst>
                <a:ext uri="{FF2B5EF4-FFF2-40B4-BE49-F238E27FC236}">
                  <a16:creationId xmlns:a16="http://schemas.microsoft.com/office/drawing/2014/main" id="{F952F4CF-ACF8-D4CE-B42C-AC2C4B04532D}"/>
                </a:ext>
              </a:extLst>
            </p:cNvPr>
            <p:cNvSpPr txBox="1"/>
            <p:nvPr/>
          </p:nvSpPr>
          <p:spPr>
            <a:xfrm>
              <a:off x="1743542" y="99393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19" name="TextBox 51">
              <a:extLst>
                <a:ext uri="{FF2B5EF4-FFF2-40B4-BE49-F238E27FC236}">
                  <a16:creationId xmlns:a16="http://schemas.microsoft.com/office/drawing/2014/main" id="{AD3E1656-227A-26CC-40FD-11F4A6C3E606}"/>
                </a:ext>
              </a:extLst>
            </p:cNvPr>
            <p:cNvSpPr txBox="1"/>
            <p:nvPr/>
          </p:nvSpPr>
          <p:spPr>
            <a:xfrm>
              <a:off x="1850710" y="83619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20" name="TextBox 51">
              <a:extLst>
                <a:ext uri="{FF2B5EF4-FFF2-40B4-BE49-F238E27FC236}">
                  <a16:creationId xmlns:a16="http://schemas.microsoft.com/office/drawing/2014/main" id="{3CAF8C3B-779E-339D-463F-647ACEB5E5A9}"/>
                </a:ext>
              </a:extLst>
            </p:cNvPr>
            <p:cNvSpPr txBox="1"/>
            <p:nvPr/>
          </p:nvSpPr>
          <p:spPr>
            <a:xfrm>
              <a:off x="1960094" y="94776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21" name="TextBox 51">
              <a:extLst>
                <a:ext uri="{FF2B5EF4-FFF2-40B4-BE49-F238E27FC236}">
                  <a16:creationId xmlns:a16="http://schemas.microsoft.com/office/drawing/2014/main" id="{7AD810AC-7C28-A6F1-E7DB-B7F3A3221DA1}"/>
                </a:ext>
              </a:extLst>
            </p:cNvPr>
            <p:cNvSpPr txBox="1"/>
            <p:nvPr/>
          </p:nvSpPr>
          <p:spPr>
            <a:xfrm>
              <a:off x="2064167" y="82303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322" name="Group 321">
            <a:extLst>
              <a:ext uri="{FF2B5EF4-FFF2-40B4-BE49-F238E27FC236}">
                <a16:creationId xmlns:a16="http://schemas.microsoft.com/office/drawing/2014/main" id="{2F553D25-B935-676E-AC9B-D2ADD2E36797}"/>
              </a:ext>
            </a:extLst>
          </p:cNvPr>
          <p:cNvGrpSpPr/>
          <p:nvPr/>
        </p:nvGrpSpPr>
        <p:grpSpPr>
          <a:xfrm>
            <a:off x="352944" y="1515271"/>
            <a:ext cx="1905389" cy="348297"/>
            <a:chOff x="352944" y="609839"/>
            <a:chExt cx="1905389" cy="348297"/>
          </a:xfrm>
        </p:grpSpPr>
        <p:sp>
          <p:nvSpPr>
            <p:cNvPr id="323" name="TextBox 51">
              <a:extLst>
                <a:ext uri="{FF2B5EF4-FFF2-40B4-BE49-F238E27FC236}">
                  <a16:creationId xmlns:a16="http://schemas.microsoft.com/office/drawing/2014/main" id="{D51E4F09-4E27-FB7B-D715-EAAEC2440FEA}"/>
                </a:ext>
              </a:extLst>
            </p:cNvPr>
            <p:cNvSpPr txBox="1"/>
            <p:nvPr/>
          </p:nvSpPr>
          <p:spPr>
            <a:xfrm>
              <a:off x="565205" y="81121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24" name="TextBox 51">
              <a:extLst>
                <a:ext uri="{FF2B5EF4-FFF2-40B4-BE49-F238E27FC236}">
                  <a16:creationId xmlns:a16="http://schemas.microsoft.com/office/drawing/2014/main" id="{9053822A-DC79-B11F-F26C-B94227B325F5}"/>
                </a:ext>
              </a:extLst>
            </p:cNvPr>
            <p:cNvSpPr txBox="1"/>
            <p:nvPr/>
          </p:nvSpPr>
          <p:spPr>
            <a:xfrm>
              <a:off x="884274" y="81835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25" name="TextBox 51">
              <a:extLst>
                <a:ext uri="{FF2B5EF4-FFF2-40B4-BE49-F238E27FC236}">
                  <a16:creationId xmlns:a16="http://schemas.microsoft.com/office/drawing/2014/main" id="{977BFAA3-ABE8-4D94-BC42-23EBCF11E176}"/>
                </a:ext>
              </a:extLst>
            </p:cNvPr>
            <p:cNvSpPr txBox="1"/>
            <p:nvPr/>
          </p:nvSpPr>
          <p:spPr>
            <a:xfrm>
              <a:off x="778176" y="65579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26" name="TextBox 51">
              <a:extLst>
                <a:ext uri="{FF2B5EF4-FFF2-40B4-BE49-F238E27FC236}">
                  <a16:creationId xmlns:a16="http://schemas.microsoft.com/office/drawing/2014/main" id="{37F19B38-C496-A87D-942D-0E60B6A2234C}"/>
                </a:ext>
              </a:extLst>
            </p:cNvPr>
            <p:cNvSpPr txBox="1"/>
            <p:nvPr/>
          </p:nvSpPr>
          <p:spPr>
            <a:xfrm>
              <a:off x="352944" y="82949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27" name="TextBox 51">
              <a:extLst>
                <a:ext uri="{FF2B5EF4-FFF2-40B4-BE49-F238E27FC236}">
                  <a16:creationId xmlns:a16="http://schemas.microsoft.com/office/drawing/2014/main" id="{780C3608-521B-99A3-5827-B66DC3DF5D56}"/>
                </a:ext>
              </a:extLst>
            </p:cNvPr>
            <p:cNvSpPr txBox="1"/>
            <p:nvPr/>
          </p:nvSpPr>
          <p:spPr>
            <a:xfrm>
              <a:off x="993336" y="82788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28" name="TextBox 51">
              <a:extLst>
                <a:ext uri="{FF2B5EF4-FFF2-40B4-BE49-F238E27FC236}">
                  <a16:creationId xmlns:a16="http://schemas.microsoft.com/office/drawing/2014/main" id="{73DBC551-774F-0801-6F7A-FE3DCC9A8370}"/>
                </a:ext>
              </a:extLst>
            </p:cNvPr>
            <p:cNvSpPr txBox="1"/>
            <p:nvPr/>
          </p:nvSpPr>
          <p:spPr>
            <a:xfrm>
              <a:off x="1100208" y="82550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29" name="TextBox 51">
              <a:extLst>
                <a:ext uri="{FF2B5EF4-FFF2-40B4-BE49-F238E27FC236}">
                  <a16:creationId xmlns:a16="http://schemas.microsoft.com/office/drawing/2014/main" id="{823150E1-C08C-1D6E-FDFF-FE901EA370C5}"/>
                </a:ext>
              </a:extLst>
            </p:cNvPr>
            <p:cNvSpPr txBox="1"/>
            <p:nvPr/>
          </p:nvSpPr>
          <p:spPr>
            <a:xfrm>
              <a:off x="1209331" y="71461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30" name="TextBox 51">
              <a:extLst>
                <a:ext uri="{FF2B5EF4-FFF2-40B4-BE49-F238E27FC236}">
                  <a16:creationId xmlns:a16="http://schemas.microsoft.com/office/drawing/2014/main" id="{36633353-1385-63A8-E0FA-FFC296DDADD4}"/>
                </a:ext>
              </a:extLst>
            </p:cNvPr>
            <p:cNvSpPr txBox="1"/>
            <p:nvPr/>
          </p:nvSpPr>
          <p:spPr>
            <a:xfrm>
              <a:off x="1421293" y="82073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31" name="TextBox 51">
              <a:extLst>
                <a:ext uri="{FF2B5EF4-FFF2-40B4-BE49-F238E27FC236}">
                  <a16:creationId xmlns:a16="http://schemas.microsoft.com/office/drawing/2014/main" id="{0728F161-6FF4-69CA-B2FD-E547F9DB4DE8}"/>
                </a:ext>
              </a:extLst>
            </p:cNvPr>
            <p:cNvSpPr txBox="1"/>
            <p:nvPr/>
          </p:nvSpPr>
          <p:spPr>
            <a:xfrm>
              <a:off x="1637630" y="83264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32" name="TextBox 51">
              <a:extLst>
                <a:ext uri="{FF2B5EF4-FFF2-40B4-BE49-F238E27FC236}">
                  <a16:creationId xmlns:a16="http://schemas.microsoft.com/office/drawing/2014/main" id="{12F924AF-8755-2C7B-C17F-7B9DEDB0C427}"/>
                </a:ext>
              </a:extLst>
            </p:cNvPr>
            <p:cNvSpPr txBox="1"/>
            <p:nvPr/>
          </p:nvSpPr>
          <p:spPr>
            <a:xfrm>
              <a:off x="1531019" y="81597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33" name="TextBox 51">
              <a:extLst>
                <a:ext uri="{FF2B5EF4-FFF2-40B4-BE49-F238E27FC236}">
                  <a16:creationId xmlns:a16="http://schemas.microsoft.com/office/drawing/2014/main" id="{7FFC0932-D7AD-2CC1-CC78-1476174DADCA}"/>
                </a:ext>
              </a:extLst>
            </p:cNvPr>
            <p:cNvSpPr txBox="1"/>
            <p:nvPr/>
          </p:nvSpPr>
          <p:spPr>
            <a:xfrm>
              <a:off x="1313411" y="73969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34" name="TextBox 51">
              <a:extLst>
                <a:ext uri="{FF2B5EF4-FFF2-40B4-BE49-F238E27FC236}">
                  <a16:creationId xmlns:a16="http://schemas.microsoft.com/office/drawing/2014/main" id="{A3D59E47-04CE-CF14-BB92-49B4E091007A}"/>
                </a:ext>
              </a:extLst>
            </p:cNvPr>
            <p:cNvSpPr txBox="1"/>
            <p:nvPr/>
          </p:nvSpPr>
          <p:spPr>
            <a:xfrm>
              <a:off x="1743542" y="83502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35" name="TextBox 51">
              <a:extLst>
                <a:ext uri="{FF2B5EF4-FFF2-40B4-BE49-F238E27FC236}">
                  <a16:creationId xmlns:a16="http://schemas.microsoft.com/office/drawing/2014/main" id="{C3D2E634-D4AF-1183-78D2-7257759650F6}"/>
                </a:ext>
              </a:extLst>
            </p:cNvPr>
            <p:cNvSpPr txBox="1"/>
            <p:nvPr/>
          </p:nvSpPr>
          <p:spPr>
            <a:xfrm>
              <a:off x="1850710" y="81121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36" name="TextBox 51">
              <a:extLst>
                <a:ext uri="{FF2B5EF4-FFF2-40B4-BE49-F238E27FC236}">
                  <a16:creationId xmlns:a16="http://schemas.microsoft.com/office/drawing/2014/main" id="{4435D587-18C0-14D7-04F7-98562F75272C}"/>
                </a:ext>
              </a:extLst>
            </p:cNvPr>
            <p:cNvSpPr txBox="1"/>
            <p:nvPr/>
          </p:nvSpPr>
          <p:spPr>
            <a:xfrm>
              <a:off x="1960094" y="77890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37" name="TextBox 51">
              <a:extLst>
                <a:ext uri="{FF2B5EF4-FFF2-40B4-BE49-F238E27FC236}">
                  <a16:creationId xmlns:a16="http://schemas.microsoft.com/office/drawing/2014/main" id="{5FE2B019-7209-3E41-C882-4871E051C639}"/>
                </a:ext>
              </a:extLst>
            </p:cNvPr>
            <p:cNvSpPr txBox="1"/>
            <p:nvPr/>
          </p:nvSpPr>
          <p:spPr>
            <a:xfrm>
              <a:off x="2064167" y="60983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B7A70AAC-E696-CAA4-1A09-47304C85E277}"/>
              </a:ext>
            </a:extLst>
          </p:cNvPr>
          <p:cNvGrpSpPr/>
          <p:nvPr/>
        </p:nvGrpSpPr>
        <p:grpSpPr>
          <a:xfrm>
            <a:off x="352944" y="2351090"/>
            <a:ext cx="1905389" cy="263549"/>
            <a:chOff x="352944" y="2370138"/>
            <a:chExt cx="1905389" cy="263549"/>
          </a:xfrm>
        </p:grpSpPr>
        <p:sp>
          <p:nvSpPr>
            <p:cNvPr id="340" name="TextBox 51">
              <a:extLst>
                <a:ext uri="{FF2B5EF4-FFF2-40B4-BE49-F238E27FC236}">
                  <a16:creationId xmlns:a16="http://schemas.microsoft.com/office/drawing/2014/main" id="{0F95A985-C2A9-2FC1-3B12-0D996FA39F23}"/>
                </a:ext>
              </a:extLst>
            </p:cNvPr>
            <p:cNvSpPr txBox="1"/>
            <p:nvPr/>
          </p:nvSpPr>
          <p:spPr>
            <a:xfrm>
              <a:off x="565205" y="249229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41" name="TextBox 51">
              <a:extLst>
                <a:ext uri="{FF2B5EF4-FFF2-40B4-BE49-F238E27FC236}">
                  <a16:creationId xmlns:a16="http://schemas.microsoft.com/office/drawing/2014/main" id="{BE750928-7EDA-1165-2977-39A3C396C9F3}"/>
                </a:ext>
              </a:extLst>
            </p:cNvPr>
            <p:cNvSpPr txBox="1"/>
            <p:nvPr/>
          </p:nvSpPr>
          <p:spPr>
            <a:xfrm>
              <a:off x="884274" y="250896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42" name="TextBox 51">
              <a:extLst>
                <a:ext uri="{FF2B5EF4-FFF2-40B4-BE49-F238E27FC236}">
                  <a16:creationId xmlns:a16="http://schemas.microsoft.com/office/drawing/2014/main" id="{91ACA216-1208-D30D-4C04-4D4B9D0EEBC5}"/>
                </a:ext>
              </a:extLst>
            </p:cNvPr>
            <p:cNvSpPr txBox="1"/>
            <p:nvPr/>
          </p:nvSpPr>
          <p:spPr>
            <a:xfrm>
              <a:off x="778176" y="250181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43" name="TextBox 51">
              <a:extLst>
                <a:ext uri="{FF2B5EF4-FFF2-40B4-BE49-F238E27FC236}">
                  <a16:creationId xmlns:a16="http://schemas.microsoft.com/office/drawing/2014/main" id="{851635E8-014A-AB02-DE32-C6CF9C605211}"/>
                </a:ext>
              </a:extLst>
            </p:cNvPr>
            <p:cNvSpPr txBox="1"/>
            <p:nvPr/>
          </p:nvSpPr>
          <p:spPr>
            <a:xfrm>
              <a:off x="352944" y="251057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44" name="TextBox 51">
              <a:extLst>
                <a:ext uri="{FF2B5EF4-FFF2-40B4-BE49-F238E27FC236}">
                  <a16:creationId xmlns:a16="http://schemas.microsoft.com/office/drawing/2014/main" id="{75BA7A98-39EB-2D12-9E7C-2010405A06D9}"/>
                </a:ext>
              </a:extLst>
            </p:cNvPr>
            <p:cNvSpPr txBox="1"/>
            <p:nvPr/>
          </p:nvSpPr>
          <p:spPr>
            <a:xfrm>
              <a:off x="993336" y="250658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45" name="TextBox 51">
              <a:extLst>
                <a:ext uri="{FF2B5EF4-FFF2-40B4-BE49-F238E27FC236}">
                  <a16:creationId xmlns:a16="http://schemas.microsoft.com/office/drawing/2014/main" id="{0DDDD21D-ACB9-C25D-2A28-C8A441B825A9}"/>
                </a:ext>
              </a:extLst>
            </p:cNvPr>
            <p:cNvSpPr txBox="1"/>
            <p:nvPr/>
          </p:nvSpPr>
          <p:spPr>
            <a:xfrm>
              <a:off x="1100208" y="250420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46" name="TextBox 51">
              <a:extLst>
                <a:ext uri="{FF2B5EF4-FFF2-40B4-BE49-F238E27FC236}">
                  <a16:creationId xmlns:a16="http://schemas.microsoft.com/office/drawing/2014/main" id="{9390764C-CAA7-6065-9CAE-B9229EA04562}"/>
                </a:ext>
              </a:extLst>
            </p:cNvPr>
            <p:cNvSpPr txBox="1"/>
            <p:nvPr/>
          </p:nvSpPr>
          <p:spPr>
            <a:xfrm>
              <a:off x="1209331" y="247800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47" name="TextBox 51">
              <a:extLst>
                <a:ext uri="{FF2B5EF4-FFF2-40B4-BE49-F238E27FC236}">
                  <a16:creationId xmlns:a16="http://schemas.microsoft.com/office/drawing/2014/main" id="{9E53770B-B9A4-F217-75CA-B07D9361C61D}"/>
                </a:ext>
              </a:extLst>
            </p:cNvPr>
            <p:cNvSpPr txBox="1"/>
            <p:nvPr/>
          </p:nvSpPr>
          <p:spPr>
            <a:xfrm>
              <a:off x="1421293" y="249706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48" name="TextBox 51">
              <a:extLst>
                <a:ext uri="{FF2B5EF4-FFF2-40B4-BE49-F238E27FC236}">
                  <a16:creationId xmlns:a16="http://schemas.microsoft.com/office/drawing/2014/main" id="{752CDED4-19FF-1ED9-57B3-49CE847D93A9}"/>
                </a:ext>
              </a:extLst>
            </p:cNvPr>
            <p:cNvSpPr txBox="1"/>
            <p:nvPr/>
          </p:nvSpPr>
          <p:spPr>
            <a:xfrm>
              <a:off x="1637630" y="250420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50" name="TextBox 51">
              <a:extLst>
                <a:ext uri="{FF2B5EF4-FFF2-40B4-BE49-F238E27FC236}">
                  <a16:creationId xmlns:a16="http://schemas.microsoft.com/office/drawing/2014/main" id="{A21C8D6B-54DD-E530-F9E9-1404E7F52328}"/>
                </a:ext>
              </a:extLst>
            </p:cNvPr>
            <p:cNvSpPr txBox="1"/>
            <p:nvPr/>
          </p:nvSpPr>
          <p:spPr>
            <a:xfrm>
              <a:off x="1531019" y="248205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51" name="TextBox 51">
              <a:extLst>
                <a:ext uri="{FF2B5EF4-FFF2-40B4-BE49-F238E27FC236}">
                  <a16:creationId xmlns:a16="http://schemas.microsoft.com/office/drawing/2014/main" id="{1633A6AA-E336-6D5B-2459-8D2489DA15BD}"/>
                </a:ext>
              </a:extLst>
            </p:cNvPr>
            <p:cNvSpPr txBox="1"/>
            <p:nvPr/>
          </p:nvSpPr>
          <p:spPr>
            <a:xfrm>
              <a:off x="1313411" y="247800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52" name="TextBox 51">
              <a:extLst>
                <a:ext uri="{FF2B5EF4-FFF2-40B4-BE49-F238E27FC236}">
                  <a16:creationId xmlns:a16="http://schemas.microsoft.com/office/drawing/2014/main" id="{C6ABD4DF-9877-3238-BD48-FD6430265F4D}"/>
                </a:ext>
              </a:extLst>
            </p:cNvPr>
            <p:cNvSpPr txBox="1"/>
            <p:nvPr/>
          </p:nvSpPr>
          <p:spPr>
            <a:xfrm>
              <a:off x="1745923" y="248205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53" name="TextBox 51">
              <a:extLst>
                <a:ext uri="{FF2B5EF4-FFF2-40B4-BE49-F238E27FC236}">
                  <a16:creationId xmlns:a16="http://schemas.microsoft.com/office/drawing/2014/main" id="{5AA3BB15-4495-4DCD-6CFD-13905C39CA6B}"/>
                </a:ext>
              </a:extLst>
            </p:cNvPr>
            <p:cNvSpPr txBox="1"/>
            <p:nvPr/>
          </p:nvSpPr>
          <p:spPr>
            <a:xfrm>
              <a:off x="1850710" y="237013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54" name="TextBox 51">
              <a:extLst>
                <a:ext uri="{FF2B5EF4-FFF2-40B4-BE49-F238E27FC236}">
                  <a16:creationId xmlns:a16="http://schemas.microsoft.com/office/drawing/2014/main" id="{E4548AB9-06D6-3861-F007-A1859B19E7C1}"/>
                </a:ext>
              </a:extLst>
            </p:cNvPr>
            <p:cNvSpPr txBox="1"/>
            <p:nvPr/>
          </p:nvSpPr>
          <p:spPr>
            <a:xfrm>
              <a:off x="1960094" y="250419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55" name="TextBox 51">
              <a:extLst>
                <a:ext uri="{FF2B5EF4-FFF2-40B4-BE49-F238E27FC236}">
                  <a16:creationId xmlns:a16="http://schemas.microsoft.com/office/drawing/2014/main" id="{C500E886-3F9A-E75B-F9D6-E3A8806A00CC}"/>
                </a:ext>
              </a:extLst>
            </p:cNvPr>
            <p:cNvSpPr txBox="1"/>
            <p:nvPr/>
          </p:nvSpPr>
          <p:spPr>
            <a:xfrm>
              <a:off x="2064167" y="239942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56" name="TextBox 51">
              <a:extLst>
                <a:ext uri="{FF2B5EF4-FFF2-40B4-BE49-F238E27FC236}">
                  <a16:creationId xmlns:a16="http://schemas.microsoft.com/office/drawing/2014/main" id="{A2EE6180-F447-283D-29AC-25E692062B9D}"/>
                </a:ext>
              </a:extLst>
            </p:cNvPr>
            <p:cNvSpPr txBox="1"/>
            <p:nvPr/>
          </p:nvSpPr>
          <p:spPr>
            <a:xfrm>
              <a:off x="673743" y="248461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359" name="Group 358">
            <a:extLst>
              <a:ext uri="{FF2B5EF4-FFF2-40B4-BE49-F238E27FC236}">
                <a16:creationId xmlns:a16="http://schemas.microsoft.com/office/drawing/2014/main" id="{EF7ECE61-8BD3-3F29-D893-6DB02A9318BF}"/>
              </a:ext>
            </a:extLst>
          </p:cNvPr>
          <p:cNvGrpSpPr/>
          <p:nvPr/>
        </p:nvGrpSpPr>
        <p:grpSpPr>
          <a:xfrm>
            <a:off x="352944" y="2857311"/>
            <a:ext cx="1905389" cy="510570"/>
            <a:chOff x="352944" y="2475627"/>
            <a:chExt cx="1905389" cy="510570"/>
          </a:xfrm>
        </p:grpSpPr>
        <p:sp>
          <p:nvSpPr>
            <p:cNvPr id="360" name="TextBox 51">
              <a:extLst>
                <a:ext uri="{FF2B5EF4-FFF2-40B4-BE49-F238E27FC236}">
                  <a16:creationId xmlns:a16="http://schemas.microsoft.com/office/drawing/2014/main" id="{4C96BD1F-41C1-B60E-CDE0-FE9A69209B66}"/>
                </a:ext>
              </a:extLst>
            </p:cNvPr>
            <p:cNvSpPr txBox="1"/>
            <p:nvPr/>
          </p:nvSpPr>
          <p:spPr>
            <a:xfrm>
              <a:off x="565205" y="282022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61" name="TextBox 51">
              <a:extLst>
                <a:ext uri="{FF2B5EF4-FFF2-40B4-BE49-F238E27FC236}">
                  <a16:creationId xmlns:a16="http://schemas.microsoft.com/office/drawing/2014/main" id="{CD287571-A8C5-B543-C904-4C49D04B7350}"/>
                </a:ext>
              </a:extLst>
            </p:cNvPr>
            <p:cNvSpPr txBox="1"/>
            <p:nvPr/>
          </p:nvSpPr>
          <p:spPr>
            <a:xfrm>
              <a:off x="889036" y="256781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63" name="TextBox 51">
              <a:extLst>
                <a:ext uri="{FF2B5EF4-FFF2-40B4-BE49-F238E27FC236}">
                  <a16:creationId xmlns:a16="http://schemas.microsoft.com/office/drawing/2014/main" id="{6951E46A-CC97-C90A-A134-C1270DEEA99A}"/>
                </a:ext>
              </a:extLst>
            </p:cNvPr>
            <p:cNvSpPr txBox="1"/>
            <p:nvPr/>
          </p:nvSpPr>
          <p:spPr>
            <a:xfrm>
              <a:off x="352944" y="284880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64" name="TextBox 51">
              <a:extLst>
                <a:ext uri="{FF2B5EF4-FFF2-40B4-BE49-F238E27FC236}">
                  <a16:creationId xmlns:a16="http://schemas.microsoft.com/office/drawing/2014/main" id="{E181D9B1-8D05-2C1F-55E6-9EE427B37224}"/>
                </a:ext>
              </a:extLst>
            </p:cNvPr>
            <p:cNvSpPr txBox="1"/>
            <p:nvPr/>
          </p:nvSpPr>
          <p:spPr>
            <a:xfrm>
              <a:off x="995717" y="279164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65" name="TextBox 51">
              <a:extLst>
                <a:ext uri="{FF2B5EF4-FFF2-40B4-BE49-F238E27FC236}">
                  <a16:creationId xmlns:a16="http://schemas.microsoft.com/office/drawing/2014/main" id="{337A6E43-2BFB-D98A-D43A-DE0AD08683CC}"/>
                </a:ext>
              </a:extLst>
            </p:cNvPr>
            <p:cNvSpPr txBox="1"/>
            <p:nvPr/>
          </p:nvSpPr>
          <p:spPr>
            <a:xfrm>
              <a:off x="1100208" y="283927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66" name="TextBox 51">
              <a:extLst>
                <a:ext uri="{FF2B5EF4-FFF2-40B4-BE49-F238E27FC236}">
                  <a16:creationId xmlns:a16="http://schemas.microsoft.com/office/drawing/2014/main" id="{4F08D76C-FD31-242F-F5F1-6143216FD560}"/>
                </a:ext>
              </a:extLst>
            </p:cNvPr>
            <p:cNvSpPr txBox="1"/>
            <p:nvPr/>
          </p:nvSpPr>
          <p:spPr>
            <a:xfrm>
              <a:off x="1209331" y="270115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67" name="TextBox 51">
              <a:extLst>
                <a:ext uri="{FF2B5EF4-FFF2-40B4-BE49-F238E27FC236}">
                  <a16:creationId xmlns:a16="http://schemas.microsoft.com/office/drawing/2014/main" id="{672E8DBA-D3D4-A66E-EFFD-BD4D0C02A133}"/>
                </a:ext>
              </a:extLst>
            </p:cNvPr>
            <p:cNvSpPr txBox="1"/>
            <p:nvPr/>
          </p:nvSpPr>
          <p:spPr>
            <a:xfrm>
              <a:off x="1423674" y="281069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68" name="TextBox 51">
              <a:extLst>
                <a:ext uri="{FF2B5EF4-FFF2-40B4-BE49-F238E27FC236}">
                  <a16:creationId xmlns:a16="http://schemas.microsoft.com/office/drawing/2014/main" id="{6305CF25-D352-B1AB-0740-4E6EDCD624A2}"/>
                </a:ext>
              </a:extLst>
            </p:cNvPr>
            <p:cNvSpPr txBox="1"/>
            <p:nvPr/>
          </p:nvSpPr>
          <p:spPr>
            <a:xfrm>
              <a:off x="1637630" y="282498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69" name="TextBox 51">
              <a:extLst>
                <a:ext uri="{FF2B5EF4-FFF2-40B4-BE49-F238E27FC236}">
                  <a16:creationId xmlns:a16="http://schemas.microsoft.com/office/drawing/2014/main" id="{7320BB13-5BEB-EDDF-B34A-4615BA58159C}"/>
                </a:ext>
              </a:extLst>
            </p:cNvPr>
            <p:cNvSpPr txBox="1"/>
            <p:nvPr/>
          </p:nvSpPr>
          <p:spPr>
            <a:xfrm>
              <a:off x="1531019" y="282187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70" name="TextBox 51">
              <a:extLst>
                <a:ext uri="{FF2B5EF4-FFF2-40B4-BE49-F238E27FC236}">
                  <a16:creationId xmlns:a16="http://schemas.microsoft.com/office/drawing/2014/main" id="{161CEBE9-4846-1A77-16E2-DDF511E7DC69}"/>
                </a:ext>
              </a:extLst>
            </p:cNvPr>
            <p:cNvSpPr txBox="1"/>
            <p:nvPr/>
          </p:nvSpPr>
          <p:spPr>
            <a:xfrm>
              <a:off x="1315792" y="270830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71" name="TextBox 51">
              <a:extLst>
                <a:ext uri="{FF2B5EF4-FFF2-40B4-BE49-F238E27FC236}">
                  <a16:creationId xmlns:a16="http://schemas.microsoft.com/office/drawing/2014/main" id="{81A0DE1B-32A7-5522-5FDE-A0EC9A9B3B7A}"/>
                </a:ext>
              </a:extLst>
            </p:cNvPr>
            <p:cNvSpPr txBox="1"/>
            <p:nvPr/>
          </p:nvSpPr>
          <p:spPr>
            <a:xfrm>
              <a:off x="1745923" y="286308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72" name="TextBox 51">
              <a:extLst>
                <a:ext uri="{FF2B5EF4-FFF2-40B4-BE49-F238E27FC236}">
                  <a16:creationId xmlns:a16="http://schemas.microsoft.com/office/drawing/2014/main" id="{AB53AB95-81A0-229B-5E20-332F2BFA69C3}"/>
                </a:ext>
              </a:extLst>
            </p:cNvPr>
            <p:cNvSpPr txBox="1"/>
            <p:nvPr/>
          </p:nvSpPr>
          <p:spPr>
            <a:xfrm>
              <a:off x="1850710" y="254400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73" name="TextBox 51">
              <a:extLst>
                <a:ext uri="{FF2B5EF4-FFF2-40B4-BE49-F238E27FC236}">
                  <a16:creationId xmlns:a16="http://schemas.microsoft.com/office/drawing/2014/main" id="{36056B63-8BD5-0761-2A87-65D5B589B9C0}"/>
                </a:ext>
              </a:extLst>
            </p:cNvPr>
            <p:cNvSpPr txBox="1"/>
            <p:nvPr/>
          </p:nvSpPr>
          <p:spPr>
            <a:xfrm>
              <a:off x="1960094" y="247562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374" name="TextBox 51">
              <a:extLst>
                <a:ext uri="{FF2B5EF4-FFF2-40B4-BE49-F238E27FC236}">
                  <a16:creationId xmlns:a16="http://schemas.microsoft.com/office/drawing/2014/main" id="{5101A4A1-1EE6-41AA-86C0-85EAB09E075A}"/>
                </a:ext>
              </a:extLst>
            </p:cNvPr>
            <p:cNvSpPr txBox="1"/>
            <p:nvPr/>
          </p:nvSpPr>
          <p:spPr>
            <a:xfrm>
              <a:off x="2064167" y="261543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392" name="Group 391">
            <a:extLst>
              <a:ext uri="{FF2B5EF4-FFF2-40B4-BE49-F238E27FC236}">
                <a16:creationId xmlns:a16="http://schemas.microsoft.com/office/drawing/2014/main" id="{5491A0CC-9DEB-039A-B713-D3308CBB01FF}"/>
              </a:ext>
            </a:extLst>
          </p:cNvPr>
          <p:cNvGrpSpPr/>
          <p:nvPr/>
        </p:nvGrpSpPr>
        <p:grpSpPr>
          <a:xfrm>
            <a:off x="2431588" y="662785"/>
            <a:ext cx="1905389" cy="309562"/>
            <a:chOff x="352944" y="2354512"/>
            <a:chExt cx="1905389" cy="309562"/>
          </a:xfrm>
        </p:grpSpPr>
        <p:sp>
          <p:nvSpPr>
            <p:cNvPr id="483" name="TextBox 51">
              <a:extLst>
                <a:ext uri="{FF2B5EF4-FFF2-40B4-BE49-F238E27FC236}">
                  <a16:creationId xmlns:a16="http://schemas.microsoft.com/office/drawing/2014/main" id="{463F4D14-86F4-E0B0-98F9-D3B2A00D87CB}"/>
                </a:ext>
              </a:extLst>
            </p:cNvPr>
            <p:cNvSpPr txBox="1"/>
            <p:nvPr/>
          </p:nvSpPr>
          <p:spPr>
            <a:xfrm>
              <a:off x="565205" y="251372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484" name="TextBox 51">
              <a:extLst>
                <a:ext uri="{FF2B5EF4-FFF2-40B4-BE49-F238E27FC236}">
                  <a16:creationId xmlns:a16="http://schemas.microsoft.com/office/drawing/2014/main" id="{85D6BB73-E9E5-3888-AB26-BC8F4A37EA7E}"/>
                </a:ext>
              </a:extLst>
            </p:cNvPr>
            <p:cNvSpPr txBox="1"/>
            <p:nvPr/>
          </p:nvSpPr>
          <p:spPr>
            <a:xfrm>
              <a:off x="884274" y="244261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485" name="TextBox 51">
              <a:extLst>
                <a:ext uri="{FF2B5EF4-FFF2-40B4-BE49-F238E27FC236}">
                  <a16:creationId xmlns:a16="http://schemas.microsoft.com/office/drawing/2014/main" id="{BAE09CA2-75C0-2DAD-D4D2-3D65BB96FF7C}"/>
                </a:ext>
              </a:extLst>
            </p:cNvPr>
            <p:cNvSpPr txBox="1"/>
            <p:nvPr/>
          </p:nvSpPr>
          <p:spPr>
            <a:xfrm>
              <a:off x="778176" y="245928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486" name="TextBox 51">
              <a:extLst>
                <a:ext uri="{FF2B5EF4-FFF2-40B4-BE49-F238E27FC236}">
                  <a16:creationId xmlns:a16="http://schemas.microsoft.com/office/drawing/2014/main" id="{D7F89976-B930-BB3A-FAAB-CB5230C6AE0F}"/>
                </a:ext>
              </a:extLst>
            </p:cNvPr>
            <p:cNvSpPr txBox="1"/>
            <p:nvPr/>
          </p:nvSpPr>
          <p:spPr>
            <a:xfrm>
              <a:off x="352944" y="251057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487" name="TextBox 51">
              <a:extLst>
                <a:ext uri="{FF2B5EF4-FFF2-40B4-BE49-F238E27FC236}">
                  <a16:creationId xmlns:a16="http://schemas.microsoft.com/office/drawing/2014/main" id="{DF5557ED-8D61-83F5-55CC-4ABACF261048}"/>
                </a:ext>
              </a:extLst>
            </p:cNvPr>
            <p:cNvSpPr txBox="1"/>
            <p:nvPr/>
          </p:nvSpPr>
          <p:spPr>
            <a:xfrm>
              <a:off x="993336" y="253039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488" name="TextBox 51">
              <a:extLst>
                <a:ext uri="{FF2B5EF4-FFF2-40B4-BE49-F238E27FC236}">
                  <a16:creationId xmlns:a16="http://schemas.microsoft.com/office/drawing/2014/main" id="{45229A35-4C91-E96E-D567-CF4D8AACDA86}"/>
                </a:ext>
              </a:extLst>
            </p:cNvPr>
            <p:cNvSpPr txBox="1"/>
            <p:nvPr/>
          </p:nvSpPr>
          <p:spPr>
            <a:xfrm>
              <a:off x="1100208" y="254096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36" name="TextBox 51">
              <a:extLst>
                <a:ext uri="{FF2B5EF4-FFF2-40B4-BE49-F238E27FC236}">
                  <a16:creationId xmlns:a16="http://schemas.microsoft.com/office/drawing/2014/main" id="{E2F1E9C1-DF56-5C4D-5EBD-FAEDA4C42C18}"/>
                </a:ext>
              </a:extLst>
            </p:cNvPr>
            <p:cNvSpPr txBox="1"/>
            <p:nvPr/>
          </p:nvSpPr>
          <p:spPr>
            <a:xfrm>
              <a:off x="1206950" y="241713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37" name="TextBox 51">
              <a:extLst>
                <a:ext uri="{FF2B5EF4-FFF2-40B4-BE49-F238E27FC236}">
                  <a16:creationId xmlns:a16="http://schemas.microsoft.com/office/drawing/2014/main" id="{4D8F8FA9-9427-E1AE-A708-E2A73ADF73FF}"/>
                </a:ext>
              </a:extLst>
            </p:cNvPr>
            <p:cNvSpPr txBox="1"/>
            <p:nvPr/>
          </p:nvSpPr>
          <p:spPr>
            <a:xfrm>
              <a:off x="1421293" y="247325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38" name="TextBox 51">
              <a:extLst>
                <a:ext uri="{FF2B5EF4-FFF2-40B4-BE49-F238E27FC236}">
                  <a16:creationId xmlns:a16="http://schemas.microsoft.com/office/drawing/2014/main" id="{73258230-D027-27AE-5911-BFAAD7C40365}"/>
                </a:ext>
              </a:extLst>
            </p:cNvPr>
            <p:cNvSpPr txBox="1"/>
            <p:nvPr/>
          </p:nvSpPr>
          <p:spPr>
            <a:xfrm>
              <a:off x="1635249" y="253515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39" name="TextBox 51">
              <a:extLst>
                <a:ext uri="{FF2B5EF4-FFF2-40B4-BE49-F238E27FC236}">
                  <a16:creationId xmlns:a16="http://schemas.microsoft.com/office/drawing/2014/main" id="{3AD83353-CE3C-2E1D-D435-093121388948}"/>
                </a:ext>
              </a:extLst>
            </p:cNvPr>
            <p:cNvSpPr txBox="1"/>
            <p:nvPr/>
          </p:nvSpPr>
          <p:spPr>
            <a:xfrm>
              <a:off x="1528638" y="242967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40" name="TextBox 51">
              <a:extLst>
                <a:ext uri="{FF2B5EF4-FFF2-40B4-BE49-F238E27FC236}">
                  <a16:creationId xmlns:a16="http://schemas.microsoft.com/office/drawing/2014/main" id="{649D6E79-BC77-B5F8-5669-6758759D4E38}"/>
                </a:ext>
              </a:extLst>
            </p:cNvPr>
            <p:cNvSpPr txBox="1"/>
            <p:nvPr/>
          </p:nvSpPr>
          <p:spPr>
            <a:xfrm>
              <a:off x="1313411" y="245452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43" name="TextBox 51">
              <a:extLst>
                <a:ext uri="{FF2B5EF4-FFF2-40B4-BE49-F238E27FC236}">
                  <a16:creationId xmlns:a16="http://schemas.microsoft.com/office/drawing/2014/main" id="{5E31C2F0-8FE1-0589-7EAB-1F7538F4556C}"/>
                </a:ext>
              </a:extLst>
            </p:cNvPr>
            <p:cNvSpPr txBox="1"/>
            <p:nvPr/>
          </p:nvSpPr>
          <p:spPr>
            <a:xfrm>
              <a:off x="1957713" y="253143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44" name="TextBox 51">
              <a:extLst>
                <a:ext uri="{FF2B5EF4-FFF2-40B4-BE49-F238E27FC236}">
                  <a16:creationId xmlns:a16="http://schemas.microsoft.com/office/drawing/2014/main" id="{62844E58-407B-3B0F-B465-A40D41F442EB}"/>
                </a:ext>
              </a:extLst>
            </p:cNvPr>
            <p:cNvSpPr txBox="1"/>
            <p:nvPr/>
          </p:nvSpPr>
          <p:spPr>
            <a:xfrm>
              <a:off x="2064167" y="235451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45" name="TextBox 51">
              <a:extLst>
                <a:ext uri="{FF2B5EF4-FFF2-40B4-BE49-F238E27FC236}">
                  <a16:creationId xmlns:a16="http://schemas.microsoft.com/office/drawing/2014/main" id="{F152C5A0-896B-C29A-9E37-6B1C57CA92F7}"/>
                </a:ext>
              </a:extLst>
            </p:cNvPr>
            <p:cNvSpPr txBox="1"/>
            <p:nvPr/>
          </p:nvSpPr>
          <p:spPr>
            <a:xfrm>
              <a:off x="673743" y="246166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547" name="Group 546">
            <a:extLst>
              <a:ext uri="{FF2B5EF4-FFF2-40B4-BE49-F238E27FC236}">
                <a16:creationId xmlns:a16="http://schemas.microsoft.com/office/drawing/2014/main" id="{330A53CC-BE17-4BA7-A79A-E9B6EAC23912}"/>
              </a:ext>
            </a:extLst>
          </p:cNvPr>
          <p:cNvGrpSpPr/>
          <p:nvPr/>
        </p:nvGrpSpPr>
        <p:grpSpPr>
          <a:xfrm>
            <a:off x="2431588" y="1509887"/>
            <a:ext cx="1905389" cy="326851"/>
            <a:chOff x="352944" y="2370138"/>
            <a:chExt cx="1905389" cy="326851"/>
          </a:xfrm>
        </p:grpSpPr>
        <p:sp>
          <p:nvSpPr>
            <p:cNvPr id="548" name="TextBox 51">
              <a:extLst>
                <a:ext uri="{FF2B5EF4-FFF2-40B4-BE49-F238E27FC236}">
                  <a16:creationId xmlns:a16="http://schemas.microsoft.com/office/drawing/2014/main" id="{86082ADA-4E25-ADB8-EF8C-EC2AE4173090}"/>
                </a:ext>
              </a:extLst>
            </p:cNvPr>
            <p:cNvSpPr txBox="1"/>
            <p:nvPr/>
          </p:nvSpPr>
          <p:spPr>
            <a:xfrm>
              <a:off x="565205" y="255420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49" name="TextBox 51">
              <a:extLst>
                <a:ext uri="{FF2B5EF4-FFF2-40B4-BE49-F238E27FC236}">
                  <a16:creationId xmlns:a16="http://schemas.microsoft.com/office/drawing/2014/main" id="{DA2DDBE0-7F86-FACB-B294-70D0D0555E45}"/>
                </a:ext>
              </a:extLst>
            </p:cNvPr>
            <p:cNvSpPr txBox="1"/>
            <p:nvPr/>
          </p:nvSpPr>
          <p:spPr>
            <a:xfrm>
              <a:off x="884274" y="256673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0" name="TextBox 51">
              <a:extLst>
                <a:ext uri="{FF2B5EF4-FFF2-40B4-BE49-F238E27FC236}">
                  <a16:creationId xmlns:a16="http://schemas.microsoft.com/office/drawing/2014/main" id="{F2416B77-2DE4-6F9A-A000-A898EC17D850}"/>
                </a:ext>
              </a:extLst>
            </p:cNvPr>
            <p:cNvSpPr txBox="1"/>
            <p:nvPr/>
          </p:nvSpPr>
          <p:spPr>
            <a:xfrm>
              <a:off x="778176" y="256134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1" name="TextBox 51">
              <a:extLst>
                <a:ext uri="{FF2B5EF4-FFF2-40B4-BE49-F238E27FC236}">
                  <a16:creationId xmlns:a16="http://schemas.microsoft.com/office/drawing/2014/main" id="{55E1E233-5594-5FC0-0E22-26BCD8E6D7DF}"/>
                </a:ext>
              </a:extLst>
            </p:cNvPr>
            <p:cNvSpPr txBox="1"/>
            <p:nvPr/>
          </p:nvSpPr>
          <p:spPr>
            <a:xfrm>
              <a:off x="352944" y="256772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2" name="TextBox 51">
              <a:extLst>
                <a:ext uri="{FF2B5EF4-FFF2-40B4-BE49-F238E27FC236}">
                  <a16:creationId xmlns:a16="http://schemas.microsoft.com/office/drawing/2014/main" id="{93B85DA7-9034-52E4-DB9D-274A7F9098EB}"/>
                </a:ext>
              </a:extLst>
            </p:cNvPr>
            <p:cNvSpPr txBox="1"/>
            <p:nvPr/>
          </p:nvSpPr>
          <p:spPr>
            <a:xfrm>
              <a:off x="993336" y="256372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3" name="TextBox 51">
              <a:extLst>
                <a:ext uri="{FF2B5EF4-FFF2-40B4-BE49-F238E27FC236}">
                  <a16:creationId xmlns:a16="http://schemas.microsoft.com/office/drawing/2014/main" id="{BDD8675F-A170-9EEA-7A0B-960B9E4BA1EE}"/>
                </a:ext>
              </a:extLst>
            </p:cNvPr>
            <p:cNvSpPr txBox="1"/>
            <p:nvPr/>
          </p:nvSpPr>
          <p:spPr>
            <a:xfrm>
              <a:off x="1100208" y="257387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4" name="TextBox 51">
              <a:extLst>
                <a:ext uri="{FF2B5EF4-FFF2-40B4-BE49-F238E27FC236}">
                  <a16:creationId xmlns:a16="http://schemas.microsoft.com/office/drawing/2014/main" id="{D3BBBA4A-291B-652D-5361-8F9187039CC5}"/>
                </a:ext>
              </a:extLst>
            </p:cNvPr>
            <p:cNvSpPr txBox="1"/>
            <p:nvPr/>
          </p:nvSpPr>
          <p:spPr>
            <a:xfrm>
              <a:off x="1206950" y="254768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5" name="TextBox 51">
              <a:extLst>
                <a:ext uri="{FF2B5EF4-FFF2-40B4-BE49-F238E27FC236}">
                  <a16:creationId xmlns:a16="http://schemas.microsoft.com/office/drawing/2014/main" id="{A5F72F69-64DB-6DA5-F7CD-707039183979}"/>
                </a:ext>
              </a:extLst>
            </p:cNvPr>
            <p:cNvSpPr txBox="1"/>
            <p:nvPr/>
          </p:nvSpPr>
          <p:spPr>
            <a:xfrm>
              <a:off x="1421293" y="257149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6" name="TextBox 51">
              <a:extLst>
                <a:ext uri="{FF2B5EF4-FFF2-40B4-BE49-F238E27FC236}">
                  <a16:creationId xmlns:a16="http://schemas.microsoft.com/office/drawing/2014/main" id="{2632A047-9E0E-A52E-16A6-E5BEDEB366AC}"/>
                </a:ext>
              </a:extLst>
            </p:cNvPr>
            <p:cNvSpPr txBox="1"/>
            <p:nvPr/>
          </p:nvSpPr>
          <p:spPr>
            <a:xfrm>
              <a:off x="1637630" y="256673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7" name="TextBox 51">
              <a:extLst>
                <a:ext uri="{FF2B5EF4-FFF2-40B4-BE49-F238E27FC236}">
                  <a16:creationId xmlns:a16="http://schemas.microsoft.com/office/drawing/2014/main" id="{89D8D2B4-D968-0388-3A1B-3B739FF71396}"/>
                </a:ext>
              </a:extLst>
            </p:cNvPr>
            <p:cNvSpPr txBox="1"/>
            <p:nvPr/>
          </p:nvSpPr>
          <p:spPr>
            <a:xfrm>
              <a:off x="1528638" y="245824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8" name="TextBox 51">
              <a:extLst>
                <a:ext uri="{FF2B5EF4-FFF2-40B4-BE49-F238E27FC236}">
                  <a16:creationId xmlns:a16="http://schemas.microsoft.com/office/drawing/2014/main" id="{BA346A8D-3BF8-CDE0-32C3-099F14D3A164}"/>
                </a:ext>
              </a:extLst>
            </p:cNvPr>
            <p:cNvSpPr txBox="1"/>
            <p:nvPr/>
          </p:nvSpPr>
          <p:spPr>
            <a:xfrm>
              <a:off x="1313411" y="256196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59" name="TextBox 51">
              <a:extLst>
                <a:ext uri="{FF2B5EF4-FFF2-40B4-BE49-F238E27FC236}">
                  <a16:creationId xmlns:a16="http://schemas.microsoft.com/office/drawing/2014/main" id="{CE6F45B2-7578-63C3-0F22-86A6C8F5C357}"/>
                </a:ext>
              </a:extLst>
            </p:cNvPr>
            <p:cNvSpPr txBox="1"/>
            <p:nvPr/>
          </p:nvSpPr>
          <p:spPr>
            <a:xfrm>
              <a:off x="1745923" y="256839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60" name="TextBox 51">
              <a:extLst>
                <a:ext uri="{FF2B5EF4-FFF2-40B4-BE49-F238E27FC236}">
                  <a16:creationId xmlns:a16="http://schemas.microsoft.com/office/drawing/2014/main" id="{7C4523A5-556D-8342-2F5C-A2D69BB80094}"/>
                </a:ext>
              </a:extLst>
            </p:cNvPr>
            <p:cNvSpPr txBox="1"/>
            <p:nvPr/>
          </p:nvSpPr>
          <p:spPr>
            <a:xfrm>
              <a:off x="1850710" y="237013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61" name="TextBox 51">
              <a:extLst>
                <a:ext uri="{FF2B5EF4-FFF2-40B4-BE49-F238E27FC236}">
                  <a16:creationId xmlns:a16="http://schemas.microsoft.com/office/drawing/2014/main" id="{F8546B2B-1409-A80C-55C3-1506CFF7F049}"/>
                </a:ext>
              </a:extLst>
            </p:cNvPr>
            <p:cNvSpPr txBox="1"/>
            <p:nvPr/>
          </p:nvSpPr>
          <p:spPr>
            <a:xfrm>
              <a:off x="1957713" y="252554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62" name="TextBox 51">
              <a:extLst>
                <a:ext uri="{FF2B5EF4-FFF2-40B4-BE49-F238E27FC236}">
                  <a16:creationId xmlns:a16="http://schemas.microsoft.com/office/drawing/2014/main" id="{06F2C0F9-464F-26D0-0829-799DEB1449D9}"/>
                </a:ext>
              </a:extLst>
            </p:cNvPr>
            <p:cNvSpPr txBox="1"/>
            <p:nvPr/>
          </p:nvSpPr>
          <p:spPr>
            <a:xfrm>
              <a:off x="2064167" y="247148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63" name="TextBox 51">
              <a:extLst>
                <a:ext uri="{FF2B5EF4-FFF2-40B4-BE49-F238E27FC236}">
                  <a16:creationId xmlns:a16="http://schemas.microsoft.com/office/drawing/2014/main" id="{058D5CFA-242B-F94A-9140-151A1997962D}"/>
                </a:ext>
              </a:extLst>
            </p:cNvPr>
            <p:cNvSpPr txBox="1"/>
            <p:nvPr/>
          </p:nvSpPr>
          <p:spPr>
            <a:xfrm>
              <a:off x="673743" y="255842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565" name="Group 564">
            <a:extLst>
              <a:ext uri="{FF2B5EF4-FFF2-40B4-BE49-F238E27FC236}">
                <a16:creationId xmlns:a16="http://schemas.microsoft.com/office/drawing/2014/main" id="{8DF84A79-EC5C-9F27-0B96-9D196CF1E2B0}"/>
              </a:ext>
            </a:extLst>
          </p:cNvPr>
          <p:cNvGrpSpPr/>
          <p:nvPr/>
        </p:nvGrpSpPr>
        <p:grpSpPr>
          <a:xfrm>
            <a:off x="2643849" y="2099389"/>
            <a:ext cx="1581912" cy="511254"/>
            <a:chOff x="565205" y="2255888"/>
            <a:chExt cx="1581912" cy="511254"/>
          </a:xfrm>
        </p:grpSpPr>
        <p:sp>
          <p:nvSpPr>
            <p:cNvPr id="566" name="TextBox 51">
              <a:extLst>
                <a:ext uri="{FF2B5EF4-FFF2-40B4-BE49-F238E27FC236}">
                  <a16:creationId xmlns:a16="http://schemas.microsoft.com/office/drawing/2014/main" id="{5373DF3E-F041-69A5-8A26-285865F0A135}"/>
                </a:ext>
              </a:extLst>
            </p:cNvPr>
            <p:cNvSpPr txBox="1"/>
            <p:nvPr/>
          </p:nvSpPr>
          <p:spPr>
            <a:xfrm>
              <a:off x="565205" y="248448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67" name="TextBox 51">
              <a:extLst>
                <a:ext uri="{FF2B5EF4-FFF2-40B4-BE49-F238E27FC236}">
                  <a16:creationId xmlns:a16="http://schemas.microsoft.com/office/drawing/2014/main" id="{562ED9B7-B300-0FDF-2118-E27CE3D35B31}"/>
                </a:ext>
              </a:extLst>
            </p:cNvPr>
            <p:cNvSpPr txBox="1"/>
            <p:nvPr/>
          </p:nvSpPr>
          <p:spPr>
            <a:xfrm>
              <a:off x="884274" y="250821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568" name="TextBox 51">
              <a:extLst>
                <a:ext uri="{FF2B5EF4-FFF2-40B4-BE49-F238E27FC236}">
                  <a16:creationId xmlns:a16="http://schemas.microsoft.com/office/drawing/2014/main" id="{083B96B9-FCCC-4863-3F0D-99121EF92895}"/>
                </a:ext>
              </a:extLst>
            </p:cNvPr>
            <p:cNvSpPr txBox="1"/>
            <p:nvPr/>
          </p:nvSpPr>
          <p:spPr>
            <a:xfrm>
              <a:off x="775795" y="227660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70" name="TextBox 51">
              <a:extLst>
                <a:ext uri="{FF2B5EF4-FFF2-40B4-BE49-F238E27FC236}">
                  <a16:creationId xmlns:a16="http://schemas.microsoft.com/office/drawing/2014/main" id="{A14495ED-F013-75C8-F95D-E777C79703ED}"/>
                </a:ext>
              </a:extLst>
            </p:cNvPr>
            <p:cNvSpPr txBox="1"/>
            <p:nvPr/>
          </p:nvSpPr>
          <p:spPr>
            <a:xfrm>
              <a:off x="993336" y="250758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571" name="TextBox 51">
              <a:extLst>
                <a:ext uri="{FF2B5EF4-FFF2-40B4-BE49-F238E27FC236}">
                  <a16:creationId xmlns:a16="http://schemas.microsoft.com/office/drawing/2014/main" id="{3DBFA022-5717-25C1-DFB1-6D323A3EDA5D}"/>
                </a:ext>
              </a:extLst>
            </p:cNvPr>
            <p:cNvSpPr txBox="1"/>
            <p:nvPr/>
          </p:nvSpPr>
          <p:spPr>
            <a:xfrm>
              <a:off x="1100208" y="248101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72" name="TextBox 51">
              <a:extLst>
                <a:ext uri="{FF2B5EF4-FFF2-40B4-BE49-F238E27FC236}">
                  <a16:creationId xmlns:a16="http://schemas.microsoft.com/office/drawing/2014/main" id="{28BA674D-A0BE-ACAC-FC1E-FAF5D8A8ECAD}"/>
                </a:ext>
              </a:extLst>
            </p:cNvPr>
            <p:cNvSpPr txBox="1"/>
            <p:nvPr/>
          </p:nvSpPr>
          <p:spPr>
            <a:xfrm>
              <a:off x="1204569" y="225588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73" name="TextBox 51">
              <a:extLst>
                <a:ext uri="{FF2B5EF4-FFF2-40B4-BE49-F238E27FC236}">
                  <a16:creationId xmlns:a16="http://schemas.microsoft.com/office/drawing/2014/main" id="{87DD300D-F82D-0F6B-CC94-A25C80B518E7}"/>
                </a:ext>
              </a:extLst>
            </p:cNvPr>
            <p:cNvSpPr txBox="1"/>
            <p:nvPr/>
          </p:nvSpPr>
          <p:spPr>
            <a:xfrm>
              <a:off x="1418912" y="258102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75" name="TextBox 51">
              <a:extLst>
                <a:ext uri="{FF2B5EF4-FFF2-40B4-BE49-F238E27FC236}">
                  <a16:creationId xmlns:a16="http://schemas.microsoft.com/office/drawing/2014/main" id="{FB8A9971-AF43-77D0-89B3-93EF56762D74}"/>
                </a:ext>
              </a:extLst>
            </p:cNvPr>
            <p:cNvSpPr txBox="1"/>
            <p:nvPr/>
          </p:nvSpPr>
          <p:spPr>
            <a:xfrm>
              <a:off x="1526257" y="245110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76" name="TextBox 51">
              <a:extLst>
                <a:ext uri="{FF2B5EF4-FFF2-40B4-BE49-F238E27FC236}">
                  <a16:creationId xmlns:a16="http://schemas.microsoft.com/office/drawing/2014/main" id="{6C5651FD-090A-AD3D-1C91-A959B96D4137}"/>
                </a:ext>
              </a:extLst>
            </p:cNvPr>
            <p:cNvSpPr txBox="1"/>
            <p:nvPr/>
          </p:nvSpPr>
          <p:spPr>
            <a:xfrm>
              <a:off x="1313411" y="249291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77" name="TextBox 51">
              <a:extLst>
                <a:ext uri="{FF2B5EF4-FFF2-40B4-BE49-F238E27FC236}">
                  <a16:creationId xmlns:a16="http://schemas.microsoft.com/office/drawing/2014/main" id="{BF43C37A-6D28-533F-6261-7809E74D0C77}"/>
                </a:ext>
              </a:extLst>
            </p:cNvPr>
            <p:cNvSpPr txBox="1"/>
            <p:nvPr/>
          </p:nvSpPr>
          <p:spPr>
            <a:xfrm>
              <a:off x="1741161" y="264403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78" name="TextBox 51">
              <a:extLst>
                <a:ext uri="{FF2B5EF4-FFF2-40B4-BE49-F238E27FC236}">
                  <a16:creationId xmlns:a16="http://schemas.microsoft.com/office/drawing/2014/main" id="{C8966B7E-DAFA-3559-5A97-E25B9871502B}"/>
                </a:ext>
              </a:extLst>
            </p:cNvPr>
            <p:cNvSpPr txBox="1"/>
            <p:nvPr/>
          </p:nvSpPr>
          <p:spPr>
            <a:xfrm>
              <a:off x="1845948" y="262260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79" name="TextBox 51">
              <a:extLst>
                <a:ext uri="{FF2B5EF4-FFF2-40B4-BE49-F238E27FC236}">
                  <a16:creationId xmlns:a16="http://schemas.microsoft.com/office/drawing/2014/main" id="{8B263636-3F96-E7F3-BB38-9D1BF2CFA5B3}"/>
                </a:ext>
              </a:extLst>
            </p:cNvPr>
            <p:cNvSpPr txBox="1"/>
            <p:nvPr/>
          </p:nvSpPr>
          <p:spPr>
            <a:xfrm>
              <a:off x="1952951" y="260117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81" name="TextBox 51">
              <a:extLst>
                <a:ext uri="{FF2B5EF4-FFF2-40B4-BE49-F238E27FC236}">
                  <a16:creationId xmlns:a16="http://schemas.microsoft.com/office/drawing/2014/main" id="{E13E764F-AE42-17F6-12CE-5336DA00B99A}"/>
                </a:ext>
              </a:extLst>
            </p:cNvPr>
            <p:cNvSpPr txBox="1"/>
            <p:nvPr/>
          </p:nvSpPr>
          <p:spPr>
            <a:xfrm>
              <a:off x="671362" y="239638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583" name="Group 582">
            <a:extLst>
              <a:ext uri="{FF2B5EF4-FFF2-40B4-BE49-F238E27FC236}">
                <a16:creationId xmlns:a16="http://schemas.microsoft.com/office/drawing/2014/main" id="{5A6A3440-12FA-3B6C-F921-D23296B259BF}"/>
              </a:ext>
            </a:extLst>
          </p:cNvPr>
          <p:cNvGrpSpPr/>
          <p:nvPr/>
        </p:nvGrpSpPr>
        <p:grpSpPr>
          <a:xfrm>
            <a:off x="2431588" y="2787570"/>
            <a:ext cx="1905389" cy="587454"/>
            <a:chOff x="352944" y="2207164"/>
            <a:chExt cx="1905389" cy="587454"/>
          </a:xfrm>
        </p:grpSpPr>
        <p:sp>
          <p:nvSpPr>
            <p:cNvPr id="584" name="TextBox 51">
              <a:extLst>
                <a:ext uri="{FF2B5EF4-FFF2-40B4-BE49-F238E27FC236}">
                  <a16:creationId xmlns:a16="http://schemas.microsoft.com/office/drawing/2014/main" id="{7EEE341A-3D00-E64D-4695-48ADB9736BBF}"/>
                </a:ext>
              </a:extLst>
            </p:cNvPr>
            <p:cNvSpPr txBox="1"/>
            <p:nvPr/>
          </p:nvSpPr>
          <p:spPr>
            <a:xfrm>
              <a:off x="565205" y="262942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85" name="TextBox 51">
              <a:extLst>
                <a:ext uri="{FF2B5EF4-FFF2-40B4-BE49-F238E27FC236}">
                  <a16:creationId xmlns:a16="http://schemas.microsoft.com/office/drawing/2014/main" id="{E37CDC93-3327-A621-CA28-F94FB89944E0}"/>
                </a:ext>
              </a:extLst>
            </p:cNvPr>
            <p:cNvSpPr txBox="1"/>
            <p:nvPr/>
          </p:nvSpPr>
          <p:spPr>
            <a:xfrm>
              <a:off x="884274" y="263103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86" name="TextBox 51">
              <a:extLst>
                <a:ext uri="{FF2B5EF4-FFF2-40B4-BE49-F238E27FC236}">
                  <a16:creationId xmlns:a16="http://schemas.microsoft.com/office/drawing/2014/main" id="{F8301806-8C93-25F1-6795-755E84F8E7C7}"/>
                </a:ext>
              </a:extLst>
            </p:cNvPr>
            <p:cNvSpPr txBox="1"/>
            <p:nvPr/>
          </p:nvSpPr>
          <p:spPr>
            <a:xfrm>
              <a:off x="778176" y="257086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87" name="TextBox 51">
              <a:extLst>
                <a:ext uri="{FF2B5EF4-FFF2-40B4-BE49-F238E27FC236}">
                  <a16:creationId xmlns:a16="http://schemas.microsoft.com/office/drawing/2014/main" id="{760916CE-5394-7867-E473-34364D1C10B5}"/>
                </a:ext>
              </a:extLst>
            </p:cNvPr>
            <p:cNvSpPr txBox="1"/>
            <p:nvPr/>
          </p:nvSpPr>
          <p:spPr>
            <a:xfrm>
              <a:off x="352944" y="266912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88" name="TextBox 51">
              <a:extLst>
                <a:ext uri="{FF2B5EF4-FFF2-40B4-BE49-F238E27FC236}">
                  <a16:creationId xmlns:a16="http://schemas.microsoft.com/office/drawing/2014/main" id="{8443D625-CAFE-F5AC-D77B-8F9C77CE1ABC}"/>
                </a:ext>
              </a:extLst>
            </p:cNvPr>
            <p:cNvSpPr txBox="1"/>
            <p:nvPr/>
          </p:nvSpPr>
          <p:spPr>
            <a:xfrm>
              <a:off x="993336" y="256372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89" name="TextBox 51">
              <a:extLst>
                <a:ext uri="{FF2B5EF4-FFF2-40B4-BE49-F238E27FC236}">
                  <a16:creationId xmlns:a16="http://schemas.microsoft.com/office/drawing/2014/main" id="{A1B0246E-9433-DD45-A61F-3342EB82502F}"/>
                </a:ext>
              </a:extLst>
            </p:cNvPr>
            <p:cNvSpPr txBox="1"/>
            <p:nvPr/>
          </p:nvSpPr>
          <p:spPr>
            <a:xfrm>
              <a:off x="1100208" y="262626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0" name="TextBox 51">
              <a:extLst>
                <a:ext uri="{FF2B5EF4-FFF2-40B4-BE49-F238E27FC236}">
                  <a16:creationId xmlns:a16="http://schemas.microsoft.com/office/drawing/2014/main" id="{70385E18-1193-870B-94D1-224847D0F825}"/>
                </a:ext>
              </a:extLst>
            </p:cNvPr>
            <p:cNvSpPr txBox="1"/>
            <p:nvPr/>
          </p:nvSpPr>
          <p:spPr>
            <a:xfrm>
              <a:off x="1206950" y="220716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1" name="TextBox 51">
              <a:extLst>
                <a:ext uri="{FF2B5EF4-FFF2-40B4-BE49-F238E27FC236}">
                  <a16:creationId xmlns:a16="http://schemas.microsoft.com/office/drawing/2014/main" id="{B6E38DAC-1516-22BB-1EE1-12F498D000A3}"/>
                </a:ext>
              </a:extLst>
            </p:cNvPr>
            <p:cNvSpPr txBox="1"/>
            <p:nvPr/>
          </p:nvSpPr>
          <p:spPr>
            <a:xfrm>
              <a:off x="1421293" y="265722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2" name="TextBox 51">
              <a:extLst>
                <a:ext uri="{FF2B5EF4-FFF2-40B4-BE49-F238E27FC236}">
                  <a16:creationId xmlns:a16="http://schemas.microsoft.com/office/drawing/2014/main" id="{5E06DB40-588C-35BC-2BE9-39CDC7BB5955}"/>
                </a:ext>
              </a:extLst>
            </p:cNvPr>
            <p:cNvSpPr txBox="1"/>
            <p:nvPr/>
          </p:nvSpPr>
          <p:spPr>
            <a:xfrm>
              <a:off x="1637630" y="265556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3" name="TextBox 51">
              <a:extLst>
                <a:ext uri="{FF2B5EF4-FFF2-40B4-BE49-F238E27FC236}">
                  <a16:creationId xmlns:a16="http://schemas.microsoft.com/office/drawing/2014/main" id="{DE40E19F-B944-3F6E-6FE1-D20B0A4DE783}"/>
                </a:ext>
              </a:extLst>
            </p:cNvPr>
            <p:cNvSpPr txBox="1"/>
            <p:nvPr/>
          </p:nvSpPr>
          <p:spPr>
            <a:xfrm>
              <a:off x="1528638" y="260483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4" name="TextBox 51">
              <a:extLst>
                <a:ext uri="{FF2B5EF4-FFF2-40B4-BE49-F238E27FC236}">
                  <a16:creationId xmlns:a16="http://schemas.microsoft.com/office/drawing/2014/main" id="{DEE4B4F1-CFE4-B87F-6B06-A30501CB74D0}"/>
                </a:ext>
              </a:extLst>
            </p:cNvPr>
            <p:cNvSpPr txBox="1"/>
            <p:nvPr/>
          </p:nvSpPr>
          <p:spPr>
            <a:xfrm>
              <a:off x="1313411" y="258101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5" name="TextBox 51">
              <a:extLst>
                <a:ext uri="{FF2B5EF4-FFF2-40B4-BE49-F238E27FC236}">
                  <a16:creationId xmlns:a16="http://schemas.microsoft.com/office/drawing/2014/main" id="{486A7801-36A8-1970-8368-52A66F01B97B}"/>
                </a:ext>
              </a:extLst>
            </p:cNvPr>
            <p:cNvSpPr txBox="1"/>
            <p:nvPr/>
          </p:nvSpPr>
          <p:spPr>
            <a:xfrm>
              <a:off x="1743542" y="267150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7" name="TextBox 51">
              <a:extLst>
                <a:ext uri="{FF2B5EF4-FFF2-40B4-BE49-F238E27FC236}">
                  <a16:creationId xmlns:a16="http://schemas.microsoft.com/office/drawing/2014/main" id="{6A2A0007-A0F5-AA85-6E54-0B76349D0A90}"/>
                </a:ext>
              </a:extLst>
            </p:cNvPr>
            <p:cNvSpPr txBox="1"/>
            <p:nvPr/>
          </p:nvSpPr>
          <p:spPr>
            <a:xfrm>
              <a:off x="1957713" y="265007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8" name="TextBox 51">
              <a:extLst>
                <a:ext uri="{FF2B5EF4-FFF2-40B4-BE49-F238E27FC236}">
                  <a16:creationId xmlns:a16="http://schemas.microsoft.com/office/drawing/2014/main" id="{DD59F0DF-C1E7-9608-E09F-A52807418AC8}"/>
                </a:ext>
              </a:extLst>
            </p:cNvPr>
            <p:cNvSpPr txBox="1"/>
            <p:nvPr/>
          </p:nvSpPr>
          <p:spPr>
            <a:xfrm>
              <a:off x="2064167" y="254839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599" name="TextBox 51">
              <a:extLst>
                <a:ext uri="{FF2B5EF4-FFF2-40B4-BE49-F238E27FC236}">
                  <a16:creationId xmlns:a16="http://schemas.microsoft.com/office/drawing/2014/main" id="{5D1282C5-E82A-5FAA-868C-F9A4FC454621}"/>
                </a:ext>
              </a:extLst>
            </p:cNvPr>
            <p:cNvSpPr txBox="1"/>
            <p:nvPr/>
          </p:nvSpPr>
          <p:spPr>
            <a:xfrm>
              <a:off x="673743" y="258461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602" name="Group 601">
            <a:extLst>
              <a:ext uri="{FF2B5EF4-FFF2-40B4-BE49-F238E27FC236}">
                <a16:creationId xmlns:a16="http://schemas.microsoft.com/office/drawing/2014/main" id="{D43EC5C6-F360-5851-5BFD-E391A8B3A585}"/>
              </a:ext>
            </a:extLst>
          </p:cNvPr>
          <p:cNvGrpSpPr/>
          <p:nvPr/>
        </p:nvGrpSpPr>
        <p:grpSpPr>
          <a:xfrm>
            <a:off x="4509740" y="592467"/>
            <a:ext cx="1900627" cy="377499"/>
            <a:chOff x="357706" y="2469101"/>
            <a:chExt cx="1900627" cy="377499"/>
          </a:xfrm>
        </p:grpSpPr>
        <p:sp>
          <p:nvSpPr>
            <p:cNvPr id="604" name="TextBox 51">
              <a:extLst>
                <a:ext uri="{FF2B5EF4-FFF2-40B4-BE49-F238E27FC236}">
                  <a16:creationId xmlns:a16="http://schemas.microsoft.com/office/drawing/2014/main" id="{6965EEAF-7DA9-4525-C70C-0544EE43F8CA}"/>
                </a:ext>
              </a:extLst>
            </p:cNvPr>
            <p:cNvSpPr txBox="1"/>
            <p:nvPr/>
          </p:nvSpPr>
          <p:spPr>
            <a:xfrm>
              <a:off x="884274" y="256084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06" name="TextBox 51">
              <a:extLst>
                <a:ext uri="{FF2B5EF4-FFF2-40B4-BE49-F238E27FC236}">
                  <a16:creationId xmlns:a16="http://schemas.microsoft.com/office/drawing/2014/main" id="{29319F28-95A2-6E3C-7B3E-926014CDBBB5}"/>
                </a:ext>
              </a:extLst>
            </p:cNvPr>
            <p:cNvSpPr txBox="1"/>
            <p:nvPr/>
          </p:nvSpPr>
          <p:spPr>
            <a:xfrm>
              <a:off x="357706" y="256772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09" name="TextBox 51">
              <a:extLst>
                <a:ext uri="{FF2B5EF4-FFF2-40B4-BE49-F238E27FC236}">
                  <a16:creationId xmlns:a16="http://schemas.microsoft.com/office/drawing/2014/main" id="{903708E8-139B-B5F8-13DE-F1886571FBD0}"/>
                </a:ext>
              </a:extLst>
            </p:cNvPr>
            <p:cNvSpPr txBox="1"/>
            <p:nvPr/>
          </p:nvSpPr>
          <p:spPr>
            <a:xfrm>
              <a:off x="1206950" y="248941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10" name="TextBox 51">
              <a:extLst>
                <a:ext uri="{FF2B5EF4-FFF2-40B4-BE49-F238E27FC236}">
                  <a16:creationId xmlns:a16="http://schemas.microsoft.com/office/drawing/2014/main" id="{7CC9BD12-23A4-C7DF-B1EA-A822B61BF962}"/>
                </a:ext>
              </a:extLst>
            </p:cNvPr>
            <p:cNvSpPr txBox="1"/>
            <p:nvPr/>
          </p:nvSpPr>
          <p:spPr>
            <a:xfrm>
              <a:off x="1423674" y="259530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13" name="TextBox 51">
              <a:extLst>
                <a:ext uri="{FF2B5EF4-FFF2-40B4-BE49-F238E27FC236}">
                  <a16:creationId xmlns:a16="http://schemas.microsoft.com/office/drawing/2014/main" id="{394452B3-7D2E-D2C7-946D-954A11E98638}"/>
                </a:ext>
              </a:extLst>
            </p:cNvPr>
            <p:cNvSpPr txBox="1"/>
            <p:nvPr/>
          </p:nvSpPr>
          <p:spPr>
            <a:xfrm>
              <a:off x="1313411" y="259530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14" name="TextBox 51">
              <a:extLst>
                <a:ext uri="{FF2B5EF4-FFF2-40B4-BE49-F238E27FC236}">
                  <a16:creationId xmlns:a16="http://schemas.microsoft.com/office/drawing/2014/main" id="{F83A438D-A577-ADF3-6078-948B7832CFC4}"/>
                </a:ext>
              </a:extLst>
            </p:cNvPr>
            <p:cNvSpPr txBox="1"/>
            <p:nvPr/>
          </p:nvSpPr>
          <p:spPr>
            <a:xfrm>
              <a:off x="1745923" y="272348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15" name="TextBox 51">
              <a:extLst>
                <a:ext uri="{FF2B5EF4-FFF2-40B4-BE49-F238E27FC236}">
                  <a16:creationId xmlns:a16="http://schemas.microsoft.com/office/drawing/2014/main" id="{FF6DB921-0BDE-D579-E95E-C073D9C74DE3}"/>
                </a:ext>
              </a:extLst>
            </p:cNvPr>
            <p:cNvSpPr txBox="1"/>
            <p:nvPr/>
          </p:nvSpPr>
          <p:spPr>
            <a:xfrm>
              <a:off x="1850710" y="257108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17" name="TextBox 51">
              <a:extLst>
                <a:ext uri="{FF2B5EF4-FFF2-40B4-BE49-F238E27FC236}">
                  <a16:creationId xmlns:a16="http://schemas.microsoft.com/office/drawing/2014/main" id="{BE84D21C-4814-5325-C82D-64F36A477FAD}"/>
                </a:ext>
              </a:extLst>
            </p:cNvPr>
            <p:cNvSpPr txBox="1"/>
            <p:nvPr/>
          </p:nvSpPr>
          <p:spPr>
            <a:xfrm>
              <a:off x="2064167" y="246910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9DE8756E-EC5C-4125-F590-EDFB4FB74819}"/>
              </a:ext>
            </a:extLst>
          </p:cNvPr>
          <p:cNvGrpSpPr/>
          <p:nvPr/>
        </p:nvGrpSpPr>
        <p:grpSpPr>
          <a:xfrm>
            <a:off x="4509740" y="1332627"/>
            <a:ext cx="1905389" cy="532683"/>
            <a:chOff x="4509740" y="1351675"/>
            <a:chExt cx="1905389" cy="532683"/>
          </a:xfrm>
        </p:grpSpPr>
        <p:sp>
          <p:nvSpPr>
            <p:cNvPr id="620" name="TextBox 51">
              <a:extLst>
                <a:ext uri="{FF2B5EF4-FFF2-40B4-BE49-F238E27FC236}">
                  <a16:creationId xmlns:a16="http://schemas.microsoft.com/office/drawing/2014/main" id="{F4469F87-CD10-5012-FCBC-B248BEBB29F6}"/>
                </a:ext>
              </a:extLst>
            </p:cNvPr>
            <p:cNvSpPr txBox="1"/>
            <p:nvPr/>
          </p:nvSpPr>
          <p:spPr>
            <a:xfrm>
              <a:off x="4719620" y="173582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21" name="TextBox 51">
              <a:extLst>
                <a:ext uri="{FF2B5EF4-FFF2-40B4-BE49-F238E27FC236}">
                  <a16:creationId xmlns:a16="http://schemas.microsoft.com/office/drawing/2014/main" id="{2D2222E3-BCA2-1968-2F86-B5C0CCD7C48F}"/>
                </a:ext>
              </a:extLst>
            </p:cNvPr>
            <p:cNvSpPr txBox="1"/>
            <p:nvPr/>
          </p:nvSpPr>
          <p:spPr>
            <a:xfrm>
              <a:off x="5041070" y="175886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22" name="TextBox 51">
              <a:extLst>
                <a:ext uri="{FF2B5EF4-FFF2-40B4-BE49-F238E27FC236}">
                  <a16:creationId xmlns:a16="http://schemas.microsoft.com/office/drawing/2014/main" id="{6BD07529-9C75-ADD6-47AA-7781D62B81FA}"/>
                </a:ext>
              </a:extLst>
            </p:cNvPr>
            <p:cNvSpPr txBox="1"/>
            <p:nvPr/>
          </p:nvSpPr>
          <p:spPr>
            <a:xfrm>
              <a:off x="4932361" y="135167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23" name="TextBox 51">
              <a:extLst>
                <a:ext uri="{FF2B5EF4-FFF2-40B4-BE49-F238E27FC236}">
                  <a16:creationId xmlns:a16="http://schemas.microsoft.com/office/drawing/2014/main" id="{CB72220E-4377-6DD1-F6D9-67A5C3439D9E}"/>
                </a:ext>
              </a:extLst>
            </p:cNvPr>
            <p:cNvSpPr txBox="1"/>
            <p:nvPr/>
          </p:nvSpPr>
          <p:spPr>
            <a:xfrm>
              <a:off x="4509740" y="175886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24" name="TextBox 51">
              <a:extLst>
                <a:ext uri="{FF2B5EF4-FFF2-40B4-BE49-F238E27FC236}">
                  <a16:creationId xmlns:a16="http://schemas.microsoft.com/office/drawing/2014/main" id="{91912305-AF82-1E85-5F78-FB70D7B20BF4}"/>
                </a:ext>
              </a:extLst>
            </p:cNvPr>
            <p:cNvSpPr txBox="1"/>
            <p:nvPr/>
          </p:nvSpPr>
          <p:spPr>
            <a:xfrm>
              <a:off x="5147751" y="167727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25" name="TextBox 51">
              <a:extLst>
                <a:ext uri="{FF2B5EF4-FFF2-40B4-BE49-F238E27FC236}">
                  <a16:creationId xmlns:a16="http://schemas.microsoft.com/office/drawing/2014/main" id="{9BD68C9C-CE2D-E685-621D-3833831571B0}"/>
                </a:ext>
              </a:extLst>
            </p:cNvPr>
            <p:cNvSpPr txBox="1"/>
            <p:nvPr/>
          </p:nvSpPr>
          <p:spPr>
            <a:xfrm>
              <a:off x="5252242" y="175648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26" name="TextBox 51">
              <a:extLst>
                <a:ext uri="{FF2B5EF4-FFF2-40B4-BE49-F238E27FC236}">
                  <a16:creationId xmlns:a16="http://schemas.microsoft.com/office/drawing/2014/main" id="{2B6F4A05-65F4-CDE1-9089-67BC75518E97}"/>
                </a:ext>
              </a:extLst>
            </p:cNvPr>
            <p:cNvSpPr txBox="1"/>
            <p:nvPr/>
          </p:nvSpPr>
          <p:spPr>
            <a:xfrm>
              <a:off x="5361365" y="168671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27" name="TextBox 51">
              <a:extLst>
                <a:ext uri="{FF2B5EF4-FFF2-40B4-BE49-F238E27FC236}">
                  <a16:creationId xmlns:a16="http://schemas.microsoft.com/office/drawing/2014/main" id="{ECE06B89-8F97-E227-750D-C3062ED851DF}"/>
                </a:ext>
              </a:extLst>
            </p:cNvPr>
            <p:cNvSpPr txBox="1"/>
            <p:nvPr/>
          </p:nvSpPr>
          <p:spPr>
            <a:xfrm>
              <a:off x="5578089" y="176124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28" name="TextBox 51">
              <a:extLst>
                <a:ext uri="{FF2B5EF4-FFF2-40B4-BE49-F238E27FC236}">
                  <a16:creationId xmlns:a16="http://schemas.microsoft.com/office/drawing/2014/main" id="{00B97964-E849-1C29-1FBE-159953088F4D}"/>
                </a:ext>
              </a:extLst>
            </p:cNvPr>
            <p:cNvSpPr txBox="1"/>
            <p:nvPr/>
          </p:nvSpPr>
          <p:spPr>
            <a:xfrm>
              <a:off x="5794426" y="176124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29" name="TextBox 51">
              <a:extLst>
                <a:ext uri="{FF2B5EF4-FFF2-40B4-BE49-F238E27FC236}">
                  <a16:creationId xmlns:a16="http://schemas.microsoft.com/office/drawing/2014/main" id="{383A5B4D-4181-A449-55B9-9C760267DE16}"/>
                </a:ext>
              </a:extLst>
            </p:cNvPr>
            <p:cNvSpPr txBox="1"/>
            <p:nvPr/>
          </p:nvSpPr>
          <p:spPr>
            <a:xfrm>
              <a:off x="5685434" y="176124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30" name="TextBox 51">
              <a:extLst>
                <a:ext uri="{FF2B5EF4-FFF2-40B4-BE49-F238E27FC236}">
                  <a16:creationId xmlns:a16="http://schemas.microsoft.com/office/drawing/2014/main" id="{98BA6A81-BBC0-4926-C44B-903EEF5AC8CD}"/>
                </a:ext>
              </a:extLst>
            </p:cNvPr>
            <p:cNvSpPr txBox="1"/>
            <p:nvPr/>
          </p:nvSpPr>
          <p:spPr>
            <a:xfrm>
              <a:off x="5465445" y="176124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31" name="TextBox 51">
              <a:extLst>
                <a:ext uri="{FF2B5EF4-FFF2-40B4-BE49-F238E27FC236}">
                  <a16:creationId xmlns:a16="http://schemas.microsoft.com/office/drawing/2014/main" id="{5F7E4BAF-E704-7469-34E5-BF1CB2451277}"/>
                </a:ext>
              </a:extLst>
            </p:cNvPr>
            <p:cNvSpPr txBox="1"/>
            <p:nvPr/>
          </p:nvSpPr>
          <p:spPr>
            <a:xfrm>
              <a:off x="5900338" y="176124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32" name="TextBox 51">
              <a:extLst>
                <a:ext uri="{FF2B5EF4-FFF2-40B4-BE49-F238E27FC236}">
                  <a16:creationId xmlns:a16="http://schemas.microsoft.com/office/drawing/2014/main" id="{5E1383AF-090C-1FCF-8ACC-B1530D9FD34C}"/>
                </a:ext>
              </a:extLst>
            </p:cNvPr>
            <p:cNvSpPr txBox="1"/>
            <p:nvPr/>
          </p:nvSpPr>
          <p:spPr>
            <a:xfrm>
              <a:off x="6109747" y="174934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33" name="TextBox 51">
              <a:extLst>
                <a:ext uri="{FF2B5EF4-FFF2-40B4-BE49-F238E27FC236}">
                  <a16:creationId xmlns:a16="http://schemas.microsoft.com/office/drawing/2014/main" id="{CE63FE67-558C-07AC-FC21-2A329CDC7CBC}"/>
                </a:ext>
              </a:extLst>
            </p:cNvPr>
            <p:cNvSpPr txBox="1"/>
            <p:nvPr/>
          </p:nvSpPr>
          <p:spPr>
            <a:xfrm>
              <a:off x="6220963" y="176124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34" name="TextBox 51">
              <a:extLst>
                <a:ext uri="{FF2B5EF4-FFF2-40B4-BE49-F238E27FC236}">
                  <a16:creationId xmlns:a16="http://schemas.microsoft.com/office/drawing/2014/main" id="{597976A1-B89E-0DD8-7517-DC010805BD8F}"/>
                </a:ext>
              </a:extLst>
            </p:cNvPr>
            <p:cNvSpPr txBox="1"/>
            <p:nvPr/>
          </p:nvSpPr>
          <p:spPr>
            <a:xfrm>
              <a:off x="4825777" y="173981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35" name="TextBox 51">
              <a:extLst>
                <a:ext uri="{FF2B5EF4-FFF2-40B4-BE49-F238E27FC236}">
                  <a16:creationId xmlns:a16="http://schemas.microsoft.com/office/drawing/2014/main" id="{C6148724-08B9-CBD5-FA26-BF3D1FDDCF1E}"/>
                </a:ext>
              </a:extLst>
            </p:cNvPr>
            <p:cNvSpPr txBox="1"/>
            <p:nvPr/>
          </p:nvSpPr>
          <p:spPr>
            <a:xfrm>
              <a:off x="6002744" y="159150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638" name="Group 637">
            <a:extLst>
              <a:ext uri="{FF2B5EF4-FFF2-40B4-BE49-F238E27FC236}">
                <a16:creationId xmlns:a16="http://schemas.microsoft.com/office/drawing/2014/main" id="{172A9873-4748-E41A-DC51-4DB28CA79631}"/>
              </a:ext>
            </a:extLst>
          </p:cNvPr>
          <p:cNvGrpSpPr/>
          <p:nvPr/>
        </p:nvGrpSpPr>
        <p:grpSpPr>
          <a:xfrm>
            <a:off x="4509740" y="2098680"/>
            <a:ext cx="1900627" cy="500058"/>
            <a:chOff x="4509740" y="1412872"/>
            <a:chExt cx="1900627" cy="500058"/>
          </a:xfrm>
        </p:grpSpPr>
        <p:sp>
          <p:nvSpPr>
            <p:cNvPr id="639" name="TextBox 51">
              <a:extLst>
                <a:ext uri="{FF2B5EF4-FFF2-40B4-BE49-F238E27FC236}">
                  <a16:creationId xmlns:a16="http://schemas.microsoft.com/office/drawing/2014/main" id="{7FEABB7F-77EE-49E5-8265-236467805E7F}"/>
                </a:ext>
              </a:extLst>
            </p:cNvPr>
            <p:cNvSpPr txBox="1"/>
            <p:nvPr/>
          </p:nvSpPr>
          <p:spPr>
            <a:xfrm>
              <a:off x="4717239" y="174297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0" name="TextBox 51">
              <a:extLst>
                <a:ext uri="{FF2B5EF4-FFF2-40B4-BE49-F238E27FC236}">
                  <a16:creationId xmlns:a16="http://schemas.microsoft.com/office/drawing/2014/main" id="{CAE28CDC-6931-70B3-662F-07FA0BB986AE}"/>
                </a:ext>
              </a:extLst>
            </p:cNvPr>
            <p:cNvSpPr txBox="1"/>
            <p:nvPr/>
          </p:nvSpPr>
          <p:spPr>
            <a:xfrm>
              <a:off x="5041070" y="175886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1" name="TextBox 51">
              <a:extLst>
                <a:ext uri="{FF2B5EF4-FFF2-40B4-BE49-F238E27FC236}">
                  <a16:creationId xmlns:a16="http://schemas.microsoft.com/office/drawing/2014/main" id="{30398090-ECC4-B77E-3903-920C54737402}"/>
                </a:ext>
              </a:extLst>
            </p:cNvPr>
            <p:cNvSpPr txBox="1"/>
            <p:nvPr/>
          </p:nvSpPr>
          <p:spPr>
            <a:xfrm>
              <a:off x="4932361" y="168980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2" name="TextBox 51">
              <a:extLst>
                <a:ext uri="{FF2B5EF4-FFF2-40B4-BE49-F238E27FC236}">
                  <a16:creationId xmlns:a16="http://schemas.microsoft.com/office/drawing/2014/main" id="{6DC96E3A-88EB-ADCF-AC99-216FF44713E8}"/>
                </a:ext>
              </a:extLst>
            </p:cNvPr>
            <p:cNvSpPr txBox="1"/>
            <p:nvPr/>
          </p:nvSpPr>
          <p:spPr>
            <a:xfrm>
              <a:off x="4509740" y="175886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4" name="TextBox 51">
              <a:extLst>
                <a:ext uri="{FF2B5EF4-FFF2-40B4-BE49-F238E27FC236}">
                  <a16:creationId xmlns:a16="http://schemas.microsoft.com/office/drawing/2014/main" id="{B2FB5CFE-9770-5281-F85C-AC59FBBB8C83}"/>
                </a:ext>
              </a:extLst>
            </p:cNvPr>
            <p:cNvSpPr txBox="1"/>
            <p:nvPr/>
          </p:nvSpPr>
          <p:spPr>
            <a:xfrm>
              <a:off x="5252242" y="174934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6" name="TextBox 51">
              <a:extLst>
                <a:ext uri="{FF2B5EF4-FFF2-40B4-BE49-F238E27FC236}">
                  <a16:creationId xmlns:a16="http://schemas.microsoft.com/office/drawing/2014/main" id="{39D2222F-6137-BF92-823F-017709E0699C}"/>
                </a:ext>
              </a:extLst>
            </p:cNvPr>
            <p:cNvSpPr txBox="1"/>
            <p:nvPr/>
          </p:nvSpPr>
          <p:spPr>
            <a:xfrm>
              <a:off x="5573327" y="175172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7" name="TextBox 51">
              <a:extLst>
                <a:ext uri="{FF2B5EF4-FFF2-40B4-BE49-F238E27FC236}">
                  <a16:creationId xmlns:a16="http://schemas.microsoft.com/office/drawing/2014/main" id="{ABFBF3EC-AD71-D2D5-FDA3-230FD8DC455E}"/>
                </a:ext>
              </a:extLst>
            </p:cNvPr>
            <p:cNvSpPr txBox="1"/>
            <p:nvPr/>
          </p:nvSpPr>
          <p:spPr>
            <a:xfrm>
              <a:off x="5792045" y="175886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8" name="TextBox 51">
              <a:extLst>
                <a:ext uri="{FF2B5EF4-FFF2-40B4-BE49-F238E27FC236}">
                  <a16:creationId xmlns:a16="http://schemas.microsoft.com/office/drawing/2014/main" id="{5EBF679E-3282-F215-7570-C72618809DCE}"/>
                </a:ext>
              </a:extLst>
            </p:cNvPr>
            <p:cNvSpPr txBox="1"/>
            <p:nvPr/>
          </p:nvSpPr>
          <p:spPr>
            <a:xfrm>
              <a:off x="5683053" y="1713627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49" name="TextBox 51">
              <a:extLst>
                <a:ext uri="{FF2B5EF4-FFF2-40B4-BE49-F238E27FC236}">
                  <a16:creationId xmlns:a16="http://schemas.microsoft.com/office/drawing/2014/main" id="{981C4C32-2703-7B64-B85B-E9E4DBC87D73}"/>
                </a:ext>
              </a:extLst>
            </p:cNvPr>
            <p:cNvSpPr txBox="1"/>
            <p:nvPr/>
          </p:nvSpPr>
          <p:spPr>
            <a:xfrm>
              <a:off x="5465445" y="1735056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50" name="TextBox 51">
              <a:extLst>
                <a:ext uri="{FF2B5EF4-FFF2-40B4-BE49-F238E27FC236}">
                  <a16:creationId xmlns:a16="http://schemas.microsoft.com/office/drawing/2014/main" id="{836CA8A1-348A-8D3D-3E3D-43B6AF44906E}"/>
                </a:ext>
              </a:extLst>
            </p:cNvPr>
            <p:cNvSpPr txBox="1"/>
            <p:nvPr/>
          </p:nvSpPr>
          <p:spPr>
            <a:xfrm>
              <a:off x="5895576" y="178981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52" name="TextBox 51">
              <a:extLst>
                <a:ext uri="{FF2B5EF4-FFF2-40B4-BE49-F238E27FC236}">
                  <a16:creationId xmlns:a16="http://schemas.microsoft.com/office/drawing/2014/main" id="{7CBDEE93-3994-D324-2A7F-E59345941C86}"/>
                </a:ext>
              </a:extLst>
            </p:cNvPr>
            <p:cNvSpPr txBox="1"/>
            <p:nvPr/>
          </p:nvSpPr>
          <p:spPr>
            <a:xfrm>
              <a:off x="6216201" y="169457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53" name="TextBox 51">
              <a:extLst>
                <a:ext uri="{FF2B5EF4-FFF2-40B4-BE49-F238E27FC236}">
                  <a16:creationId xmlns:a16="http://schemas.microsoft.com/office/drawing/2014/main" id="{05673AD3-BA68-477D-81E4-8381782D706B}"/>
                </a:ext>
              </a:extLst>
            </p:cNvPr>
            <p:cNvSpPr txBox="1"/>
            <p:nvPr/>
          </p:nvSpPr>
          <p:spPr>
            <a:xfrm>
              <a:off x="4825777" y="171600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54" name="TextBox 51">
              <a:extLst>
                <a:ext uri="{FF2B5EF4-FFF2-40B4-BE49-F238E27FC236}">
                  <a16:creationId xmlns:a16="http://schemas.microsoft.com/office/drawing/2014/main" id="{F70F0C92-95D3-5A62-1917-D6143B41B7A6}"/>
                </a:ext>
              </a:extLst>
            </p:cNvPr>
            <p:cNvSpPr txBox="1"/>
            <p:nvPr/>
          </p:nvSpPr>
          <p:spPr>
            <a:xfrm>
              <a:off x="6002744" y="1412872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7886D14A-9905-DF1D-5526-03D255ABEC02}"/>
              </a:ext>
            </a:extLst>
          </p:cNvPr>
          <p:cNvGrpSpPr/>
          <p:nvPr/>
        </p:nvGrpSpPr>
        <p:grpSpPr>
          <a:xfrm>
            <a:off x="4509740" y="2860733"/>
            <a:ext cx="1900627" cy="514291"/>
            <a:chOff x="4509740" y="2879781"/>
            <a:chExt cx="1900627" cy="514291"/>
          </a:xfrm>
        </p:grpSpPr>
        <p:sp>
          <p:nvSpPr>
            <p:cNvPr id="656" name="TextBox 51">
              <a:extLst>
                <a:ext uri="{FF2B5EF4-FFF2-40B4-BE49-F238E27FC236}">
                  <a16:creationId xmlns:a16="http://schemas.microsoft.com/office/drawing/2014/main" id="{6BD363A9-7E1A-5DF8-5912-4F4EFC9910BB}"/>
                </a:ext>
              </a:extLst>
            </p:cNvPr>
            <p:cNvSpPr txBox="1"/>
            <p:nvPr/>
          </p:nvSpPr>
          <p:spPr>
            <a:xfrm>
              <a:off x="4719620" y="313928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57" name="TextBox 51">
              <a:extLst>
                <a:ext uri="{FF2B5EF4-FFF2-40B4-BE49-F238E27FC236}">
                  <a16:creationId xmlns:a16="http://schemas.microsoft.com/office/drawing/2014/main" id="{5692ACC7-2960-4E7A-5956-EF71C3C0C7B4}"/>
                </a:ext>
              </a:extLst>
            </p:cNvPr>
            <p:cNvSpPr txBox="1"/>
            <p:nvPr/>
          </p:nvSpPr>
          <p:spPr>
            <a:xfrm>
              <a:off x="5041070" y="312736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59" name="TextBox 51">
              <a:extLst>
                <a:ext uri="{FF2B5EF4-FFF2-40B4-BE49-F238E27FC236}">
                  <a16:creationId xmlns:a16="http://schemas.microsoft.com/office/drawing/2014/main" id="{F6399091-6AFA-4054-E365-834E151C664D}"/>
                </a:ext>
              </a:extLst>
            </p:cNvPr>
            <p:cNvSpPr txBox="1"/>
            <p:nvPr/>
          </p:nvSpPr>
          <p:spPr>
            <a:xfrm>
              <a:off x="4509740" y="322810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60" name="TextBox 51">
              <a:extLst>
                <a:ext uri="{FF2B5EF4-FFF2-40B4-BE49-F238E27FC236}">
                  <a16:creationId xmlns:a16="http://schemas.microsoft.com/office/drawing/2014/main" id="{C18EB17F-A9FF-B53F-9B99-478554156A36}"/>
                </a:ext>
              </a:extLst>
            </p:cNvPr>
            <p:cNvSpPr txBox="1"/>
            <p:nvPr/>
          </p:nvSpPr>
          <p:spPr>
            <a:xfrm>
              <a:off x="5145370" y="3110068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61" name="TextBox 51">
              <a:extLst>
                <a:ext uri="{FF2B5EF4-FFF2-40B4-BE49-F238E27FC236}">
                  <a16:creationId xmlns:a16="http://schemas.microsoft.com/office/drawing/2014/main" id="{143F5CF5-E31E-C893-CC53-98730FB767C1}"/>
                </a:ext>
              </a:extLst>
            </p:cNvPr>
            <p:cNvSpPr txBox="1"/>
            <p:nvPr/>
          </p:nvSpPr>
          <p:spPr>
            <a:xfrm>
              <a:off x="5252242" y="315355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62" name="TextBox 51">
              <a:extLst>
                <a:ext uri="{FF2B5EF4-FFF2-40B4-BE49-F238E27FC236}">
                  <a16:creationId xmlns:a16="http://schemas.microsoft.com/office/drawing/2014/main" id="{C010B174-D2FE-6F6E-8DAB-D40C7771931E}"/>
                </a:ext>
              </a:extLst>
            </p:cNvPr>
            <p:cNvSpPr txBox="1"/>
            <p:nvPr/>
          </p:nvSpPr>
          <p:spPr>
            <a:xfrm>
              <a:off x="5361365" y="302664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63" name="TextBox 51">
              <a:extLst>
                <a:ext uri="{FF2B5EF4-FFF2-40B4-BE49-F238E27FC236}">
                  <a16:creationId xmlns:a16="http://schemas.microsoft.com/office/drawing/2014/main" id="{284ADA9E-BDED-A83E-895A-BABA9FE6E0FF}"/>
                </a:ext>
              </a:extLst>
            </p:cNvPr>
            <p:cNvSpPr txBox="1"/>
            <p:nvPr/>
          </p:nvSpPr>
          <p:spPr>
            <a:xfrm>
              <a:off x="5570946" y="3204293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64" name="TextBox 51">
              <a:extLst>
                <a:ext uri="{FF2B5EF4-FFF2-40B4-BE49-F238E27FC236}">
                  <a16:creationId xmlns:a16="http://schemas.microsoft.com/office/drawing/2014/main" id="{37B563CD-6EC8-E8B7-90DF-3F46B73950CD}"/>
                </a:ext>
              </a:extLst>
            </p:cNvPr>
            <p:cNvSpPr txBox="1"/>
            <p:nvPr/>
          </p:nvSpPr>
          <p:spPr>
            <a:xfrm>
              <a:off x="5789664" y="320428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65" name="TextBox 51">
              <a:extLst>
                <a:ext uri="{FF2B5EF4-FFF2-40B4-BE49-F238E27FC236}">
                  <a16:creationId xmlns:a16="http://schemas.microsoft.com/office/drawing/2014/main" id="{5E870419-47FC-3322-EBD2-09BD62F8C597}"/>
                </a:ext>
              </a:extLst>
            </p:cNvPr>
            <p:cNvSpPr txBox="1"/>
            <p:nvPr/>
          </p:nvSpPr>
          <p:spPr>
            <a:xfrm>
              <a:off x="5680672" y="3129749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66" name="TextBox 51">
              <a:extLst>
                <a:ext uri="{FF2B5EF4-FFF2-40B4-BE49-F238E27FC236}">
                  <a16:creationId xmlns:a16="http://schemas.microsoft.com/office/drawing/2014/main" id="{F2C4D23F-4102-3905-8E93-29ED3207C133}"/>
                </a:ext>
              </a:extLst>
            </p:cNvPr>
            <p:cNvSpPr txBox="1"/>
            <p:nvPr/>
          </p:nvSpPr>
          <p:spPr>
            <a:xfrm>
              <a:off x="5465445" y="3108320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67" name="TextBox 51">
              <a:extLst>
                <a:ext uri="{FF2B5EF4-FFF2-40B4-BE49-F238E27FC236}">
                  <a16:creationId xmlns:a16="http://schemas.microsoft.com/office/drawing/2014/main" id="{49523822-6545-023A-6A24-3C2616695DFB}"/>
                </a:ext>
              </a:extLst>
            </p:cNvPr>
            <p:cNvSpPr txBox="1"/>
            <p:nvPr/>
          </p:nvSpPr>
          <p:spPr>
            <a:xfrm>
              <a:off x="5895576" y="327096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68" name="TextBox 51">
              <a:extLst>
                <a:ext uri="{FF2B5EF4-FFF2-40B4-BE49-F238E27FC236}">
                  <a16:creationId xmlns:a16="http://schemas.microsoft.com/office/drawing/2014/main" id="{CAD5F185-2CEF-9171-5E66-87851FAF890C}"/>
                </a:ext>
              </a:extLst>
            </p:cNvPr>
            <p:cNvSpPr txBox="1"/>
            <p:nvPr/>
          </p:nvSpPr>
          <p:spPr>
            <a:xfrm>
              <a:off x="6107366" y="315666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69" name="TextBox 51">
              <a:extLst>
                <a:ext uri="{FF2B5EF4-FFF2-40B4-BE49-F238E27FC236}">
                  <a16:creationId xmlns:a16="http://schemas.microsoft.com/office/drawing/2014/main" id="{F70C69CE-68D6-67E9-66EA-CEA697E6EF54}"/>
                </a:ext>
              </a:extLst>
            </p:cNvPr>
            <p:cNvSpPr txBox="1"/>
            <p:nvPr/>
          </p:nvSpPr>
          <p:spPr>
            <a:xfrm>
              <a:off x="6216201" y="3144035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670" name="TextBox 51">
              <a:extLst>
                <a:ext uri="{FF2B5EF4-FFF2-40B4-BE49-F238E27FC236}">
                  <a16:creationId xmlns:a16="http://schemas.microsoft.com/office/drawing/2014/main" id="{53D7F9DD-EFF0-19E1-7138-41B690889BB6}"/>
                </a:ext>
              </a:extLst>
            </p:cNvPr>
            <p:cNvSpPr txBox="1"/>
            <p:nvPr/>
          </p:nvSpPr>
          <p:spPr>
            <a:xfrm>
              <a:off x="4930466" y="3025964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673" name="TextBox 51">
              <a:extLst>
                <a:ext uri="{FF2B5EF4-FFF2-40B4-BE49-F238E27FC236}">
                  <a16:creationId xmlns:a16="http://schemas.microsoft.com/office/drawing/2014/main" id="{990A498B-1548-DDB8-0B36-CF95F6423912}"/>
                </a:ext>
              </a:extLst>
            </p:cNvPr>
            <p:cNvSpPr txBox="1"/>
            <p:nvPr/>
          </p:nvSpPr>
          <p:spPr>
            <a:xfrm>
              <a:off x="5357966" y="2879781"/>
              <a:ext cx="19416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70619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868686"/>
        </a:solidFill>
        <a:ln w="12700" cap="flat">
          <a:solidFill>
            <a:schemeClr val="tx1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200" dirty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46</TotalTime>
  <Words>296</Words>
  <Application>Microsoft Office PowerPoint</Application>
  <PresentationFormat>Custom</PresentationFormat>
  <Paragraphs>29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5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keshi Saito</dc:creator>
  <cp:lastModifiedBy>Sugahara Go</cp:lastModifiedBy>
  <cp:revision>135</cp:revision>
  <cp:lastPrinted>2013-07-30T20:19:09Z</cp:lastPrinted>
  <dcterms:created xsi:type="dcterms:W3CDTF">2013-05-03T19:48:35Z</dcterms:created>
  <dcterms:modified xsi:type="dcterms:W3CDTF">2022-10-15T03:35:05Z</dcterms:modified>
</cp:coreProperties>
</file>